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3"/>
  </p:notesMasterIdLst>
  <p:sldIdLst>
    <p:sldId id="256" r:id="rId2"/>
    <p:sldId id="353" r:id="rId3"/>
    <p:sldId id="259" r:id="rId4"/>
    <p:sldId id="264" r:id="rId5"/>
    <p:sldId id="260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3" r:id="rId15"/>
    <p:sldId id="274" r:id="rId16"/>
    <p:sldId id="398" r:id="rId17"/>
    <p:sldId id="276" r:id="rId18"/>
    <p:sldId id="275" r:id="rId19"/>
    <p:sldId id="277" r:id="rId20"/>
    <p:sldId id="278" r:id="rId21"/>
    <p:sldId id="399" r:id="rId22"/>
    <p:sldId id="286" r:id="rId23"/>
    <p:sldId id="287" r:id="rId24"/>
    <p:sldId id="400" r:id="rId25"/>
    <p:sldId id="261" r:id="rId26"/>
    <p:sldId id="402" r:id="rId27"/>
    <p:sldId id="403" r:id="rId28"/>
    <p:sldId id="404" r:id="rId29"/>
    <p:sldId id="405" r:id="rId30"/>
    <p:sldId id="406" r:id="rId31"/>
    <p:sldId id="401" r:id="rId32"/>
    <p:sldId id="279" r:id="rId33"/>
    <p:sldId id="280" r:id="rId34"/>
    <p:sldId id="281" r:id="rId35"/>
    <p:sldId id="282" r:id="rId36"/>
    <p:sldId id="262" r:id="rId37"/>
    <p:sldId id="263" r:id="rId38"/>
    <p:sldId id="285" r:id="rId39"/>
    <p:sldId id="283" r:id="rId40"/>
    <p:sldId id="397" r:id="rId41"/>
    <p:sldId id="408" r:id="rId4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B88263-F79C-56F4-1B75-C67C77C74CBE}" v="5" dt="2025-05-16T21:41:48.6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86" d="100"/>
          <a:sy n="86" d="100"/>
        </p:scale>
        <p:origin x="96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notesMaster" Target="notesMasters/notesMaster1.xml"/><Relationship Id="rId48" Type="http://schemas.microsoft.com/office/2016/11/relationships/changesInfo" Target="changesInfos/changesInfo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laid, Sirine" userId="S::belaids@upmc.edu::5dcb4cf5-c058-49ea-93f8-4f4e6c877fcd" providerId="AD" clId="Web-{A5C379F1-091E-DD7C-0E90-D4B8F584DF0F}"/>
    <pc:docChg chg="modSld">
      <pc:chgData name="Belaid, Sirine" userId="S::belaids@upmc.edu::5dcb4cf5-c058-49ea-93f8-4f4e6c877fcd" providerId="AD" clId="Web-{A5C379F1-091E-DD7C-0E90-D4B8F584DF0F}" dt="2025-03-19T18:28:22.436" v="3" actId="1076"/>
      <pc:docMkLst>
        <pc:docMk/>
      </pc:docMkLst>
      <pc:sldChg chg="modSp">
        <pc:chgData name="Belaid, Sirine" userId="S::belaids@upmc.edu::5dcb4cf5-c058-49ea-93f8-4f4e6c877fcd" providerId="AD" clId="Web-{A5C379F1-091E-DD7C-0E90-D4B8F584DF0F}" dt="2025-03-19T18:03:59.180" v="0" actId="1076"/>
        <pc:sldMkLst>
          <pc:docMk/>
          <pc:sldMk cId="2595590755" sldId="264"/>
        </pc:sldMkLst>
        <pc:spChg chg="mod">
          <ac:chgData name="Belaid, Sirine" userId="S::belaids@upmc.edu::5dcb4cf5-c058-49ea-93f8-4f4e6c877fcd" providerId="AD" clId="Web-{A5C379F1-091E-DD7C-0E90-D4B8F584DF0F}" dt="2025-03-19T18:03:59.180" v="0" actId="1076"/>
          <ac:spMkLst>
            <pc:docMk/>
            <pc:sldMk cId="2595590755" sldId="264"/>
            <ac:spMk id="4" creationId="{2990DE21-E26E-9308-8E5C-D7F669956FA6}"/>
          </ac:spMkLst>
        </pc:spChg>
      </pc:sldChg>
      <pc:sldChg chg="modSp">
        <pc:chgData name="Belaid, Sirine" userId="S::belaids@upmc.edu::5dcb4cf5-c058-49ea-93f8-4f4e6c877fcd" providerId="AD" clId="Web-{A5C379F1-091E-DD7C-0E90-D4B8F584DF0F}" dt="2025-03-19T18:28:22.436" v="3" actId="1076"/>
        <pc:sldMkLst>
          <pc:docMk/>
          <pc:sldMk cId="459350262" sldId="398"/>
        </pc:sldMkLst>
        <pc:spChg chg="mod">
          <ac:chgData name="Belaid, Sirine" userId="S::belaids@upmc.edu::5dcb4cf5-c058-49ea-93f8-4f4e6c877fcd" providerId="AD" clId="Web-{A5C379F1-091E-DD7C-0E90-D4B8F584DF0F}" dt="2025-03-19T18:27:45.811" v="1" actId="1076"/>
          <ac:spMkLst>
            <pc:docMk/>
            <pc:sldMk cId="459350262" sldId="398"/>
            <ac:spMk id="5" creationId="{0737E187-B4B9-4F1C-F620-DAFFFA253E47}"/>
          </ac:spMkLst>
        </pc:spChg>
        <pc:spChg chg="mod">
          <ac:chgData name="Belaid, Sirine" userId="S::belaids@upmc.edu::5dcb4cf5-c058-49ea-93f8-4f4e6c877fcd" providerId="AD" clId="Web-{A5C379F1-091E-DD7C-0E90-D4B8F584DF0F}" dt="2025-03-19T18:28:22.436" v="3" actId="1076"/>
          <ac:spMkLst>
            <pc:docMk/>
            <pc:sldMk cId="459350262" sldId="398"/>
            <ac:spMk id="8" creationId="{1714D9FF-F973-F9DE-2C8E-9D57AA952318}"/>
          </ac:spMkLst>
        </pc:spChg>
      </pc:sldChg>
    </pc:docChg>
  </pc:docChgLst>
  <pc:docChgLst>
    <pc:chgData name="Belaid, Sirine" userId="S::belaids@upmc.edu::5dcb4cf5-c058-49ea-93f8-4f4e6c877fcd" providerId="AD" clId="Web-{276B8BE6-22C8-BB7C-ECF5-975C05F0F2B5}"/>
    <pc:docChg chg="modSld">
      <pc:chgData name="Belaid, Sirine" userId="S::belaids@upmc.edu::5dcb4cf5-c058-49ea-93f8-4f4e6c877fcd" providerId="AD" clId="Web-{276B8BE6-22C8-BB7C-ECF5-975C05F0F2B5}" dt="2025-03-11T19:05:15.951" v="2" actId="1076"/>
      <pc:docMkLst>
        <pc:docMk/>
      </pc:docMkLst>
      <pc:sldChg chg="modSp">
        <pc:chgData name="Belaid, Sirine" userId="S::belaids@upmc.edu::5dcb4cf5-c058-49ea-93f8-4f4e6c877fcd" providerId="AD" clId="Web-{276B8BE6-22C8-BB7C-ECF5-975C05F0F2B5}" dt="2025-03-11T19:05:15.951" v="2" actId="1076"/>
        <pc:sldMkLst>
          <pc:docMk/>
          <pc:sldMk cId="1613301265" sldId="401"/>
        </pc:sldMkLst>
        <pc:spChg chg="mod">
          <ac:chgData name="Belaid, Sirine" userId="S::belaids@upmc.edu::5dcb4cf5-c058-49ea-93f8-4f4e6c877fcd" providerId="AD" clId="Web-{276B8BE6-22C8-BB7C-ECF5-975C05F0F2B5}" dt="2025-03-11T19:05:15.951" v="2" actId="1076"/>
          <ac:spMkLst>
            <pc:docMk/>
            <pc:sldMk cId="1613301265" sldId="401"/>
            <ac:spMk id="8" creationId="{C7A73E15-61A5-E4B3-0F7A-EF3D7FBF84C6}"/>
          </ac:spMkLst>
        </pc:spChg>
        <pc:spChg chg="mod">
          <ac:chgData name="Belaid, Sirine" userId="S::belaids@upmc.edu::5dcb4cf5-c058-49ea-93f8-4f4e6c877fcd" providerId="AD" clId="Web-{276B8BE6-22C8-BB7C-ECF5-975C05F0F2B5}" dt="2025-03-11T17:49:28.734" v="0" actId="1076"/>
          <ac:spMkLst>
            <pc:docMk/>
            <pc:sldMk cId="1613301265" sldId="401"/>
            <ac:spMk id="10" creationId="{19D5FEC9-A227-5FDD-332A-0C29A3C4D3D7}"/>
          </ac:spMkLst>
        </pc:spChg>
      </pc:sldChg>
    </pc:docChg>
  </pc:docChgLst>
  <pc:docChgLst>
    <pc:chgData name="Belaid, Sirine" userId="S::belaids@upmc.edu::5dcb4cf5-c058-49ea-93f8-4f4e6c877fcd" providerId="AD" clId="Web-{39B88263-F79C-56F4-1B75-C67C77C74CBE}"/>
    <pc:docChg chg="delSld modSld">
      <pc:chgData name="Belaid, Sirine" userId="S::belaids@upmc.edu::5dcb4cf5-c058-49ea-93f8-4f4e6c877fcd" providerId="AD" clId="Web-{39B88263-F79C-56F4-1B75-C67C77C74CBE}" dt="2025-05-16T21:41:48.690" v="6"/>
      <pc:docMkLst>
        <pc:docMk/>
      </pc:docMkLst>
      <pc:sldChg chg="modSp">
        <pc:chgData name="Belaid, Sirine" userId="S::belaids@upmc.edu::5dcb4cf5-c058-49ea-93f8-4f4e6c877fcd" providerId="AD" clId="Web-{39B88263-F79C-56F4-1B75-C67C77C74CBE}" dt="2025-05-16T21:38:07.182" v="0" actId="1076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39B88263-F79C-56F4-1B75-C67C77C74CBE}" dt="2025-05-16T21:38:07.182" v="0" actId="1076"/>
          <ac:spMkLst>
            <pc:docMk/>
            <pc:sldMk cId="2302766718" sldId="261"/>
            <ac:spMk id="15" creationId="{AB115BB4-AFD6-968C-7187-B33813FD14C1}"/>
          </ac:spMkLst>
        </pc:spChg>
      </pc:sldChg>
      <pc:sldChg chg="del modNotes">
        <pc:chgData name="Belaid, Sirine" userId="S::belaids@upmc.edu::5dcb4cf5-c058-49ea-93f8-4f4e6c877fcd" providerId="AD" clId="Web-{39B88263-F79C-56F4-1B75-C67C77C74CBE}" dt="2025-05-16T21:41:44.143" v="4"/>
        <pc:sldMkLst>
          <pc:docMk/>
          <pc:sldMk cId="1929808205" sldId="284"/>
        </pc:sldMkLst>
      </pc:sldChg>
      <pc:sldChg chg="del">
        <pc:chgData name="Belaid, Sirine" userId="S::belaids@upmc.edu::5dcb4cf5-c058-49ea-93f8-4f4e6c877fcd" providerId="AD" clId="Web-{39B88263-F79C-56F4-1B75-C67C77C74CBE}" dt="2025-05-16T21:41:46.003" v="5"/>
        <pc:sldMkLst>
          <pc:docMk/>
          <pc:sldMk cId="0" sldId="349"/>
        </pc:sldMkLst>
      </pc:sldChg>
      <pc:sldChg chg="del mod modShow">
        <pc:chgData name="Belaid, Sirine" userId="S::belaids@upmc.edu::5dcb4cf5-c058-49ea-93f8-4f4e6c877fcd" providerId="AD" clId="Web-{39B88263-F79C-56F4-1B75-C67C77C74CBE}" dt="2025-05-16T21:41:48.690" v="6"/>
        <pc:sldMkLst>
          <pc:docMk/>
          <pc:sldMk cId="1359416691" sldId="407"/>
        </pc:sldMkLst>
      </pc:sldChg>
    </pc:docChg>
  </pc:docChgLst>
  <pc:docChgLst>
    <pc:chgData name="Belaid, Sirine" userId="S::belaids@upmc.edu::5dcb4cf5-c058-49ea-93f8-4f4e6c877fcd" providerId="AD" clId="Web-{4086A36D-6D30-8337-4E48-CC4FD04098A4}"/>
    <pc:docChg chg="modSld">
      <pc:chgData name="Belaid, Sirine" userId="S::belaids@upmc.edu::5dcb4cf5-c058-49ea-93f8-4f4e6c877fcd" providerId="AD" clId="Web-{4086A36D-6D30-8337-4E48-CC4FD04098A4}" dt="2024-12-18T19:34:54.911" v="2" actId="1076"/>
      <pc:docMkLst>
        <pc:docMk/>
      </pc:docMkLst>
      <pc:sldChg chg="modSp">
        <pc:chgData name="Belaid, Sirine" userId="S::belaids@upmc.edu::5dcb4cf5-c058-49ea-93f8-4f4e6c877fcd" providerId="AD" clId="Web-{4086A36D-6D30-8337-4E48-CC4FD04098A4}" dt="2024-12-18T19:34:30.129" v="0" actId="1076"/>
        <pc:sldMkLst>
          <pc:docMk/>
          <pc:sldMk cId="2595590755" sldId="264"/>
        </pc:sldMkLst>
        <pc:spChg chg="mod">
          <ac:chgData name="Belaid, Sirine" userId="S::belaids@upmc.edu::5dcb4cf5-c058-49ea-93f8-4f4e6c877fcd" providerId="AD" clId="Web-{4086A36D-6D30-8337-4E48-CC4FD04098A4}" dt="2024-12-18T19:34:30.129" v="0" actId="1076"/>
          <ac:spMkLst>
            <pc:docMk/>
            <pc:sldMk cId="2595590755" sldId="264"/>
            <ac:spMk id="4" creationId="{2990DE21-E26E-9308-8E5C-D7F669956FA6}"/>
          </ac:spMkLst>
        </pc:spChg>
      </pc:sldChg>
      <pc:sldChg chg="modSp">
        <pc:chgData name="Belaid, Sirine" userId="S::belaids@upmc.edu::5dcb4cf5-c058-49ea-93f8-4f4e6c877fcd" providerId="AD" clId="Web-{4086A36D-6D30-8337-4E48-CC4FD04098A4}" dt="2024-12-18T19:34:42.051" v="1" actId="1076"/>
        <pc:sldMkLst>
          <pc:docMk/>
          <pc:sldMk cId="3955110762" sldId="266"/>
        </pc:sldMkLst>
        <pc:spChg chg="mod">
          <ac:chgData name="Belaid, Sirine" userId="S::belaids@upmc.edu::5dcb4cf5-c058-49ea-93f8-4f4e6c877fcd" providerId="AD" clId="Web-{4086A36D-6D30-8337-4E48-CC4FD04098A4}" dt="2024-12-18T19:34:42.051" v="1" actId="1076"/>
          <ac:spMkLst>
            <pc:docMk/>
            <pc:sldMk cId="3955110762" sldId="266"/>
            <ac:spMk id="5" creationId="{8D05FE3C-E449-BDCA-51CC-1A4B1DCBAB32}"/>
          </ac:spMkLst>
        </pc:spChg>
      </pc:sldChg>
      <pc:sldChg chg="modSp">
        <pc:chgData name="Belaid, Sirine" userId="S::belaids@upmc.edu::5dcb4cf5-c058-49ea-93f8-4f4e6c877fcd" providerId="AD" clId="Web-{4086A36D-6D30-8337-4E48-CC4FD04098A4}" dt="2024-12-18T19:34:54.911" v="2" actId="1076"/>
        <pc:sldMkLst>
          <pc:docMk/>
          <pc:sldMk cId="1691135755" sldId="279"/>
        </pc:sldMkLst>
        <pc:spChg chg="mod">
          <ac:chgData name="Belaid, Sirine" userId="S::belaids@upmc.edu::5dcb4cf5-c058-49ea-93f8-4f4e6c877fcd" providerId="AD" clId="Web-{4086A36D-6D30-8337-4E48-CC4FD04098A4}" dt="2024-12-18T19:34:54.911" v="2" actId="1076"/>
          <ac:spMkLst>
            <pc:docMk/>
            <pc:sldMk cId="1691135755" sldId="279"/>
            <ac:spMk id="5" creationId="{8B453B78-8D0F-35EB-2A95-E41CE867A315}"/>
          </ac:spMkLst>
        </pc:spChg>
      </pc:sldChg>
    </pc:docChg>
  </pc:docChgLst>
  <pc:docChgLst>
    <pc:chgData name="Belaid, Sirine" userId="S::belaids@upmc.edu::5dcb4cf5-c058-49ea-93f8-4f4e6c877fcd" providerId="AD" clId="Web-{6CFEB6A2-9FF3-6CBF-F83C-C19590B9B667}"/>
    <pc:docChg chg="mod addSld delSld modSld">
      <pc:chgData name="Belaid, Sirine" userId="S::belaids@upmc.edu::5dcb4cf5-c058-49ea-93f8-4f4e6c877fcd" providerId="AD" clId="Web-{6CFEB6A2-9FF3-6CBF-F83C-C19590B9B667}" dt="2024-12-12T16:27:54.234" v="137" actId="20577"/>
      <pc:docMkLst>
        <pc:docMk/>
      </pc:docMkLst>
      <pc:sldChg chg="modSp">
        <pc:chgData name="Belaid, Sirine" userId="S::belaids@upmc.edu::5dcb4cf5-c058-49ea-93f8-4f4e6c877fcd" providerId="AD" clId="Web-{6CFEB6A2-9FF3-6CBF-F83C-C19590B9B667}" dt="2024-12-12T16:27:54.234" v="137" actId="20577"/>
        <pc:sldMkLst>
          <pc:docMk/>
          <pc:sldMk cId="109857222" sldId="256"/>
        </pc:sldMkLst>
        <pc:spChg chg="mod">
          <ac:chgData name="Belaid, Sirine" userId="S::belaids@upmc.edu::5dcb4cf5-c058-49ea-93f8-4f4e6c877fcd" providerId="AD" clId="Web-{6CFEB6A2-9FF3-6CBF-F83C-C19590B9B667}" dt="2024-12-12T16:27:38.812" v="126" actId="20577"/>
          <ac:spMkLst>
            <pc:docMk/>
            <pc:sldMk cId="109857222" sldId="256"/>
            <ac:spMk id="2" creationId="{00000000-0000-0000-0000-000000000000}"/>
          </ac:spMkLst>
        </pc:spChg>
        <pc:spChg chg="mod">
          <ac:chgData name="Belaid, Sirine" userId="S::belaids@upmc.edu::5dcb4cf5-c058-49ea-93f8-4f4e6c877fcd" providerId="AD" clId="Web-{6CFEB6A2-9FF3-6CBF-F83C-C19590B9B667}" dt="2024-12-12T16:27:54.234" v="137" actId="20577"/>
          <ac:spMkLst>
            <pc:docMk/>
            <pc:sldMk cId="109857222" sldId="256"/>
            <ac:spMk id="3" creationId="{00000000-0000-0000-0000-000000000000}"/>
          </ac:spMkLst>
        </pc:spChg>
      </pc:sldChg>
      <pc:sldChg chg="new del">
        <pc:chgData name="Belaid, Sirine" userId="S::belaids@upmc.edu::5dcb4cf5-c058-49ea-93f8-4f4e6c877fcd" providerId="AD" clId="Web-{6CFEB6A2-9FF3-6CBF-F83C-C19590B9B667}" dt="2024-12-12T16:04:55.615" v="38"/>
        <pc:sldMkLst>
          <pc:docMk/>
          <pc:sldMk cId="1410581794" sldId="257"/>
        </pc:sldMkLst>
      </pc:sldChg>
      <pc:sldChg chg="add del">
        <pc:chgData name="Belaid, Sirine" userId="S::belaids@upmc.edu::5dcb4cf5-c058-49ea-93f8-4f4e6c877fcd" providerId="AD" clId="Web-{6CFEB6A2-9FF3-6CBF-F83C-C19590B9B667}" dt="2024-12-12T16:05:28.507" v="40"/>
        <pc:sldMkLst>
          <pc:docMk/>
          <pc:sldMk cId="344766927" sldId="259"/>
        </pc:sldMkLst>
      </pc:sldChg>
      <pc:sldChg chg="add del">
        <pc:chgData name="Belaid, Sirine" userId="S::belaids@upmc.edu::5dcb4cf5-c058-49ea-93f8-4f4e6c877fcd" providerId="AD" clId="Web-{6CFEB6A2-9FF3-6CBF-F83C-C19590B9B667}" dt="2024-12-12T16:05:28.538" v="42"/>
        <pc:sldMkLst>
          <pc:docMk/>
          <pc:sldMk cId="3651327643" sldId="260"/>
        </pc:sldMkLst>
      </pc:sldChg>
      <pc:sldChg chg="add del">
        <pc:chgData name="Belaid, Sirine" userId="S::belaids@upmc.edu::5dcb4cf5-c058-49ea-93f8-4f4e6c877fcd" providerId="AD" clId="Web-{6CFEB6A2-9FF3-6CBF-F83C-C19590B9B667}" dt="2024-12-12T16:07:36.323" v="73"/>
        <pc:sldMkLst>
          <pc:docMk/>
          <pc:sldMk cId="2302766718" sldId="261"/>
        </pc:sldMkLst>
      </pc:sldChg>
      <pc:sldChg chg="add del">
        <pc:chgData name="Belaid, Sirine" userId="S::belaids@upmc.edu::5dcb4cf5-c058-49ea-93f8-4f4e6c877fcd" providerId="AD" clId="Web-{6CFEB6A2-9FF3-6CBF-F83C-C19590B9B667}" dt="2024-12-12T16:09:35.983" v="94"/>
        <pc:sldMkLst>
          <pc:docMk/>
          <pc:sldMk cId="576414548" sldId="262"/>
        </pc:sldMkLst>
      </pc:sldChg>
      <pc:sldChg chg="add del">
        <pc:chgData name="Belaid, Sirine" userId="S::belaids@upmc.edu::5dcb4cf5-c058-49ea-93f8-4f4e6c877fcd" providerId="AD" clId="Web-{6CFEB6A2-9FF3-6CBF-F83C-C19590B9B667}" dt="2024-12-12T16:09:35.983" v="95"/>
        <pc:sldMkLst>
          <pc:docMk/>
          <pc:sldMk cId="339090689" sldId="263"/>
        </pc:sldMkLst>
      </pc:sldChg>
      <pc:sldChg chg="add del">
        <pc:chgData name="Belaid, Sirine" userId="S::belaids@upmc.edu::5dcb4cf5-c058-49ea-93f8-4f4e6c877fcd" providerId="AD" clId="Web-{6CFEB6A2-9FF3-6CBF-F83C-C19590B9B667}" dt="2024-12-12T16:05:28.523" v="41"/>
        <pc:sldMkLst>
          <pc:docMk/>
          <pc:sldMk cId="2595590755" sldId="264"/>
        </pc:sldMkLst>
      </pc:sldChg>
      <pc:sldChg chg="add del">
        <pc:chgData name="Belaid, Sirine" userId="S::belaids@upmc.edu::5dcb4cf5-c058-49ea-93f8-4f4e6c877fcd" providerId="AD" clId="Web-{6CFEB6A2-9FF3-6CBF-F83C-C19590B9B667}" dt="2024-12-12T16:05:28.538" v="43"/>
        <pc:sldMkLst>
          <pc:docMk/>
          <pc:sldMk cId="571547126" sldId="265"/>
        </pc:sldMkLst>
      </pc:sldChg>
      <pc:sldChg chg="add del">
        <pc:chgData name="Belaid, Sirine" userId="S::belaids@upmc.edu::5dcb4cf5-c058-49ea-93f8-4f4e6c877fcd" providerId="AD" clId="Web-{6CFEB6A2-9FF3-6CBF-F83C-C19590B9B667}" dt="2024-12-12T16:05:59.711" v="44"/>
        <pc:sldMkLst>
          <pc:docMk/>
          <pc:sldMk cId="3955110762" sldId="266"/>
        </pc:sldMkLst>
      </pc:sldChg>
      <pc:sldChg chg="add del">
        <pc:chgData name="Belaid, Sirine" userId="S::belaids@upmc.edu::5dcb4cf5-c058-49ea-93f8-4f4e6c877fcd" providerId="AD" clId="Web-{6CFEB6A2-9FF3-6CBF-F83C-C19590B9B667}" dt="2024-12-12T16:05:59.711" v="45"/>
        <pc:sldMkLst>
          <pc:docMk/>
          <pc:sldMk cId="2923304690" sldId="267"/>
        </pc:sldMkLst>
      </pc:sldChg>
      <pc:sldChg chg="add del">
        <pc:chgData name="Belaid, Sirine" userId="S::belaids@upmc.edu::5dcb4cf5-c058-49ea-93f8-4f4e6c877fcd" providerId="AD" clId="Web-{6CFEB6A2-9FF3-6CBF-F83C-C19590B9B667}" dt="2024-12-12T16:05:59.727" v="46"/>
        <pc:sldMkLst>
          <pc:docMk/>
          <pc:sldMk cId="280177216" sldId="268"/>
        </pc:sldMkLst>
      </pc:sldChg>
      <pc:sldChg chg="add del">
        <pc:chgData name="Belaid, Sirine" userId="S::belaids@upmc.edu::5dcb4cf5-c058-49ea-93f8-4f4e6c877fcd" providerId="AD" clId="Web-{6CFEB6A2-9FF3-6CBF-F83C-C19590B9B667}" dt="2024-12-12T16:05:59.727" v="47"/>
        <pc:sldMkLst>
          <pc:docMk/>
          <pc:sldMk cId="666331701" sldId="269"/>
        </pc:sldMkLst>
      </pc:sldChg>
      <pc:sldChg chg="add del">
        <pc:chgData name="Belaid, Sirine" userId="S::belaids@upmc.edu::5dcb4cf5-c058-49ea-93f8-4f4e6c877fcd" providerId="AD" clId="Web-{6CFEB6A2-9FF3-6CBF-F83C-C19590B9B667}" dt="2024-12-12T16:05:59.742" v="48"/>
        <pc:sldMkLst>
          <pc:docMk/>
          <pc:sldMk cId="3489943564" sldId="270"/>
        </pc:sldMkLst>
      </pc:sldChg>
      <pc:sldChg chg="add del">
        <pc:chgData name="Belaid, Sirine" userId="S::belaids@upmc.edu::5dcb4cf5-c058-49ea-93f8-4f4e6c877fcd" providerId="AD" clId="Web-{6CFEB6A2-9FF3-6CBF-F83C-C19590B9B667}" dt="2024-12-12T16:05:59.742" v="49"/>
        <pc:sldMkLst>
          <pc:docMk/>
          <pc:sldMk cId="4163017298" sldId="271"/>
        </pc:sldMkLst>
      </pc:sldChg>
      <pc:sldChg chg="add del">
        <pc:chgData name="Belaid, Sirine" userId="S::belaids@upmc.edu::5dcb4cf5-c058-49ea-93f8-4f4e6c877fcd" providerId="AD" clId="Web-{6CFEB6A2-9FF3-6CBF-F83C-C19590B9B667}" dt="2024-12-12T16:06:27.196" v="50"/>
        <pc:sldMkLst>
          <pc:docMk/>
          <pc:sldMk cId="138475673" sldId="272"/>
        </pc:sldMkLst>
      </pc:sldChg>
      <pc:sldChg chg="add del">
        <pc:chgData name="Belaid, Sirine" userId="S::belaids@upmc.edu::5dcb4cf5-c058-49ea-93f8-4f4e6c877fcd" providerId="AD" clId="Web-{6CFEB6A2-9FF3-6CBF-F83C-C19590B9B667}" dt="2024-12-12T16:06:27.212" v="51"/>
        <pc:sldMkLst>
          <pc:docMk/>
          <pc:sldMk cId="2876258149" sldId="273"/>
        </pc:sldMkLst>
      </pc:sldChg>
      <pc:sldChg chg="add del">
        <pc:chgData name="Belaid, Sirine" userId="S::belaids@upmc.edu::5dcb4cf5-c058-49ea-93f8-4f4e6c877fcd" providerId="AD" clId="Web-{6CFEB6A2-9FF3-6CBF-F83C-C19590B9B667}" dt="2024-12-12T16:06:27.228" v="52"/>
        <pc:sldMkLst>
          <pc:docMk/>
          <pc:sldMk cId="1037168473" sldId="274"/>
        </pc:sldMkLst>
      </pc:sldChg>
      <pc:sldChg chg="add del">
        <pc:chgData name="Belaid, Sirine" userId="S::belaids@upmc.edu::5dcb4cf5-c058-49ea-93f8-4f4e6c877fcd" providerId="AD" clId="Web-{6CFEB6A2-9FF3-6CBF-F83C-C19590B9B667}" dt="2024-12-12T16:06:27.243" v="54"/>
        <pc:sldMkLst>
          <pc:docMk/>
          <pc:sldMk cId="460022324" sldId="275"/>
        </pc:sldMkLst>
      </pc:sldChg>
      <pc:sldChg chg="add del">
        <pc:chgData name="Belaid, Sirine" userId="S::belaids@upmc.edu::5dcb4cf5-c058-49ea-93f8-4f4e6c877fcd" providerId="AD" clId="Web-{6CFEB6A2-9FF3-6CBF-F83C-C19590B9B667}" dt="2024-12-12T16:06:27.228" v="53"/>
        <pc:sldMkLst>
          <pc:docMk/>
          <pc:sldMk cId="890179914" sldId="276"/>
        </pc:sldMkLst>
      </pc:sldChg>
      <pc:sldChg chg="add del">
        <pc:chgData name="Belaid, Sirine" userId="S::belaids@upmc.edu::5dcb4cf5-c058-49ea-93f8-4f4e6c877fcd" providerId="AD" clId="Web-{6CFEB6A2-9FF3-6CBF-F83C-C19590B9B667}" dt="2024-12-12T16:06:27.259" v="55"/>
        <pc:sldMkLst>
          <pc:docMk/>
          <pc:sldMk cId="2737701447" sldId="277"/>
        </pc:sldMkLst>
      </pc:sldChg>
      <pc:sldChg chg="add del">
        <pc:chgData name="Belaid, Sirine" userId="S::belaids@upmc.edu::5dcb4cf5-c058-49ea-93f8-4f4e6c877fcd" providerId="AD" clId="Web-{6CFEB6A2-9FF3-6CBF-F83C-C19590B9B667}" dt="2024-12-12T16:06:27.274" v="56"/>
        <pc:sldMkLst>
          <pc:docMk/>
          <pc:sldMk cId="3040203494" sldId="278"/>
        </pc:sldMkLst>
      </pc:sldChg>
      <pc:sldChg chg="add del">
        <pc:chgData name="Belaid, Sirine" userId="S::belaids@upmc.edu::5dcb4cf5-c058-49ea-93f8-4f4e6c877fcd" providerId="AD" clId="Web-{6CFEB6A2-9FF3-6CBF-F83C-C19590B9B667}" dt="2024-12-12T16:07:36.323" v="74"/>
        <pc:sldMkLst>
          <pc:docMk/>
          <pc:sldMk cId="1691135755" sldId="279"/>
        </pc:sldMkLst>
      </pc:sldChg>
      <pc:sldChg chg="add del">
        <pc:chgData name="Belaid, Sirine" userId="S::belaids@upmc.edu::5dcb4cf5-c058-49ea-93f8-4f4e6c877fcd" providerId="AD" clId="Web-{6CFEB6A2-9FF3-6CBF-F83C-C19590B9B667}" dt="2024-12-12T16:08:57.826" v="85"/>
        <pc:sldMkLst>
          <pc:docMk/>
          <pc:sldMk cId="2334828839" sldId="280"/>
        </pc:sldMkLst>
      </pc:sldChg>
      <pc:sldChg chg="add del">
        <pc:chgData name="Belaid, Sirine" userId="S::belaids@upmc.edu::5dcb4cf5-c058-49ea-93f8-4f4e6c877fcd" providerId="AD" clId="Web-{6CFEB6A2-9FF3-6CBF-F83C-C19590B9B667}" dt="2024-12-12T16:08:57.826" v="86"/>
        <pc:sldMkLst>
          <pc:docMk/>
          <pc:sldMk cId="1811786192" sldId="281"/>
        </pc:sldMkLst>
      </pc:sldChg>
      <pc:sldChg chg="add del">
        <pc:chgData name="Belaid, Sirine" userId="S::belaids@upmc.edu::5dcb4cf5-c058-49ea-93f8-4f4e6c877fcd" providerId="AD" clId="Web-{6CFEB6A2-9FF3-6CBF-F83C-C19590B9B667}" dt="2024-12-12T16:08:57.841" v="87"/>
        <pc:sldMkLst>
          <pc:docMk/>
          <pc:sldMk cId="534894233" sldId="282"/>
        </pc:sldMkLst>
      </pc:sldChg>
      <pc:sldChg chg="add del">
        <pc:chgData name="Belaid, Sirine" userId="S::belaids@upmc.edu::5dcb4cf5-c058-49ea-93f8-4f4e6c877fcd" providerId="AD" clId="Web-{6CFEB6A2-9FF3-6CBF-F83C-C19590B9B667}" dt="2024-12-12T16:10:31.797" v="103"/>
        <pc:sldMkLst>
          <pc:docMk/>
          <pc:sldMk cId="3128388144" sldId="283"/>
        </pc:sldMkLst>
      </pc:sldChg>
      <pc:sldChg chg="modSp add del">
        <pc:chgData name="Belaid, Sirine" userId="S::belaids@upmc.edu::5dcb4cf5-c058-49ea-93f8-4f4e6c877fcd" providerId="AD" clId="Web-{6CFEB6A2-9FF3-6CBF-F83C-C19590B9B667}" dt="2024-12-12T16:20:14.476" v="117" actId="20577"/>
        <pc:sldMkLst>
          <pc:docMk/>
          <pc:sldMk cId="1929808205" sldId="284"/>
        </pc:sldMkLst>
        <pc:spChg chg="mod">
          <ac:chgData name="Belaid, Sirine" userId="S::belaids@upmc.edu::5dcb4cf5-c058-49ea-93f8-4f4e6c877fcd" providerId="AD" clId="Web-{6CFEB6A2-9FF3-6CBF-F83C-C19590B9B667}" dt="2024-12-12T16:11:38.034" v="113" actId="1076"/>
          <ac:spMkLst>
            <pc:docMk/>
            <pc:sldMk cId="1929808205" sldId="284"/>
            <ac:spMk id="2" creationId="{12FEC93E-BAE3-8E25-0A92-C71506366C6D}"/>
          </ac:spMkLst>
        </pc:spChg>
        <pc:spChg chg="mod">
          <ac:chgData name="Belaid, Sirine" userId="S::belaids@upmc.edu::5dcb4cf5-c058-49ea-93f8-4f4e6c877fcd" providerId="AD" clId="Web-{6CFEB6A2-9FF3-6CBF-F83C-C19590B9B667}" dt="2024-12-12T16:20:14.476" v="117" actId="20577"/>
          <ac:spMkLst>
            <pc:docMk/>
            <pc:sldMk cId="1929808205" sldId="284"/>
            <ac:spMk id="3" creationId="{58FCD493-5D8B-98D4-345B-FD2F49D6AADC}"/>
          </ac:spMkLst>
        </pc:spChg>
      </pc:sldChg>
      <pc:sldChg chg="add del">
        <pc:chgData name="Belaid, Sirine" userId="S::belaids@upmc.edu::5dcb4cf5-c058-49ea-93f8-4f4e6c877fcd" providerId="AD" clId="Web-{6CFEB6A2-9FF3-6CBF-F83C-C19590B9B667}" dt="2024-12-12T16:10:31.782" v="102"/>
        <pc:sldMkLst>
          <pc:docMk/>
          <pc:sldMk cId="117287384" sldId="285"/>
        </pc:sldMkLst>
      </pc:sldChg>
      <pc:sldChg chg="add del">
        <pc:chgData name="Belaid, Sirine" userId="S::belaids@upmc.edu::5dcb4cf5-c058-49ea-93f8-4f4e6c877fcd" providerId="AD" clId="Web-{6CFEB6A2-9FF3-6CBF-F83C-C19590B9B667}" dt="2024-12-12T16:07:36.261" v="71"/>
        <pc:sldMkLst>
          <pc:docMk/>
          <pc:sldMk cId="1161013520" sldId="286"/>
        </pc:sldMkLst>
      </pc:sldChg>
      <pc:sldChg chg="add del">
        <pc:chgData name="Belaid, Sirine" userId="S::belaids@upmc.edu::5dcb4cf5-c058-49ea-93f8-4f4e6c877fcd" providerId="AD" clId="Web-{6CFEB6A2-9FF3-6CBF-F83C-C19590B9B667}" dt="2024-12-12T16:07:36.308" v="72"/>
        <pc:sldMkLst>
          <pc:docMk/>
          <pc:sldMk cId="931904134" sldId="287"/>
        </pc:sldMkLst>
      </pc:sldChg>
      <pc:sldChg chg="add del modNotes">
        <pc:chgData name="Belaid, Sirine" userId="S::belaids@upmc.edu::5dcb4cf5-c058-49ea-93f8-4f4e6c877fcd" providerId="AD" clId="Web-{6CFEB6A2-9FF3-6CBF-F83C-C19590B9B667}" dt="2024-12-12T16:27:28.140" v="123"/>
        <pc:sldMkLst>
          <pc:docMk/>
          <pc:sldMk cId="0" sldId="349"/>
        </pc:sldMkLst>
      </pc:sldChg>
      <pc:sldChg chg="add del">
        <pc:chgData name="Belaid, Sirine" userId="S::belaids@upmc.edu::5dcb4cf5-c058-49ea-93f8-4f4e6c877fcd" providerId="AD" clId="Web-{6CFEB6A2-9FF3-6CBF-F83C-C19590B9B667}" dt="2024-12-12T16:05:28.491" v="39"/>
        <pc:sldMkLst>
          <pc:docMk/>
          <pc:sldMk cId="481006994" sldId="353"/>
        </pc:sldMkLst>
      </pc:sldChg>
      <pc:sldChg chg="add del">
        <pc:chgData name="Belaid, Sirine" userId="S::belaids@upmc.edu::5dcb4cf5-c058-49ea-93f8-4f4e6c877fcd" providerId="AD" clId="Web-{6CFEB6A2-9FF3-6CBF-F83C-C19590B9B667}" dt="2024-12-12T16:11:06.470" v="110"/>
        <pc:sldMkLst>
          <pc:docMk/>
          <pc:sldMk cId="1670317384" sldId="397"/>
        </pc:sldMkLst>
      </pc:sldChg>
    </pc:docChg>
  </pc:docChgLst>
  <pc:docChgLst>
    <pc:chgData name="Belaid, Sirine" userId="S::belaids@upmc.edu::5dcb4cf5-c058-49ea-93f8-4f4e6c877fcd" providerId="AD" clId="Web-{DD6AC853-C1EC-9904-652D-0CE623E03907}"/>
    <pc:docChg chg="modSld">
      <pc:chgData name="Belaid, Sirine" userId="S::belaids@upmc.edu::5dcb4cf5-c058-49ea-93f8-4f4e6c877fcd" providerId="AD" clId="Web-{DD6AC853-C1EC-9904-652D-0CE623E03907}" dt="2025-02-11T21:12:35.904" v="18" actId="1076"/>
      <pc:docMkLst>
        <pc:docMk/>
      </pc:docMkLst>
      <pc:sldChg chg="modSp">
        <pc:chgData name="Belaid, Sirine" userId="S::belaids@upmc.edu::5dcb4cf5-c058-49ea-93f8-4f4e6c877fcd" providerId="AD" clId="Web-{DD6AC853-C1EC-9904-652D-0CE623E03907}" dt="2025-02-04T21:24:59.188" v="3" actId="1076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DD6AC853-C1EC-9904-652D-0CE623E03907}" dt="2025-02-04T21:24:59.188" v="3" actId="1076"/>
          <ac:spMkLst>
            <pc:docMk/>
            <pc:sldMk cId="2302766718" sldId="261"/>
            <ac:spMk id="15" creationId="{AB115BB4-AFD6-968C-7187-B33813FD14C1}"/>
          </ac:spMkLst>
        </pc:spChg>
      </pc:sldChg>
      <pc:sldChg chg="addSp modSp">
        <pc:chgData name="Belaid, Sirine" userId="S::belaids@upmc.edu::5dcb4cf5-c058-49ea-93f8-4f4e6c877fcd" providerId="AD" clId="Web-{DD6AC853-C1EC-9904-652D-0CE623E03907}" dt="2025-02-11T21:12:35.904" v="18" actId="1076"/>
        <pc:sldMkLst>
          <pc:docMk/>
          <pc:sldMk cId="3040203494" sldId="278"/>
        </pc:sldMkLst>
        <pc:spChg chg="add mod">
          <ac:chgData name="Belaid, Sirine" userId="S::belaids@upmc.edu::5dcb4cf5-c058-49ea-93f8-4f4e6c877fcd" providerId="AD" clId="Web-{DD6AC853-C1EC-9904-652D-0CE623E03907}" dt="2025-02-11T21:12:29.435" v="14" actId="1076"/>
          <ac:spMkLst>
            <pc:docMk/>
            <pc:sldMk cId="3040203494" sldId="278"/>
            <ac:spMk id="4" creationId="{3E38F8BF-0211-609D-877C-7793EC8C03CA}"/>
          </ac:spMkLst>
        </pc:spChg>
        <pc:spChg chg="add mod">
          <ac:chgData name="Belaid, Sirine" userId="S::belaids@upmc.edu::5dcb4cf5-c058-49ea-93f8-4f4e6c877fcd" providerId="AD" clId="Web-{DD6AC853-C1EC-9904-652D-0CE623E03907}" dt="2025-02-11T21:12:32.576" v="16" actId="1076"/>
          <ac:spMkLst>
            <pc:docMk/>
            <pc:sldMk cId="3040203494" sldId="278"/>
            <ac:spMk id="6" creationId="{1858643D-EBF6-A457-7006-6C7ABB799401}"/>
          </ac:spMkLst>
        </pc:spChg>
        <pc:spChg chg="add mod">
          <ac:chgData name="Belaid, Sirine" userId="S::belaids@upmc.edu::5dcb4cf5-c058-49ea-93f8-4f4e6c877fcd" providerId="AD" clId="Web-{DD6AC853-C1EC-9904-652D-0CE623E03907}" dt="2025-02-11T21:12:35.904" v="18" actId="1076"/>
          <ac:spMkLst>
            <pc:docMk/>
            <pc:sldMk cId="3040203494" sldId="278"/>
            <ac:spMk id="9" creationId="{52D721BA-F51C-1A42-BB31-BE0F0501BF15}"/>
          </ac:spMkLst>
        </pc:spChg>
      </pc:sldChg>
      <pc:sldChg chg="modSp">
        <pc:chgData name="Belaid, Sirine" userId="S::belaids@upmc.edu::5dcb4cf5-c058-49ea-93f8-4f4e6c877fcd" providerId="AD" clId="Web-{DD6AC853-C1EC-9904-652D-0CE623E03907}" dt="2025-02-04T20:34:12.949" v="0" actId="1076"/>
        <pc:sldMkLst>
          <pc:docMk/>
          <pc:sldMk cId="534894233" sldId="282"/>
        </pc:sldMkLst>
        <pc:spChg chg="mod">
          <ac:chgData name="Belaid, Sirine" userId="S::belaids@upmc.edu::5dcb4cf5-c058-49ea-93f8-4f4e6c877fcd" providerId="AD" clId="Web-{DD6AC853-C1EC-9904-652D-0CE623E03907}" dt="2025-02-04T20:34:12.949" v="0" actId="1076"/>
          <ac:spMkLst>
            <pc:docMk/>
            <pc:sldMk cId="534894233" sldId="282"/>
            <ac:spMk id="5" creationId="{190BDE7B-1907-C434-9171-AC3C3EE9BD0D}"/>
          </ac:spMkLst>
        </pc:spChg>
      </pc:sldChg>
      <pc:sldChg chg="addSp modSp">
        <pc:chgData name="Belaid, Sirine" userId="S::belaids@upmc.edu::5dcb4cf5-c058-49ea-93f8-4f4e6c877fcd" providerId="AD" clId="Web-{DD6AC853-C1EC-9904-652D-0CE623E03907}" dt="2025-02-11T21:11:24.667" v="12" actId="1076"/>
        <pc:sldMkLst>
          <pc:docMk/>
          <pc:sldMk cId="459350262" sldId="398"/>
        </pc:sldMkLst>
        <pc:spChg chg="add mod">
          <ac:chgData name="Belaid, Sirine" userId="S::belaids@upmc.edu::5dcb4cf5-c058-49ea-93f8-4f4e6c877fcd" providerId="AD" clId="Web-{DD6AC853-C1EC-9904-652D-0CE623E03907}" dt="2025-02-11T21:11:15.011" v="8" actId="1076"/>
          <ac:spMkLst>
            <pc:docMk/>
            <pc:sldMk cId="459350262" sldId="398"/>
            <ac:spMk id="5" creationId="{0737E187-B4B9-4F1C-F620-DAFFFA253E47}"/>
          </ac:spMkLst>
        </pc:spChg>
        <pc:spChg chg="add mod">
          <ac:chgData name="Belaid, Sirine" userId="S::belaids@upmc.edu::5dcb4cf5-c058-49ea-93f8-4f4e6c877fcd" providerId="AD" clId="Web-{DD6AC853-C1EC-9904-652D-0CE623E03907}" dt="2025-02-11T21:11:19.417" v="10" actId="1076"/>
          <ac:spMkLst>
            <pc:docMk/>
            <pc:sldMk cId="459350262" sldId="398"/>
            <ac:spMk id="8" creationId="{1714D9FF-F973-F9DE-2C8E-9D57AA952318}"/>
          </ac:spMkLst>
        </pc:spChg>
        <pc:spChg chg="add mod">
          <ac:chgData name="Belaid, Sirine" userId="S::belaids@upmc.edu::5dcb4cf5-c058-49ea-93f8-4f4e6c877fcd" providerId="AD" clId="Web-{DD6AC853-C1EC-9904-652D-0CE623E03907}" dt="2025-02-11T21:11:24.667" v="12" actId="1076"/>
          <ac:spMkLst>
            <pc:docMk/>
            <pc:sldMk cId="459350262" sldId="398"/>
            <ac:spMk id="10" creationId="{CB21DD64-0211-1F52-DFFE-03D8887A6B96}"/>
          </ac:spMkLst>
        </pc:spChg>
      </pc:sldChg>
      <pc:sldChg chg="modSp">
        <pc:chgData name="Belaid, Sirine" userId="S::belaids@upmc.edu::5dcb4cf5-c058-49ea-93f8-4f4e6c877fcd" providerId="AD" clId="Web-{DD6AC853-C1EC-9904-652D-0CE623E03907}" dt="2025-02-04T21:40:34.322" v="6" actId="1076"/>
        <pc:sldMkLst>
          <pc:docMk/>
          <pc:sldMk cId="1613301265" sldId="401"/>
        </pc:sldMkLst>
        <pc:spChg chg="mod">
          <ac:chgData name="Belaid, Sirine" userId="S::belaids@upmc.edu::5dcb4cf5-c058-49ea-93f8-4f4e6c877fcd" providerId="AD" clId="Web-{DD6AC853-C1EC-9904-652D-0CE623E03907}" dt="2025-02-04T21:40:34.322" v="6" actId="1076"/>
          <ac:spMkLst>
            <pc:docMk/>
            <pc:sldMk cId="1613301265" sldId="401"/>
            <ac:spMk id="10" creationId="{19D5FEC9-A227-5FDD-332A-0C29A3C4D3D7}"/>
          </ac:spMkLst>
        </pc:spChg>
      </pc:sldChg>
    </pc:docChg>
  </pc:docChgLst>
  <pc:docChgLst>
    <pc:chgData name="Belaid, Sirine" userId="S::belaids@upmc.edu::5dcb4cf5-c058-49ea-93f8-4f4e6c877fcd" providerId="AD" clId="Web-{1F8AAFA3-92CC-09ED-18CC-0989FA1B6BD1}"/>
    <pc:docChg chg="modSld">
      <pc:chgData name="Belaid, Sirine" userId="S::belaids@upmc.edu::5dcb4cf5-c058-49ea-93f8-4f4e6c877fcd" providerId="AD" clId="Web-{1F8AAFA3-92CC-09ED-18CC-0989FA1B6BD1}" dt="2025-04-09T19:17:42.318" v="7" actId="1076"/>
      <pc:docMkLst>
        <pc:docMk/>
      </pc:docMkLst>
      <pc:sldChg chg="modSp">
        <pc:chgData name="Belaid, Sirine" userId="S::belaids@upmc.edu::5dcb4cf5-c058-49ea-93f8-4f4e6c877fcd" providerId="AD" clId="Web-{1F8AAFA3-92CC-09ED-18CC-0989FA1B6BD1}" dt="2025-04-09T19:17:42.318" v="7" actId="1076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1F8AAFA3-92CC-09ED-18CC-0989FA1B6BD1}" dt="2025-04-09T19:17:42.318" v="7" actId="1076"/>
          <ac:spMkLst>
            <pc:docMk/>
            <pc:sldMk cId="2302766718" sldId="261"/>
            <ac:spMk id="15" creationId="{AB115BB4-AFD6-968C-7187-B33813FD14C1}"/>
          </ac:spMkLst>
        </pc:spChg>
      </pc:sldChg>
      <pc:sldChg chg="modSp">
        <pc:chgData name="Belaid, Sirine" userId="S::belaids@upmc.edu::5dcb4cf5-c058-49ea-93f8-4f4e6c877fcd" providerId="AD" clId="Web-{1F8AAFA3-92CC-09ED-18CC-0989FA1B6BD1}" dt="2025-04-04T21:57:29.632" v="6" actId="1076"/>
        <pc:sldMkLst>
          <pc:docMk/>
          <pc:sldMk cId="1613301265" sldId="401"/>
        </pc:sldMkLst>
        <pc:spChg chg="mod">
          <ac:chgData name="Belaid, Sirine" userId="S::belaids@upmc.edu::5dcb4cf5-c058-49ea-93f8-4f4e6c877fcd" providerId="AD" clId="Web-{1F8AAFA3-92CC-09ED-18CC-0989FA1B6BD1}" dt="2025-04-04T21:57:29.632" v="6" actId="1076"/>
          <ac:spMkLst>
            <pc:docMk/>
            <pc:sldMk cId="1613301265" sldId="401"/>
            <ac:spMk id="8" creationId="{C7A73E15-61A5-E4B3-0F7A-EF3D7FBF84C6}"/>
          </ac:spMkLst>
        </pc:spChg>
      </pc:sldChg>
    </pc:docChg>
  </pc:docChgLst>
  <pc:docChgLst>
    <pc:chgData name="Belaid, Sirine" userId="S::belaids@upmc.edu::5dcb4cf5-c058-49ea-93f8-4f4e6c877fcd" providerId="AD" clId="Web-{397B2DAD-2A6E-BE8F-F3ED-8734E4A5E3DB}"/>
    <pc:docChg chg="modSld">
      <pc:chgData name="Belaid, Sirine" userId="S::belaids@upmc.edu::5dcb4cf5-c058-49ea-93f8-4f4e6c877fcd" providerId="AD" clId="Web-{397B2DAD-2A6E-BE8F-F3ED-8734E4A5E3DB}" dt="2025-01-07T20:04:20.811" v="3" actId="1076"/>
      <pc:docMkLst>
        <pc:docMk/>
      </pc:docMkLst>
      <pc:sldChg chg="modSp">
        <pc:chgData name="Belaid, Sirine" userId="S::belaids@upmc.edu::5dcb4cf5-c058-49ea-93f8-4f4e6c877fcd" providerId="AD" clId="Web-{397B2DAD-2A6E-BE8F-F3ED-8734E4A5E3DB}" dt="2025-01-07T20:04:20.811" v="3" actId="1076"/>
        <pc:sldMkLst>
          <pc:docMk/>
          <pc:sldMk cId="534894233" sldId="282"/>
        </pc:sldMkLst>
        <pc:spChg chg="mod">
          <ac:chgData name="Belaid, Sirine" userId="S::belaids@upmc.edu::5dcb4cf5-c058-49ea-93f8-4f4e6c877fcd" providerId="AD" clId="Web-{397B2DAD-2A6E-BE8F-F3ED-8734E4A5E3DB}" dt="2025-01-07T20:04:20.811" v="3" actId="1076"/>
          <ac:spMkLst>
            <pc:docMk/>
            <pc:sldMk cId="534894233" sldId="282"/>
            <ac:spMk id="5" creationId="{190BDE7B-1907-C434-9171-AC3C3EE9BD0D}"/>
          </ac:spMkLst>
        </pc:spChg>
      </pc:sldChg>
      <pc:sldChg chg="modSp">
        <pc:chgData name="Belaid, Sirine" userId="S::belaids@upmc.edu::5dcb4cf5-c058-49ea-93f8-4f4e6c877fcd" providerId="AD" clId="Web-{397B2DAD-2A6E-BE8F-F3ED-8734E4A5E3DB}" dt="2025-01-07T19:51:07.864" v="0" actId="1076"/>
        <pc:sldMkLst>
          <pc:docMk/>
          <pc:sldMk cId="3377343647" sldId="402"/>
        </pc:sldMkLst>
        <pc:spChg chg="mod">
          <ac:chgData name="Belaid, Sirine" userId="S::belaids@upmc.edu::5dcb4cf5-c058-49ea-93f8-4f4e6c877fcd" providerId="AD" clId="Web-{397B2DAD-2A6E-BE8F-F3ED-8734E4A5E3DB}" dt="2025-01-07T19:51:07.864" v="0" actId="1076"/>
          <ac:spMkLst>
            <pc:docMk/>
            <pc:sldMk cId="3377343647" sldId="402"/>
            <ac:spMk id="9" creationId="{7385A5BB-5602-E4F2-783F-32CDB9FB9E7B}"/>
          </ac:spMkLst>
        </pc:spChg>
      </pc:sldChg>
    </pc:docChg>
  </pc:docChgLst>
  <pc:docChgLst>
    <pc:chgData name="Belaid, Sirine" userId="S::belaids@upmc.edu::5dcb4cf5-c058-49ea-93f8-4f4e6c877fcd" providerId="AD" clId="Web-{C4C78195-5FCE-BAB4-851F-7038B675D721}"/>
    <pc:docChg chg="modSld">
      <pc:chgData name="Belaid, Sirine" userId="S::belaids@upmc.edu::5dcb4cf5-c058-49ea-93f8-4f4e6c877fcd" providerId="AD" clId="Web-{C4C78195-5FCE-BAB4-851F-7038B675D721}" dt="2025-01-23T22:36:38.564" v="7" actId="1076"/>
      <pc:docMkLst>
        <pc:docMk/>
      </pc:docMkLst>
      <pc:sldChg chg="modSp">
        <pc:chgData name="Belaid, Sirine" userId="S::belaids@upmc.edu::5dcb4cf5-c058-49ea-93f8-4f4e6c877fcd" providerId="AD" clId="Web-{C4C78195-5FCE-BAB4-851F-7038B675D721}" dt="2025-01-23T22:28:06.377" v="6" actId="1076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C4C78195-5FCE-BAB4-851F-7038B675D721}" dt="2025-01-23T22:28:06.377" v="6" actId="1076"/>
          <ac:spMkLst>
            <pc:docMk/>
            <pc:sldMk cId="2302766718" sldId="261"/>
            <ac:spMk id="15" creationId="{AB115BB4-AFD6-968C-7187-B33813FD14C1}"/>
          </ac:spMkLst>
        </pc:spChg>
      </pc:sldChg>
      <pc:sldChg chg="modSp">
        <pc:chgData name="Belaid, Sirine" userId="S::belaids@upmc.edu::5dcb4cf5-c058-49ea-93f8-4f4e6c877fcd" providerId="AD" clId="Web-{C4C78195-5FCE-BAB4-851F-7038B675D721}" dt="2025-01-21T19:33:26.131" v="0" actId="1076"/>
        <pc:sldMkLst>
          <pc:docMk/>
          <pc:sldMk cId="2595590755" sldId="264"/>
        </pc:sldMkLst>
        <pc:spChg chg="mod">
          <ac:chgData name="Belaid, Sirine" userId="S::belaids@upmc.edu::5dcb4cf5-c058-49ea-93f8-4f4e6c877fcd" providerId="AD" clId="Web-{C4C78195-5FCE-BAB4-851F-7038B675D721}" dt="2025-01-21T19:33:26.131" v="0" actId="1076"/>
          <ac:spMkLst>
            <pc:docMk/>
            <pc:sldMk cId="2595590755" sldId="264"/>
            <ac:spMk id="4" creationId="{2990DE21-E26E-9308-8E5C-D7F669956FA6}"/>
          </ac:spMkLst>
        </pc:spChg>
      </pc:sldChg>
      <pc:sldChg chg="modSp">
        <pc:chgData name="Belaid, Sirine" userId="S::belaids@upmc.edu::5dcb4cf5-c058-49ea-93f8-4f4e6c877fcd" providerId="AD" clId="Web-{C4C78195-5FCE-BAB4-851F-7038B675D721}" dt="2025-01-21T19:53:18.784" v="5" actId="1076"/>
        <pc:sldMkLst>
          <pc:docMk/>
          <pc:sldMk cId="1613301265" sldId="401"/>
        </pc:sldMkLst>
        <pc:spChg chg="mod">
          <ac:chgData name="Belaid, Sirine" userId="S::belaids@upmc.edu::5dcb4cf5-c058-49ea-93f8-4f4e6c877fcd" providerId="AD" clId="Web-{C4C78195-5FCE-BAB4-851F-7038B675D721}" dt="2025-01-21T19:53:18.784" v="5" actId="1076"/>
          <ac:spMkLst>
            <pc:docMk/>
            <pc:sldMk cId="1613301265" sldId="401"/>
            <ac:spMk id="6" creationId="{59AB9A91-6868-9208-0C3C-E2B77CD802B3}"/>
          </ac:spMkLst>
        </pc:spChg>
        <pc:spChg chg="mod">
          <ac:chgData name="Belaid, Sirine" userId="S::belaids@upmc.edu::5dcb4cf5-c058-49ea-93f8-4f4e6c877fcd" providerId="AD" clId="Web-{C4C78195-5FCE-BAB4-851F-7038B675D721}" dt="2025-01-21T19:53:15.581" v="4" actId="1076"/>
          <ac:spMkLst>
            <pc:docMk/>
            <pc:sldMk cId="1613301265" sldId="401"/>
            <ac:spMk id="10" creationId="{19D5FEC9-A227-5FDD-332A-0C29A3C4D3D7}"/>
          </ac:spMkLst>
        </pc:spChg>
      </pc:sldChg>
      <pc:sldChg chg="modSp">
        <pc:chgData name="Belaid, Sirine" userId="S::belaids@upmc.edu::5dcb4cf5-c058-49ea-93f8-4f4e6c877fcd" providerId="AD" clId="Web-{C4C78195-5FCE-BAB4-851F-7038B675D721}" dt="2025-01-23T22:36:38.564" v="7" actId="1076"/>
        <pc:sldMkLst>
          <pc:docMk/>
          <pc:sldMk cId="3377343647" sldId="402"/>
        </pc:sldMkLst>
        <pc:spChg chg="mod">
          <ac:chgData name="Belaid, Sirine" userId="S::belaids@upmc.edu::5dcb4cf5-c058-49ea-93f8-4f4e6c877fcd" providerId="AD" clId="Web-{C4C78195-5FCE-BAB4-851F-7038B675D721}" dt="2025-01-23T22:36:38.564" v="7" actId="1076"/>
          <ac:spMkLst>
            <pc:docMk/>
            <pc:sldMk cId="3377343647" sldId="402"/>
            <ac:spMk id="9" creationId="{7385A5BB-5602-E4F2-783F-32CDB9FB9E7B}"/>
          </ac:spMkLst>
        </pc:spChg>
      </pc:sldChg>
      <pc:sldChg chg="modSp">
        <pc:chgData name="Belaid, Sirine" userId="S::belaids@upmc.edu::5dcb4cf5-c058-49ea-93f8-4f4e6c877fcd" providerId="AD" clId="Web-{C4C78195-5FCE-BAB4-851F-7038B675D721}" dt="2025-01-21T19:33:57.381" v="1" actId="1076"/>
        <pc:sldMkLst>
          <pc:docMk/>
          <pc:sldMk cId="4036016796" sldId="404"/>
        </pc:sldMkLst>
        <pc:spChg chg="mod">
          <ac:chgData name="Belaid, Sirine" userId="S::belaids@upmc.edu::5dcb4cf5-c058-49ea-93f8-4f4e6c877fcd" providerId="AD" clId="Web-{C4C78195-5FCE-BAB4-851F-7038B675D721}" dt="2025-01-21T19:33:57.381" v="1" actId="1076"/>
          <ac:spMkLst>
            <pc:docMk/>
            <pc:sldMk cId="4036016796" sldId="404"/>
            <ac:spMk id="10" creationId="{47C246D0-D2E0-84EF-151E-7CD30CFA3F7E}"/>
          </ac:spMkLst>
        </pc:spChg>
      </pc:sldChg>
    </pc:docChg>
  </pc:docChgLst>
  <pc:docChgLst>
    <pc:chgData name="Belaid, Sirine" userId="S::belaids@upmc.edu::5dcb4cf5-c058-49ea-93f8-4f4e6c877fcd" providerId="AD" clId="Web-{E94FA9D8-49E0-2317-5951-4F4429BD9715}"/>
    <pc:docChg chg="addSld delSld modSld">
      <pc:chgData name="Belaid, Sirine" userId="S::belaids@upmc.edu::5dcb4cf5-c058-49ea-93f8-4f4e6c877fcd" providerId="AD" clId="Web-{E94FA9D8-49E0-2317-5951-4F4429BD9715}" dt="2024-12-30T03:07:23.768" v="458" actId="14100"/>
      <pc:docMkLst>
        <pc:docMk/>
      </pc:docMkLst>
      <pc:sldChg chg="modSp">
        <pc:chgData name="Belaid, Sirine" userId="S::belaids@upmc.edu::5dcb4cf5-c058-49ea-93f8-4f4e6c877fcd" providerId="AD" clId="Web-{E94FA9D8-49E0-2317-5951-4F4429BD9715}" dt="2024-12-29T20:57:31.018" v="0" actId="20577"/>
        <pc:sldMkLst>
          <pc:docMk/>
          <pc:sldMk cId="344766927" sldId="259"/>
        </pc:sldMkLst>
        <pc:spChg chg="mod">
          <ac:chgData name="Belaid, Sirine" userId="S::belaids@upmc.edu::5dcb4cf5-c058-49ea-93f8-4f4e6c877fcd" providerId="AD" clId="Web-{E94FA9D8-49E0-2317-5951-4F4429BD9715}" dt="2024-12-29T20:57:31.018" v="0" actId="20577"/>
          <ac:spMkLst>
            <pc:docMk/>
            <pc:sldMk cId="344766927" sldId="259"/>
            <ac:spMk id="2" creationId="{9BBBE17F-3388-CD35-D6F3-A1EE6652238F}"/>
          </ac:spMkLst>
        </pc:spChg>
      </pc:sldChg>
      <pc:sldChg chg="delSp">
        <pc:chgData name="Belaid, Sirine" userId="S::belaids@upmc.edu::5dcb4cf5-c058-49ea-93f8-4f4e6c877fcd" providerId="AD" clId="Web-{E94FA9D8-49E0-2317-5951-4F4429BD9715}" dt="2024-12-29T20:58:09.722" v="1"/>
        <pc:sldMkLst>
          <pc:docMk/>
          <pc:sldMk cId="3651327643" sldId="260"/>
        </pc:sldMkLst>
        <pc:spChg chg="del">
          <ac:chgData name="Belaid, Sirine" userId="S::belaids@upmc.edu::5dcb4cf5-c058-49ea-93f8-4f4e6c877fcd" providerId="AD" clId="Web-{E94FA9D8-49E0-2317-5951-4F4429BD9715}" dt="2024-12-29T20:58:09.722" v="1"/>
          <ac:spMkLst>
            <pc:docMk/>
            <pc:sldMk cId="3651327643" sldId="260"/>
            <ac:spMk id="3" creationId="{23C63626-BFBC-CB2F-2972-A1C1CB269B47}"/>
          </ac:spMkLst>
        </pc:spChg>
      </pc:sldChg>
      <pc:sldChg chg="addSp delSp modSp">
        <pc:chgData name="Belaid, Sirine" userId="S::belaids@upmc.edu::5dcb4cf5-c058-49ea-93f8-4f4e6c877fcd" providerId="AD" clId="Web-{E94FA9D8-49E0-2317-5951-4F4429BD9715}" dt="2024-12-30T02:20:08.419" v="281" actId="20577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E94FA9D8-49E0-2317-5951-4F4429BD9715}" dt="2024-12-30T02:20:08.419" v="281" actId="20577"/>
          <ac:spMkLst>
            <pc:docMk/>
            <pc:sldMk cId="2302766718" sldId="261"/>
            <ac:spMk id="2" creationId="{049050E2-8D86-1CE2-1DAE-D1D3F05419D4}"/>
          </ac:spMkLst>
        </pc:spChg>
        <pc:spChg chg="del mod">
          <ac:chgData name="Belaid, Sirine" userId="S::belaids@upmc.edu::5dcb4cf5-c058-49ea-93f8-4f4e6c877fcd" providerId="AD" clId="Web-{E94FA9D8-49E0-2317-5951-4F4429BD9715}" dt="2024-12-30T01:55:02.094" v="87"/>
          <ac:spMkLst>
            <pc:docMk/>
            <pc:sldMk cId="2302766718" sldId="261"/>
            <ac:spMk id="6" creationId="{59AB9A91-6868-9208-0C3C-E2B77CD802B3}"/>
          </ac:spMkLst>
        </pc:spChg>
        <pc:spChg chg="del">
          <ac:chgData name="Belaid, Sirine" userId="S::belaids@upmc.edu::5dcb4cf5-c058-49ea-93f8-4f4e6c877fcd" providerId="AD" clId="Web-{E94FA9D8-49E0-2317-5951-4F4429BD9715}" dt="2024-12-30T01:55:02.094" v="86"/>
          <ac:spMkLst>
            <pc:docMk/>
            <pc:sldMk cId="2302766718" sldId="261"/>
            <ac:spMk id="8" creationId="{C7A73E15-61A5-E4B3-0F7A-EF3D7FBF84C6}"/>
          </ac:spMkLst>
        </pc:spChg>
        <pc:spChg chg="del">
          <ac:chgData name="Belaid, Sirine" userId="S::belaids@upmc.edu::5dcb4cf5-c058-49ea-93f8-4f4e6c877fcd" providerId="AD" clId="Web-{E94FA9D8-49E0-2317-5951-4F4429BD9715}" dt="2024-12-30T01:55:02.094" v="85"/>
          <ac:spMkLst>
            <pc:docMk/>
            <pc:sldMk cId="2302766718" sldId="261"/>
            <ac:spMk id="10" creationId="{19D5FEC9-A227-5FDD-332A-0C29A3C4D3D7}"/>
          </ac:spMkLst>
        </pc:spChg>
        <pc:spChg chg="add mod">
          <ac:chgData name="Belaid, Sirine" userId="S::belaids@upmc.edu::5dcb4cf5-c058-49ea-93f8-4f4e6c877fcd" providerId="AD" clId="Web-{E94FA9D8-49E0-2317-5951-4F4429BD9715}" dt="2024-12-30T01:57:23.225" v="104" actId="1076"/>
          <ac:spMkLst>
            <pc:docMk/>
            <pc:sldMk cId="2302766718" sldId="261"/>
            <ac:spMk id="11" creationId="{D73E02A3-D443-DB0E-5656-D79320260562}"/>
          </ac:spMkLst>
        </pc:spChg>
        <pc:spChg chg="del">
          <ac:chgData name="Belaid, Sirine" userId="S::belaids@upmc.edu::5dcb4cf5-c058-49ea-93f8-4f4e6c877fcd" providerId="AD" clId="Web-{E94FA9D8-49E0-2317-5951-4F4429BD9715}" dt="2024-12-30T01:55:24.642" v="91"/>
          <ac:spMkLst>
            <pc:docMk/>
            <pc:sldMk cId="2302766718" sldId="261"/>
            <ac:spMk id="12" creationId="{AF3D8C70-3150-27C0-2D43-04BB4B781995}"/>
          </ac:spMkLst>
        </pc:spChg>
        <pc:spChg chg="del">
          <ac:chgData name="Belaid, Sirine" userId="S::belaids@upmc.edu::5dcb4cf5-c058-49ea-93f8-4f4e6c877fcd" providerId="AD" clId="Web-{E94FA9D8-49E0-2317-5951-4F4429BD9715}" dt="2024-12-30T01:55:24.642" v="90"/>
          <ac:spMkLst>
            <pc:docMk/>
            <pc:sldMk cId="2302766718" sldId="261"/>
            <ac:spMk id="14" creationId="{30DDA2BD-58CC-3571-0D62-CB72B2E12291}"/>
          </ac:spMkLst>
        </pc:spChg>
        <pc:spChg chg="add mod">
          <ac:chgData name="Belaid, Sirine" userId="S::belaids@upmc.edu::5dcb4cf5-c058-49ea-93f8-4f4e6c877fcd" providerId="AD" clId="Web-{E94FA9D8-49E0-2317-5951-4F4429BD9715}" dt="2024-12-30T01:57:54.430" v="112" actId="1076"/>
          <ac:spMkLst>
            <pc:docMk/>
            <pc:sldMk cId="2302766718" sldId="261"/>
            <ac:spMk id="15" creationId="{AB115BB4-AFD6-968C-7187-B33813FD14C1}"/>
          </ac:spMkLst>
        </pc:spChg>
        <pc:spChg chg="del">
          <ac:chgData name="Belaid, Sirine" userId="S::belaids@upmc.edu::5dcb4cf5-c058-49ea-93f8-4f4e6c877fcd" providerId="AD" clId="Web-{E94FA9D8-49E0-2317-5951-4F4429BD9715}" dt="2024-12-30T01:55:24.642" v="89"/>
          <ac:spMkLst>
            <pc:docMk/>
            <pc:sldMk cId="2302766718" sldId="261"/>
            <ac:spMk id="16" creationId="{4ABC1E52-6A91-D66B-231E-2CAA638C3A65}"/>
          </ac:spMkLst>
        </pc:spChg>
        <pc:spChg chg="del">
          <ac:chgData name="Belaid, Sirine" userId="S::belaids@upmc.edu::5dcb4cf5-c058-49ea-93f8-4f4e6c877fcd" providerId="AD" clId="Web-{E94FA9D8-49E0-2317-5951-4F4429BD9715}" dt="2024-12-30T01:55:29.486" v="93"/>
          <ac:spMkLst>
            <pc:docMk/>
            <pc:sldMk cId="2302766718" sldId="261"/>
            <ac:spMk id="18" creationId="{A1D21C41-5547-97D6-4988-D99D75AFBB3A}"/>
          </ac:spMkLst>
        </pc:spChg>
        <pc:spChg chg="add mod">
          <ac:chgData name="Belaid, Sirine" userId="S::belaids@upmc.edu::5dcb4cf5-c058-49ea-93f8-4f4e6c877fcd" providerId="AD" clId="Web-{E94FA9D8-49E0-2317-5951-4F4429BD9715}" dt="2024-12-30T01:57:46.898" v="110" actId="1076"/>
          <ac:spMkLst>
            <pc:docMk/>
            <pc:sldMk cId="2302766718" sldId="261"/>
            <ac:spMk id="19" creationId="{F545EADD-59F9-0BDA-84D6-A1722CE61AC7}"/>
          </ac:spMkLst>
        </pc:spChg>
        <pc:spChg chg="del">
          <ac:chgData name="Belaid, Sirine" userId="S::belaids@upmc.edu::5dcb4cf5-c058-49ea-93f8-4f4e6c877fcd" providerId="AD" clId="Web-{E94FA9D8-49E0-2317-5951-4F4429BD9715}" dt="2024-12-30T01:55:29.486" v="92"/>
          <ac:spMkLst>
            <pc:docMk/>
            <pc:sldMk cId="2302766718" sldId="261"/>
            <ac:spMk id="20" creationId="{B650BEB8-BEA3-49C3-2C18-960CB9661CA0}"/>
          </ac:spMkLst>
        </pc:spChg>
        <pc:spChg chg="del">
          <ac:chgData name="Belaid, Sirine" userId="S::belaids@upmc.edu::5dcb4cf5-c058-49ea-93f8-4f4e6c877fcd" providerId="AD" clId="Web-{E94FA9D8-49E0-2317-5951-4F4429BD9715}" dt="2024-12-30T01:55:24.642" v="88"/>
          <ac:spMkLst>
            <pc:docMk/>
            <pc:sldMk cId="2302766718" sldId="261"/>
            <ac:spMk id="22" creationId="{FCA5C757-B61D-A4B2-07BE-B36196757BBE}"/>
          </ac:spMkLst>
        </pc:spChg>
        <pc:spChg chg="add mod">
          <ac:chgData name="Belaid, Sirine" userId="S::belaids@upmc.edu::5dcb4cf5-c058-49ea-93f8-4f4e6c877fcd" providerId="AD" clId="Web-{E94FA9D8-49E0-2317-5951-4F4429BD9715}" dt="2024-12-30T01:58:37.682" v="119" actId="14100"/>
          <ac:spMkLst>
            <pc:docMk/>
            <pc:sldMk cId="2302766718" sldId="261"/>
            <ac:spMk id="23" creationId="{F6C05B64-5D1F-993C-809A-66E67911168C}"/>
          </ac:spMkLst>
        </pc:spChg>
        <pc:spChg chg="add mod">
          <ac:chgData name="Belaid, Sirine" userId="S::belaids@upmc.edu::5dcb4cf5-c058-49ea-93f8-4f4e6c877fcd" providerId="AD" clId="Web-{E94FA9D8-49E0-2317-5951-4F4429BD9715}" dt="2024-12-30T01:58:53.547" v="121" actId="1076"/>
          <ac:spMkLst>
            <pc:docMk/>
            <pc:sldMk cId="2302766718" sldId="261"/>
            <ac:spMk id="25" creationId="{DA9CD1DE-EE36-A229-E759-1D21D0D53582}"/>
          </ac:spMkLst>
        </pc:spChg>
        <pc:spChg chg="add mod">
          <ac:chgData name="Belaid, Sirine" userId="S::belaids@upmc.edu::5dcb4cf5-c058-49ea-93f8-4f4e6c877fcd" providerId="AD" clId="Web-{E94FA9D8-49E0-2317-5951-4F4429BD9715}" dt="2024-12-30T02:00:16.253" v="130" actId="1076"/>
          <ac:spMkLst>
            <pc:docMk/>
            <pc:sldMk cId="2302766718" sldId="261"/>
            <ac:spMk id="27" creationId="{000E27A4-2024-8802-36F2-E875F2C9E993}"/>
          </ac:spMkLst>
        </pc:spChg>
        <pc:spChg chg="add mod">
          <ac:chgData name="Belaid, Sirine" userId="S::belaids@upmc.edu::5dcb4cf5-c058-49ea-93f8-4f4e6c877fcd" providerId="AD" clId="Web-{E94FA9D8-49E0-2317-5951-4F4429BD9715}" dt="2024-12-30T02:10:02.239" v="134" actId="14100"/>
          <ac:spMkLst>
            <pc:docMk/>
            <pc:sldMk cId="2302766718" sldId="261"/>
            <ac:spMk id="29" creationId="{47DA5E49-51D9-856D-DBAC-D9418D7F1836}"/>
          </ac:spMkLst>
        </pc:spChg>
        <pc:spChg chg="add mod">
          <ac:chgData name="Belaid, Sirine" userId="S::belaids@upmc.edu::5dcb4cf5-c058-49ea-93f8-4f4e6c877fcd" providerId="AD" clId="Web-{E94FA9D8-49E0-2317-5951-4F4429BD9715}" dt="2024-12-30T02:10:43.944" v="139" actId="1076"/>
          <ac:spMkLst>
            <pc:docMk/>
            <pc:sldMk cId="2302766718" sldId="261"/>
            <ac:spMk id="30" creationId="{2CDE898E-68FB-67B8-67D5-9CFD7F23871A}"/>
          </ac:spMkLst>
        </pc:spChg>
        <pc:picChg chg="add del mod">
          <ac:chgData name="Belaid, Sirine" userId="S::belaids@upmc.edu::5dcb4cf5-c058-49ea-93f8-4f4e6c877fcd" providerId="AD" clId="Web-{E94FA9D8-49E0-2317-5951-4F4429BD9715}" dt="2024-12-30T01:55:35.783" v="95"/>
          <ac:picMkLst>
            <pc:docMk/>
            <pc:sldMk cId="2302766718" sldId="261"/>
            <ac:picMk id="4" creationId="{225D6118-8FA0-CA66-53C7-1D48606DD421}"/>
          </ac:picMkLst>
        </pc:picChg>
        <pc:picChg chg="del">
          <ac:chgData name="Belaid, Sirine" userId="S::belaids@upmc.edu::5dcb4cf5-c058-49ea-93f8-4f4e6c877fcd" providerId="AD" clId="Web-{E94FA9D8-49E0-2317-5951-4F4429BD9715}" dt="2024-12-30T01:54:12.748" v="78"/>
          <ac:picMkLst>
            <pc:docMk/>
            <pc:sldMk cId="2302766718" sldId="261"/>
            <ac:picMk id="5" creationId="{BA7AEFEF-2778-5D37-4B86-BFBA360D73E1}"/>
          </ac:picMkLst>
        </pc:picChg>
        <pc:picChg chg="add mod">
          <ac:chgData name="Belaid, Sirine" userId="S::belaids@upmc.edu::5dcb4cf5-c058-49ea-93f8-4f4e6c877fcd" providerId="AD" clId="Web-{E94FA9D8-49E0-2317-5951-4F4429BD9715}" dt="2024-12-30T01:58:09.227" v="115" actId="1076"/>
          <ac:picMkLst>
            <pc:docMk/>
            <pc:sldMk cId="2302766718" sldId="261"/>
            <ac:picMk id="7" creationId="{369BDD8B-8588-2E51-8B50-724FF1061EB2}"/>
          </ac:picMkLst>
        </pc:picChg>
      </pc:sldChg>
      <pc:sldChg chg="modSp">
        <pc:chgData name="Belaid, Sirine" userId="S::belaids@upmc.edu::5dcb4cf5-c058-49ea-93f8-4f4e6c877fcd" providerId="AD" clId="Web-{E94FA9D8-49E0-2317-5951-4F4429BD9715}" dt="2024-12-29T21:06:11.544" v="2" actId="1076"/>
        <pc:sldMkLst>
          <pc:docMk/>
          <pc:sldMk cId="890179914" sldId="276"/>
        </pc:sldMkLst>
        <pc:spChg chg="mod">
          <ac:chgData name="Belaid, Sirine" userId="S::belaids@upmc.edu::5dcb4cf5-c058-49ea-93f8-4f4e6c877fcd" providerId="AD" clId="Web-{E94FA9D8-49E0-2317-5951-4F4429BD9715}" dt="2024-12-29T21:06:11.544" v="2" actId="1076"/>
          <ac:spMkLst>
            <pc:docMk/>
            <pc:sldMk cId="890179914" sldId="276"/>
            <ac:spMk id="2" creationId="{4111335E-0275-7F85-1A60-B2E9C5BFCB5E}"/>
          </ac:spMkLst>
        </pc:spChg>
      </pc:sldChg>
      <pc:sldChg chg="addSp delSp modSp">
        <pc:chgData name="Belaid, Sirine" userId="S::belaids@upmc.edu::5dcb4cf5-c058-49ea-93f8-4f4e6c877fcd" providerId="AD" clId="Web-{E94FA9D8-49E0-2317-5951-4F4429BD9715}" dt="2024-12-29T21:12:54.476" v="56" actId="1076"/>
        <pc:sldMkLst>
          <pc:docMk/>
          <pc:sldMk cId="3040203494" sldId="278"/>
        </pc:sldMkLst>
        <pc:spChg chg="mod">
          <ac:chgData name="Belaid, Sirine" userId="S::belaids@upmc.edu::5dcb4cf5-c058-49ea-93f8-4f4e6c877fcd" providerId="AD" clId="Web-{E94FA9D8-49E0-2317-5951-4F4429BD9715}" dt="2024-12-29T21:12:54.476" v="56" actId="1076"/>
          <ac:spMkLst>
            <pc:docMk/>
            <pc:sldMk cId="3040203494" sldId="278"/>
            <ac:spMk id="2" creationId="{7EF46163-41C0-84F5-5AA7-1C10CAB73748}"/>
          </ac:spMkLst>
        </pc:spChg>
        <pc:spChg chg="del mod">
          <ac:chgData name="Belaid, Sirine" userId="S::belaids@upmc.edu::5dcb4cf5-c058-49ea-93f8-4f4e6c877fcd" providerId="AD" clId="Web-{E94FA9D8-49E0-2317-5951-4F4429BD9715}" dt="2024-12-29T21:11:30.099" v="40"/>
          <ac:spMkLst>
            <pc:docMk/>
            <pc:sldMk cId="3040203494" sldId="278"/>
            <ac:spMk id="7" creationId="{8A7B1E0F-CFB0-DFF9-80E9-168D43CF19E7}"/>
          </ac:spMkLst>
        </pc:spChg>
        <pc:spChg chg="del mod">
          <ac:chgData name="Belaid, Sirine" userId="S::belaids@upmc.edu::5dcb4cf5-c058-49ea-93f8-4f4e6c877fcd" providerId="AD" clId="Web-{E94FA9D8-49E0-2317-5951-4F4429BD9715}" dt="2024-12-29T21:11:24.990" v="37"/>
          <ac:spMkLst>
            <pc:docMk/>
            <pc:sldMk cId="3040203494" sldId="278"/>
            <ac:spMk id="9" creationId="{44520E45-38F9-1C14-504C-EF35711E769E}"/>
          </ac:spMkLst>
        </pc:spChg>
        <pc:spChg chg="add mod">
          <ac:chgData name="Belaid, Sirine" userId="S::belaids@upmc.edu::5dcb4cf5-c058-49ea-93f8-4f4e6c877fcd" providerId="AD" clId="Web-{E94FA9D8-49E0-2317-5951-4F4429BD9715}" dt="2024-12-29T21:12:46.944" v="55" actId="14100"/>
          <ac:spMkLst>
            <pc:docMk/>
            <pc:sldMk cId="3040203494" sldId="278"/>
            <ac:spMk id="11" creationId="{59756321-B5F1-65EF-7F78-165D686A3807}"/>
          </ac:spMkLst>
        </pc:spChg>
        <pc:picChg chg="del">
          <ac:chgData name="Belaid, Sirine" userId="S::belaids@upmc.edu::5dcb4cf5-c058-49ea-93f8-4f4e6c877fcd" providerId="AD" clId="Web-{E94FA9D8-49E0-2317-5951-4F4429BD9715}" dt="2024-12-29T21:10:49.458" v="24"/>
          <ac:picMkLst>
            <pc:docMk/>
            <pc:sldMk cId="3040203494" sldId="278"/>
            <ac:picMk id="4" creationId="{2E5E6F8F-2001-B58C-04D3-3E9446529007}"/>
          </ac:picMkLst>
        </pc:picChg>
        <pc:picChg chg="del">
          <ac:chgData name="Belaid, Sirine" userId="S::belaids@upmc.edu::5dcb4cf5-c058-49ea-93f8-4f4e6c877fcd" providerId="AD" clId="Web-{E94FA9D8-49E0-2317-5951-4F4429BD9715}" dt="2024-12-29T21:10:50.754" v="25"/>
          <ac:picMkLst>
            <pc:docMk/>
            <pc:sldMk cId="3040203494" sldId="278"/>
            <ac:picMk id="5" creationId="{55E18AF8-C29D-D359-1718-D4962B624461}"/>
          </ac:picMkLst>
        </pc:picChg>
        <pc:picChg chg="del">
          <ac:chgData name="Belaid, Sirine" userId="S::belaids@upmc.edu::5dcb4cf5-c058-49ea-93f8-4f4e6c877fcd" providerId="AD" clId="Web-{E94FA9D8-49E0-2317-5951-4F4429BD9715}" dt="2024-12-29T21:10:51.879" v="26"/>
          <ac:picMkLst>
            <pc:docMk/>
            <pc:sldMk cId="3040203494" sldId="278"/>
            <ac:picMk id="6" creationId="{D6EBE4EA-0D21-7864-4E0F-865BFE58FC88}"/>
          </ac:picMkLst>
        </pc:picChg>
        <pc:picChg chg="add mod">
          <ac:chgData name="Belaid, Sirine" userId="S::belaids@upmc.edu::5dcb4cf5-c058-49ea-93f8-4f4e6c877fcd" providerId="AD" clId="Web-{E94FA9D8-49E0-2317-5951-4F4429BD9715}" dt="2024-12-29T21:12:15.741" v="50" actId="14100"/>
          <ac:picMkLst>
            <pc:docMk/>
            <pc:sldMk cId="3040203494" sldId="278"/>
            <ac:picMk id="8" creationId="{D227208A-0367-7B37-DBBF-C6D89A45CDC3}"/>
          </ac:picMkLst>
        </pc:picChg>
      </pc:sldChg>
      <pc:sldChg chg="addSp delSp modSp">
        <pc:chgData name="Belaid, Sirine" userId="S::belaids@upmc.edu::5dcb4cf5-c058-49ea-93f8-4f4e6c877fcd" providerId="AD" clId="Web-{E94FA9D8-49E0-2317-5951-4F4429BD9715}" dt="2024-12-30T02:10:28.053" v="137"/>
        <pc:sldMkLst>
          <pc:docMk/>
          <pc:sldMk cId="1691135755" sldId="279"/>
        </pc:sldMkLst>
        <pc:spChg chg="add del mod">
          <ac:chgData name="Belaid, Sirine" userId="S::belaids@upmc.edu::5dcb4cf5-c058-49ea-93f8-4f4e6c877fcd" providerId="AD" clId="Web-{E94FA9D8-49E0-2317-5951-4F4429BD9715}" dt="2024-12-30T02:10:28.053" v="137"/>
          <ac:spMkLst>
            <pc:docMk/>
            <pc:sldMk cId="1691135755" sldId="279"/>
            <ac:spMk id="6" creationId="{2CDE898E-68FB-67B8-67D5-9CFD7F23871A}"/>
          </ac:spMkLst>
        </pc:spChg>
      </pc:sldChg>
      <pc:sldChg chg="modSp">
        <pc:chgData name="Belaid, Sirine" userId="S::belaids@upmc.edu::5dcb4cf5-c058-49ea-93f8-4f4e6c877fcd" providerId="AD" clId="Web-{E94FA9D8-49E0-2317-5951-4F4429BD9715}" dt="2024-12-30T02:21:15.172" v="289" actId="1076"/>
        <pc:sldMkLst>
          <pc:docMk/>
          <pc:sldMk cId="2334828839" sldId="280"/>
        </pc:sldMkLst>
        <pc:spChg chg="mod">
          <ac:chgData name="Belaid, Sirine" userId="S::belaids@upmc.edu::5dcb4cf5-c058-49ea-93f8-4f4e6c877fcd" providerId="AD" clId="Web-{E94FA9D8-49E0-2317-5951-4F4429BD9715}" dt="2024-12-30T02:21:15.172" v="289" actId="1076"/>
          <ac:spMkLst>
            <pc:docMk/>
            <pc:sldMk cId="2334828839" sldId="280"/>
            <ac:spMk id="4" creationId="{D1BCFB39-CF04-FACC-1188-03C1357FB1F6}"/>
          </ac:spMkLst>
        </pc:spChg>
        <pc:spChg chg="mod">
          <ac:chgData name="Belaid, Sirine" userId="S::belaids@upmc.edu::5dcb4cf5-c058-49ea-93f8-4f4e6c877fcd" providerId="AD" clId="Web-{E94FA9D8-49E0-2317-5951-4F4429BD9715}" dt="2024-12-30T02:16:10.246" v="211" actId="20577"/>
          <ac:spMkLst>
            <pc:docMk/>
            <pc:sldMk cId="2334828839" sldId="280"/>
            <ac:spMk id="8" creationId="{BB0D772D-D99B-C49D-9E5F-43EFC2F0F2CB}"/>
          </ac:spMkLst>
        </pc:spChg>
      </pc:sldChg>
      <pc:sldChg chg="modSp">
        <pc:chgData name="Belaid, Sirine" userId="S::belaids@upmc.edu::5dcb4cf5-c058-49ea-93f8-4f4e6c877fcd" providerId="AD" clId="Web-{E94FA9D8-49E0-2317-5951-4F4429BD9715}" dt="2024-12-30T02:28:35.061" v="292" actId="20577"/>
        <pc:sldMkLst>
          <pc:docMk/>
          <pc:sldMk cId="1811786192" sldId="281"/>
        </pc:sldMkLst>
        <pc:spChg chg="mod">
          <ac:chgData name="Belaid, Sirine" userId="S::belaids@upmc.edu::5dcb4cf5-c058-49ea-93f8-4f4e6c877fcd" providerId="AD" clId="Web-{E94FA9D8-49E0-2317-5951-4F4429BD9715}" dt="2024-12-30T02:28:35.061" v="292" actId="20577"/>
          <ac:spMkLst>
            <pc:docMk/>
            <pc:sldMk cId="1811786192" sldId="281"/>
            <ac:spMk id="4" creationId="{B91A50B9-F3FA-EFE6-8ED6-40E75CF0009A}"/>
          </ac:spMkLst>
        </pc:spChg>
      </pc:sldChg>
      <pc:sldChg chg="modSp">
        <pc:chgData name="Belaid, Sirine" userId="S::belaids@upmc.edu::5dcb4cf5-c058-49ea-93f8-4f4e6c877fcd" providerId="AD" clId="Web-{E94FA9D8-49E0-2317-5951-4F4429BD9715}" dt="2024-12-30T02:29:28.172" v="294" actId="20577"/>
        <pc:sldMkLst>
          <pc:docMk/>
          <pc:sldMk cId="534894233" sldId="282"/>
        </pc:sldMkLst>
        <pc:spChg chg="mod">
          <ac:chgData name="Belaid, Sirine" userId="S::belaids@upmc.edu::5dcb4cf5-c058-49ea-93f8-4f4e6c877fcd" providerId="AD" clId="Web-{E94FA9D8-49E0-2317-5951-4F4429BD9715}" dt="2024-12-30T02:29:28.172" v="294" actId="20577"/>
          <ac:spMkLst>
            <pc:docMk/>
            <pc:sldMk cId="534894233" sldId="282"/>
            <ac:spMk id="3" creationId="{A1B7AAB6-BB61-7DFB-4D0F-445959B95253}"/>
          </ac:spMkLst>
        </pc:spChg>
      </pc:sldChg>
      <pc:sldChg chg="addSp modSp new">
        <pc:chgData name="Belaid, Sirine" userId="S::belaids@upmc.edu::5dcb4cf5-c058-49ea-93f8-4f4e6c877fcd" providerId="AD" clId="Web-{E94FA9D8-49E0-2317-5951-4F4429BD9715}" dt="2024-12-29T21:09:33.878" v="22" actId="1076"/>
        <pc:sldMkLst>
          <pc:docMk/>
          <pc:sldMk cId="459350262" sldId="398"/>
        </pc:sldMkLst>
        <pc:spChg chg="mod">
          <ac:chgData name="Belaid, Sirine" userId="S::belaids@upmc.edu::5dcb4cf5-c058-49ea-93f8-4f4e6c877fcd" providerId="AD" clId="Web-{E94FA9D8-49E0-2317-5951-4F4429BD9715}" dt="2024-12-29T21:09:33.878" v="22" actId="1076"/>
          <ac:spMkLst>
            <pc:docMk/>
            <pc:sldMk cId="459350262" sldId="398"/>
            <ac:spMk id="2" creationId="{3B7A066D-6368-016B-92A4-33AFDAE81693}"/>
          </ac:spMkLst>
        </pc:spChg>
        <pc:spChg chg="add mod">
          <ac:chgData name="Belaid, Sirine" userId="S::belaids@upmc.edu::5dcb4cf5-c058-49ea-93f8-4f4e6c877fcd" providerId="AD" clId="Web-{E94FA9D8-49E0-2317-5951-4F4429BD9715}" dt="2024-12-29T21:09:27.440" v="21" actId="14100"/>
          <ac:spMkLst>
            <pc:docMk/>
            <pc:sldMk cId="459350262" sldId="398"/>
            <ac:spMk id="6" creationId="{33A021EB-33D7-6BA1-5AF7-3FFF2FEFC68C}"/>
          </ac:spMkLst>
        </pc:spChg>
        <pc:picChg chg="add mod">
          <ac:chgData name="Belaid, Sirine" userId="S::belaids@upmc.edu::5dcb4cf5-c058-49ea-93f8-4f4e6c877fcd" providerId="AD" clId="Web-{E94FA9D8-49E0-2317-5951-4F4429BD9715}" dt="2024-12-29T21:07:16.702" v="13" actId="1076"/>
          <ac:picMkLst>
            <pc:docMk/>
            <pc:sldMk cId="459350262" sldId="398"/>
            <ac:picMk id="4" creationId="{732CD579-E6AB-D084-B1A7-6F62D0CDB0C5}"/>
          </ac:picMkLst>
        </pc:picChg>
      </pc:sldChg>
      <pc:sldChg chg="add replId">
        <pc:chgData name="Belaid, Sirine" userId="S::belaids@upmc.edu::5dcb4cf5-c058-49ea-93f8-4f4e6c877fcd" providerId="AD" clId="Web-{E94FA9D8-49E0-2317-5951-4F4429BD9715}" dt="2024-12-29T21:10:45.801" v="23"/>
        <pc:sldMkLst>
          <pc:docMk/>
          <pc:sldMk cId="1747746462" sldId="399"/>
        </pc:sldMkLst>
      </pc:sldChg>
      <pc:sldChg chg="modSp new">
        <pc:chgData name="Belaid, Sirine" userId="S::belaids@upmc.edu::5dcb4cf5-c058-49ea-93f8-4f4e6c877fcd" providerId="AD" clId="Web-{E94FA9D8-49E0-2317-5951-4F4429BD9715}" dt="2024-12-30T01:53:35.027" v="76" actId="20577"/>
        <pc:sldMkLst>
          <pc:docMk/>
          <pc:sldMk cId="2984259280" sldId="400"/>
        </pc:sldMkLst>
        <pc:spChg chg="mod">
          <ac:chgData name="Belaid, Sirine" userId="S::belaids@upmc.edu::5dcb4cf5-c058-49ea-93f8-4f4e6c877fcd" providerId="AD" clId="Web-{E94FA9D8-49E0-2317-5951-4F4429BD9715}" dt="2024-12-30T01:53:35.027" v="76" actId="20577"/>
          <ac:spMkLst>
            <pc:docMk/>
            <pc:sldMk cId="2984259280" sldId="400"/>
            <ac:spMk id="2" creationId="{CD89118C-04CE-C79A-1972-1A5D750165A0}"/>
          </ac:spMkLst>
        </pc:spChg>
      </pc:sldChg>
      <pc:sldChg chg="modSp add replId">
        <pc:chgData name="Belaid, Sirine" userId="S::belaids@upmc.edu::5dcb4cf5-c058-49ea-93f8-4f4e6c877fcd" providerId="AD" clId="Web-{E94FA9D8-49E0-2317-5951-4F4429BD9715}" dt="2024-12-30T02:20:16.200" v="283" actId="20577"/>
        <pc:sldMkLst>
          <pc:docMk/>
          <pc:sldMk cId="1613301265" sldId="401"/>
        </pc:sldMkLst>
        <pc:spChg chg="mod">
          <ac:chgData name="Belaid, Sirine" userId="S::belaids@upmc.edu::5dcb4cf5-c058-49ea-93f8-4f4e6c877fcd" providerId="AD" clId="Web-{E94FA9D8-49E0-2317-5951-4F4429BD9715}" dt="2024-12-30T02:20:16.200" v="283" actId="20577"/>
          <ac:spMkLst>
            <pc:docMk/>
            <pc:sldMk cId="1613301265" sldId="401"/>
            <ac:spMk id="2" creationId="{049050E2-8D86-1CE2-1DAE-D1D3F05419D4}"/>
          </ac:spMkLst>
        </pc:spChg>
        <pc:spChg chg="mod">
          <ac:chgData name="Belaid, Sirine" userId="S::belaids@upmc.edu::5dcb4cf5-c058-49ea-93f8-4f4e6c877fcd" providerId="AD" clId="Web-{E94FA9D8-49E0-2317-5951-4F4429BD9715}" dt="2024-12-30T01:59:37.408" v="126" actId="14100"/>
          <ac:spMkLst>
            <pc:docMk/>
            <pc:sldMk cId="1613301265" sldId="401"/>
            <ac:spMk id="12" creationId="{AF3D8C70-3150-27C0-2D43-04BB4B781995}"/>
          </ac:spMkLst>
        </pc:spChg>
        <pc:spChg chg="mod">
          <ac:chgData name="Belaid, Sirine" userId="S::belaids@upmc.edu::5dcb4cf5-c058-49ea-93f8-4f4e6c877fcd" providerId="AD" clId="Web-{E94FA9D8-49E0-2317-5951-4F4429BD9715}" dt="2024-12-30T01:59:43.689" v="127" actId="14100"/>
          <ac:spMkLst>
            <pc:docMk/>
            <pc:sldMk cId="1613301265" sldId="401"/>
            <ac:spMk id="14" creationId="{30DDA2BD-58CC-3571-0D62-CB72B2E12291}"/>
          </ac:spMkLst>
        </pc:spChg>
      </pc:sldChg>
      <pc:sldChg chg="addSp delSp modSp add replId">
        <pc:chgData name="Belaid, Sirine" userId="S::belaids@upmc.edu::5dcb4cf5-c058-49ea-93f8-4f4e6c877fcd" providerId="AD" clId="Web-{E94FA9D8-49E0-2317-5951-4F4429BD9715}" dt="2024-12-30T02:20:35.639" v="288" actId="1076"/>
        <pc:sldMkLst>
          <pc:docMk/>
          <pc:sldMk cId="3377343647" sldId="402"/>
        </pc:sldMkLst>
        <pc:spChg chg="mod">
          <ac:chgData name="Belaid, Sirine" userId="S::belaids@upmc.edu::5dcb4cf5-c058-49ea-93f8-4f4e6c877fcd" providerId="AD" clId="Web-{E94FA9D8-49E0-2317-5951-4F4429BD9715}" dt="2024-12-30T02:12:04.542" v="150" actId="20577"/>
          <ac:spMkLst>
            <pc:docMk/>
            <pc:sldMk cId="3377343647" sldId="402"/>
            <ac:spMk id="2" creationId="{7ADAE76A-E90F-16DD-E8F0-6521F5FFBD56}"/>
          </ac:spMkLst>
        </pc:spChg>
        <pc:spChg chg="mod">
          <ac:chgData name="Belaid, Sirine" userId="S::belaids@upmc.edu::5dcb4cf5-c058-49ea-93f8-4f4e6c877fcd" providerId="AD" clId="Web-{E94FA9D8-49E0-2317-5951-4F4429BD9715}" dt="2024-12-30T02:13:17.420" v="168" actId="20577"/>
          <ac:spMkLst>
            <pc:docMk/>
            <pc:sldMk cId="3377343647" sldId="402"/>
            <ac:spMk id="3" creationId="{40154E4A-504B-F285-191C-FC2B0F11F3E3}"/>
          </ac:spMkLst>
        </pc:spChg>
        <pc:spChg chg="del">
          <ac:chgData name="Belaid, Sirine" userId="S::belaids@upmc.edu::5dcb4cf5-c058-49ea-93f8-4f4e6c877fcd" providerId="AD" clId="Web-{E94FA9D8-49E0-2317-5951-4F4429BD9715}" dt="2024-12-30T02:11:38.165" v="142"/>
          <ac:spMkLst>
            <pc:docMk/>
            <pc:sldMk cId="3377343647" sldId="402"/>
            <ac:spMk id="5" creationId="{8B453B78-8D0F-35EB-2A95-E41CE867A315}"/>
          </ac:spMkLst>
        </pc:spChg>
        <pc:spChg chg="del">
          <ac:chgData name="Belaid, Sirine" userId="S::belaids@upmc.edu::5dcb4cf5-c058-49ea-93f8-4f4e6c877fcd" providerId="AD" clId="Web-{E94FA9D8-49E0-2317-5951-4F4429BD9715}" dt="2024-12-30T02:11:39.369" v="143"/>
          <ac:spMkLst>
            <pc:docMk/>
            <pc:sldMk cId="3377343647" sldId="402"/>
            <ac:spMk id="8" creationId="{4154C069-3066-A58E-282A-AA608DBD0C9A}"/>
          </ac:spMkLst>
        </pc:spChg>
        <pc:spChg chg="add mod">
          <ac:chgData name="Belaid, Sirine" userId="S::belaids@upmc.edu::5dcb4cf5-c058-49ea-93f8-4f4e6c877fcd" providerId="AD" clId="Web-{E94FA9D8-49E0-2317-5951-4F4429BD9715}" dt="2024-12-30T02:20:26.810" v="285" actId="1076"/>
          <ac:spMkLst>
            <pc:docMk/>
            <pc:sldMk cId="3377343647" sldId="402"/>
            <ac:spMk id="9" creationId="{7385A5BB-5602-E4F2-783F-32CDB9FB9E7B}"/>
          </ac:spMkLst>
        </pc:spChg>
        <pc:spChg chg="del">
          <ac:chgData name="Belaid, Sirine" userId="S::belaids@upmc.edu::5dcb4cf5-c058-49ea-93f8-4f4e6c877fcd" providerId="AD" clId="Web-{E94FA9D8-49E0-2317-5951-4F4429BD9715}" dt="2024-12-30T02:11:40.494" v="144"/>
          <ac:spMkLst>
            <pc:docMk/>
            <pc:sldMk cId="3377343647" sldId="402"/>
            <ac:spMk id="10" creationId="{83D74C53-AD22-CFA3-C6B1-BAA310FD1C03}"/>
          </ac:spMkLst>
        </pc:spChg>
        <pc:spChg chg="add mod">
          <ac:chgData name="Belaid, Sirine" userId="S::belaids@upmc.edu::5dcb4cf5-c058-49ea-93f8-4f4e6c877fcd" providerId="AD" clId="Web-{E94FA9D8-49E0-2317-5951-4F4429BD9715}" dt="2024-12-30T02:20:35.639" v="288" actId="1076"/>
          <ac:spMkLst>
            <pc:docMk/>
            <pc:sldMk cId="3377343647" sldId="402"/>
            <ac:spMk id="12" creationId="{98798A1F-5FDA-9339-F16C-1C42BBCA8ADB}"/>
          </ac:spMkLst>
        </pc:spChg>
        <pc:picChg chg="add mod">
          <ac:chgData name="Belaid, Sirine" userId="S::belaids@upmc.edu::5dcb4cf5-c058-49ea-93f8-4f4e6c877fcd" providerId="AD" clId="Web-{E94FA9D8-49E0-2317-5951-4F4429BD9715}" dt="2024-12-30T02:11:59.885" v="149" actId="1076"/>
          <ac:picMkLst>
            <pc:docMk/>
            <pc:sldMk cId="3377343647" sldId="402"/>
            <ac:picMk id="4" creationId="{2C028B43-8789-C65A-00AD-048C0943AE95}"/>
          </ac:picMkLst>
        </pc:picChg>
        <pc:picChg chg="del">
          <ac:chgData name="Belaid, Sirine" userId="S::belaids@upmc.edu::5dcb4cf5-c058-49ea-93f8-4f4e6c877fcd" providerId="AD" clId="Web-{E94FA9D8-49E0-2317-5951-4F4429BD9715}" dt="2024-12-30T02:11:36.650" v="141"/>
          <ac:picMkLst>
            <pc:docMk/>
            <pc:sldMk cId="3377343647" sldId="402"/>
            <ac:picMk id="7" creationId="{1EAC6257-F9E8-3BF4-F995-1D9310AA4073}"/>
          </ac:picMkLst>
        </pc:picChg>
      </pc:sldChg>
      <pc:sldChg chg="addSp modSp add replId">
        <pc:chgData name="Belaid, Sirine" userId="S::belaids@upmc.edu::5dcb4cf5-c058-49ea-93f8-4f4e6c877fcd" providerId="AD" clId="Web-{E94FA9D8-49E0-2317-5951-4F4429BD9715}" dt="2024-12-30T02:19:56.653" v="279" actId="20577"/>
        <pc:sldMkLst>
          <pc:docMk/>
          <pc:sldMk cId="1498905373" sldId="403"/>
        </pc:sldMkLst>
        <pc:spChg chg="mod">
          <ac:chgData name="Belaid, Sirine" userId="S::belaids@upmc.edu::5dcb4cf5-c058-49ea-93f8-4f4e6c877fcd" providerId="AD" clId="Web-{E94FA9D8-49E0-2317-5951-4F4429BD9715}" dt="2024-12-30T02:19:44.949" v="277" actId="1076"/>
          <ac:spMkLst>
            <pc:docMk/>
            <pc:sldMk cId="1498905373" sldId="403"/>
            <ac:spMk id="4" creationId="{D1BCFB39-CF04-FACC-1188-03C1357FB1F6}"/>
          </ac:spMkLst>
        </pc:spChg>
        <pc:spChg chg="add mod">
          <ac:chgData name="Belaid, Sirine" userId="S::belaids@upmc.edu::5dcb4cf5-c058-49ea-93f8-4f4e6c877fcd" providerId="AD" clId="Web-{E94FA9D8-49E0-2317-5951-4F4429BD9715}" dt="2024-12-30T02:17:25.020" v="229" actId="1076"/>
          <ac:spMkLst>
            <pc:docMk/>
            <pc:sldMk cId="1498905373" sldId="403"/>
            <ac:spMk id="5" creationId="{4CFA9191-1EF9-A2BF-E33F-D401D29E4546}"/>
          </ac:spMkLst>
        </pc:spChg>
        <pc:spChg chg="add mod">
          <ac:chgData name="Belaid, Sirine" userId="S::belaids@upmc.edu::5dcb4cf5-c058-49ea-93f8-4f4e6c877fcd" providerId="AD" clId="Web-{E94FA9D8-49E0-2317-5951-4F4429BD9715}" dt="2024-12-30T02:18:37.602" v="255" actId="20577"/>
          <ac:spMkLst>
            <pc:docMk/>
            <pc:sldMk cId="1498905373" sldId="403"/>
            <ac:spMk id="7" creationId="{5C057910-4108-11C7-8E6E-329563B5D503}"/>
          </ac:spMkLst>
        </pc:spChg>
        <pc:spChg chg="mod">
          <ac:chgData name="Belaid, Sirine" userId="S::belaids@upmc.edu::5dcb4cf5-c058-49ea-93f8-4f4e6c877fcd" providerId="AD" clId="Web-{E94FA9D8-49E0-2317-5951-4F4429BD9715}" dt="2024-12-30T02:19:56.653" v="279" actId="20577"/>
          <ac:spMkLst>
            <pc:docMk/>
            <pc:sldMk cId="1498905373" sldId="403"/>
            <ac:spMk id="8" creationId="{BB0D772D-D99B-C49D-9E5F-43EFC2F0F2CB}"/>
          </ac:spMkLst>
        </pc:spChg>
      </pc:sldChg>
      <pc:sldChg chg="addSp delSp modSp add replId">
        <pc:chgData name="Belaid, Sirine" userId="S::belaids@upmc.edu::5dcb4cf5-c058-49ea-93f8-4f4e6c877fcd" providerId="AD" clId="Web-{E94FA9D8-49E0-2317-5951-4F4429BD9715}" dt="2024-12-30T03:02:00.425" v="408"/>
        <pc:sldMkLst>
          <pc:docMk/>
          <pc:sldMk cId="4036016796" sldId="404"/>
        </pc:sldMkLst>
        <pc:spChg chg="mod">
          <ac:chgData name="Belaid, Sirine" userId="S::belaids@upmc.edu::5dcb4cf5-c058-49ea-93f8-4f4e6c877fcd" providerId="AD" clId="Web-{E94FA9D8-49E0-2317-5951-4F4429BD9715}" dt="2024-12-30T02:58:21.243" v="395" actId="20577"/>
          <ac:spMkLst>
            <pc:docMk/>
            <pc:sldMk cId="4036016796" sldId="404"/>
            <ac:spMk id="3" creationId="{A1B7AAB6-BB61-7DFB-4D0F-445959B95253}"/>
          </ac:spMkLst>
        </pc:spChg>
        <pc:spChg chg="del">
          <ac:chgData name="Belaid, Sirine" userId="S::belaids@upmc.edu::5dcb4cf5-c058-49ea-93f8-4f4e6c877fcd" providerId="AD" clId="Web-{E94FA9D8-49E0-2317-5951-4F4429BD9715}" dt="2024-12-30T02:29:41.376" v="297"/>
          <ac:spMkLst>
            <pc:docMk/>
            <pc:sldMk cId="4036016796" sldId="404"/>
            <ac:spMk id="5" creationId="{190BDE7B-1907-C434-9171-AC3C3EE9BD0D}"/>
          </ac:spMkLst>
        </pc:spChg>
        <pc:spChg chg="add mod">
          <ac:chgData name="Belaid, Sirine" userId="S::belaids@upmc.edu::5dcb4cf5-c058-49ea-93f8-4f4e6c877fcd" providerId="AD" clId="Web-{E94FA9D8-49E0-2317-5951-4F4429BD9715}" dt="2024-12-30T02:31:32.459" v="325" actId="1076"/>
          <ac:spMkLst>
            <pc:docMk/>
            <pc:sldMk cId="4036016796" sldId="404"/>
            <ac:spMk id="10" creationId="{47C246D0-D2E0-84EF-151E-7CD30CFA3F7E}"/>
          </ac:spMkLst>
        </pc:spChg>
        <pc:spChg chg="add mod">
          <ac:chgData name="Belaid, Sirine" userId="S::belaids@upmc.edu::5dcb4cf5-c058-49ea-93f8-4f4e6c877fcd" providerId="AD" clId="Web-{E94FA9D8-49E0-2317-5951-4F4429BD9715}" dt="2024-12-30T02:31:52.788" v="327" actId="1076"/>
          <ac:spMkLst>
            <pc:docMk/>
            <pc:sldMk cId="4036016796" sldId="404"/>
            <ac:spMk id="11" creationId="{08F33A21-6171-4CFB-54FF-2125A92E57E6}"/>
          </ac:spMkLst>
        </pc:spChg>
        <pc:picChg chg="del">
          <ac:chgData name="Belaid, Sirine" userId="S::belaids@upmc.edu::5dcb4cf5-c058-49ea-93f8-4f4e6c877fcd" providerId="AD" clId="Web-{E94FA9D8-49E0-2317-5951-4F4429BD9715}" dt="2024-12-30T02:29:38.782" v="296"/>
          <ac:picMkLst>
            <pc:docMk/>
            <pc:sldMk cId="4036016796" sldId="404"/>
            <ac:picMk id="6" creationId="{1317407D-2086-93D9-DF86-CB319101199B}"/>
          </ac:picMkLst>
        </pc:picChg>
        <pc:picChg chg="del">
          <ac:chgData name="Belaid, Sirine" userId="S::belaids@upmc.edu::5dcb4cf5-c058-49ea-93f8-4f4e6c877fcd" providerId="AD" clId="Web-{E94FA9D8-49E0-2317-5951-4F4429BD9715}" dt="2024-12-30T02:30:03.924" v="303"/>
          <ac:picMkLst>
            <pc:docMk/>
            <pc:sldMk cId="4036016796" sldId="404"/>
            <ac:picMk id="7" creationId="{046213C4-A40F-67FD-2B8E-5264F73037CF}"/>
          </ac:picMkLst>
        </pc:picChg>
        <pc:picChg chg="add mod">
          <ac:chgData name="Belaid, Sirine" userId="S::belaids@upmc.edu::5dcb4cf5-c058-49ea-93f8-4f4e6c877fcd" providerId="AD" clId="Web-{E94FA9D8-49E0-2317-5951-4F4429BD9715}" dt="2024-12-30T02:31:05.771" v="323" actId="1076"/>
          <ac:picMkLst>
            <pc:docMk/>
            <pc:sldMk cId="4036016796" sldId="404"/>
            <ac:picMk id="8" creationId="{55F68537-2EEE-CDBB-2FAA-5BC16621E531}"/>
          </ac:picMkLst>
        </pc:picChg>
        <pc:picChg chg="add del mod">
          <ac:chgData name="Belaid, Sirine" userId="S::belaids@upmc.edu::5dcb4cf5-c058-49ea-93f8-4f4e6c877fcd" providerId="AD" clId="Web-{E94FA9D8-49E0-2317-5951-4F4429BD9715}" dt="2024-12-30T03:02:00.425" v="408"/>
          <ac:picMkLst>
            <pc:docMk/>
            <pc:sldMk cId="4036016796" sldId="404"/>
            <ac:picMk id="12" creationId="{F4B031F5-485E-6461-36C5-0A9ECB7A99E8}"/>
          </ac:picMkLst>
        </pc:picChg>
      </pc:sldChg>
      <pc:sldChg chg="addSp delSp modSp add replId">
        <pc:chgData name="Belaid, Sirine" userId="S::belaids@upmc.edu::5dcb4cf5-c058-49ea-93f8-4f4e6c877fcd" providerId="AD" clId="Web-{E94FA9D8-49E0-2317-5951-4F4429BD9715}" dt="2024-12-30T02:59:05.260" v="397"/>
        <pc:sldMkLst>
          <pc:docMk/>
          <pc:sldMk cId="920600292" sldId="405"/>
        </pc:sldMkLst>
        <pc:spChg chg="add mod">
          <ac:chgData name="Belaid, Sirine" userId="S::belaids@upmc.edu::5dcb4cf5-c058-49ea-93f8-4f4e6c877fcd" providerId="AD" clId="Web-{E94FA9D8-49E0-2317-5951-4F4429BD9715}" dt="2024-12-30T02:56:42.051" v="375" actId="1076"/>
          <ac:spMkLst>
            <pc:docMk/>
            <pc:sldMk cId="920600292" sldId="405"/>
            <ac:spMk id="8" creationId="{094992B6-96F9-5D9F-A0DD-0857BDE47C41}"/>
          </ac:spMkLst>
        </pc:spChg>
        <pc:spChg chg="del">
          <ac:chgData name="Belaid, Sirine" userId="S::belaids@upmc.edu::5dcb4cf5-c058-49ea-93f8-4f4e6c877fcd" providerId="AD" clId="Web-{E94FA9D8-49E0-2317-5951-4F4429BD9715}" dt="2024-12-30T02:54:46.952" v="357"/>
          <ac:spMkLst>
            <pc:docMk/>
            <pc:sldMk cId="920600292" sldId="405"/>
            <ac:spMk id="9" creationId="{F182FC2C-ABCE-D16D-70B2-F71259526D8E}"/>
          </ac:spMkLst>
        </pc:spChg>
        <pc:spChg chg="add mod">
          <ac:chgData name="Belaid, Sirine" userId="S::belaids@upmc.edu::5dcb4cf5-c058-49ea-93f8-4f4e6c877fcd" providerId="AD" clId="Web-{E94FA9D8-49E0-2317-5951-4F4429BD9715}" dt="2024-12-30T02:57:21.115" v="382" actId="14100"/>
          <ac:spMkLst>
            <pc:docMk/>
            <pc:sldMk cId="920600292" sldId="405"/>
            <ac:spMk id="10" creationId="{C6DD160C-5935-6FBB-69FC-78A30C4570CD}"/>
          </ac:spMkLst>
        </pc:spChg>
        <pc:spChg chg="add mod">
          <ac:chgData name="Belaid, Sirine" userId="S::belaids@upmc.edu::5dcb4cf5-c058-49ea-93f8-4f4e6c877fcd" providerId="AD" clId="Web-{E94FA9D8-49E0-2317-5951-4F4429BD9715}" dt="2024-12-30T02:57:30.287" v="385" actId="14100"/>
          <ac:spMkLst>
            <pc:docMk/>
            <pc:sldMk cId="920600292" sldId="405"/>
            <ac:spMk id="11" creationId="{C6DD160C-5935-6FBB-69FC-78A30C4570CD}"/>
          </ac:spMkLst>
        </pc:spChg>
        <pc:spChg chg="add mod">
          <ac:chgData name="Belaid, Sirine" userId="S::belaids@upmc.edu::5dcb4cf5-c058-49ea-93f8-4f4e6c877fcd" providerId="AD" clId="Web-{E94FA9D8-49E0-2317-5951-4F4429BD9715}" dt="2024-12-30T02:57:50.038" v="389" actId="14100"/>
          <ac:spMkLst>
            <pc:docMk/>
            <pc:sldMk cId="920600292" sldId="405"/>
            <ac:spMk id="12" creationId="{C6DD160C-5935-6FBB-69FC-78A30C4570CD}"/>
          </ac:spMkLst>
        </pc:spChg>
        <pc:spChg chg="add mod">
          <ac:chgData name="Belaid, Sirine" userId="S::belaids@upmc.edu::5dcb4cf5-c058-49ea-93f8-4f4e6c877fcd" providerId="AD" clId="Web-{E94FA9D8-49E0-2317-5951-4F4429BD9715}" dt="2024-12-30T02:58:10.539" v="393" actId="14100"/>
          <ac:spMkLst>
            <pc:docMk/>
            <pc:sldMk cId="920600292" sldId="405"/>
            <ac:spMk id="13" creationId="{C6DD160C-5935-6FBB-69FC-78A30C4570CD}"/>
          </ac:spMkLst>
        </pc:spChg>
        <pc:picChg chg="del">
          <ac:chgData name="Belaid, Sirine" userId="S::belaids@upmc.edu::5dcb4cf5-c058-49ea-93f8-4f4e6c877fcd" providerId="AD" clId="Web-{E94FA9D8-49E0-2317-5951-4F4429BD9715}" dt="2024-12-30T02:54:45.217" v="356"/>
          <ac:picMkLst>
            <pc:docMk/>
            <pc:sldMk cId="920600292" sldId="405"/>
            <ac:picMk id="3" creationId="{1F3F9A4E-56BD-D16E-B2AC-BADC314FDA49}"/>
          </ac:picMkLst>
        </pc:picChg>
        <pc:picChg chg="del">
          <ac:chgData name="Belaid, Sirine" userId="S::belaids@upmc.edu::5dcb4cf5-c058-49ea-93f8-4f4e6c877fcd" providerId="AD" clId="Web-{E94FA9D8-49E0-2317-5951-4F4429BD9715}" dt="2024-12-30T02:54:10.559" v="354"/>
          <ac:picMkLst>
            <pc:docMk/>
            <pc:sldMk cId="920600292" sldId="405"/>
            <ac:picMk id="4" creationId="{1DF4EBF3-CB21-4D9B-C581-71579BE204AD}"/>
          </ac:picMkLst>
        </pc:picChg>
        <pc:picChg chg="add mod">
          <ac:chgData name="Belaid, Sirine" userId="S::belaids@upmc.edu::5dcb4cf5-c058-49ea-93f8-4f4e6c877fcd" providerId="AD" clId="Web-{E94FA9D8-49E0-2317-5951-4F4429BD9715}" dt="2024-12-30T02:55:17.578" v="361" actId="14100"/>
          <ac:picMkLst>
            <pc:docMk/>
            <pc:sldMk cId="920600292" sldId="405"/>
            <ac:picMk id="5" creationId="{8AA6F4EE-6D07-A524-BDBC-871E8D75D3F8}"/>
          </ac:picMkLst>
        </pc:picChg>
        <pc:picChg chg="del">
          <ac:chgData name="Belaid, Sirine" userId="S::belaids@upmc.edu::5dcb4cf5-c058-49ea-93f8-4f4e6c877fcd" providerId="AD" clId="Web-{E94FA9D8-49E0-2317-5951-4F4429BD9715}" dt="2024-12-30T02:54:13.747" v="355"/>
          <ac:picMkLst>
            <pc:docMk/>
            <pc:sldMk cId="920600292" sldId="405"/>
            <ac:picMk id="6" creationId="{58CFA5DF-D2A1-3AD6-8599-EA51C68057C4}"/>
          </ac:picMkLst>
        </pc:picChg>
        <pc:picChg chg="add mod">
          <ac:chgData name="Belaid, Sirine" userId="S::belaids@upmc.edu::5dcb4cf5-c058-49ea-93f8-4f4e6c877fcd" providerId="AD" clId="Web-{E94FA9D8-49E0-2317-5951-4F4429BD9715}" dt="2024-12-30T02:56:04.596" v="364" actId="14100"/>
          <ac:picMkLst>
            <pc:docMk/>
            <pc:sldMk cId="920600292" sldId="405"/>
            <ac:picMk id="7" creationId="{31A597FD-5F3C-7818-24BD-FCD61E2FE9DD}"/>
          </ac:picMkLst>
        </pc:picChg>
        <pc:picChg chg="add del mod">
          <ac:chgData name="Belaid, Sirine" userId="S::belaids@upmc.edu::5dcb4cf5-c058-49ea-93f8-4f4e6c877fcd" providerId="AD" clId="Web-{E94FA9D8-49E0-2317-5951-4F4429BD9715}" dt="2024-12-30T02:59:05.260" v="397"/>
          <ac:picMkLst>
            <pc:docMk/>
            <pc:sldMk cId="920600292" sldId="405"/>
            <ac:picMk id="14" creationId="{12280710-72CA-112A-5BD2-E1EBFF36F180}"/>
          </ac:picMkLst>
        </pc:picChg>
      </pc:sldChg>
      <pc:sldChg chg="addSp delSp modSp add del replId">
        <pc:chgData name="Belaid, Sirine" userId="S::belaids@upmc.edu::5dcb4cf5-c058-49ea-93f8-4f4e6c877fcd" providerId="AD" clId="Web-{E94FA9D8-49E0-2317-5951-4F4429BD9715}" dt="2024-12-30T02:56:57.395" v="376"/>
        <pc:sldMkLst>
          <pc:docMk/>
          <pc:sldMk cId="152165303" sldId="406"/>
        </pc:sldMkLst>
        <pc:spChg chg="add mod">
          <ac:chgData name="Belaid, Sirine" userId="S::belaids@upmc.edu::5dcb4cf5-c058-49ea-93f8-4f4e6c877fcd" providerId="AD" clId="Web-{E94FA9D8-49E0-2317-5951-4F4429BD9715}" dt="2024-12-30T02:48:41.482" v="351" actId="14100"/>
          <ac:spMkLst>
            <pc:docMk/>
            <pc:sldMk cId="152165303" sldId="406"/>
            <ac:spMk id="8" creationId="{C6DD160C-5935-6FBB-69FC-78A30C4570CD}"/>
          </ac:spMkLst>
        </pc:spChg>
        <pc:picChg chg="add mod">
          <ac:chgData name="Belaid, Sirine" userId="S::belaids@upmc.edu::5dcb4cf5-c058-49ea-93f8-4f4e6c877fcd" providerId="AD" clId="Web-{E94FA9D8-49E0-2317-5951-4F4429BD9715}" dt="2024-12-30T02:47:18.931" v="343" actId="1076"/>
          <ac:picMkLst>
            <pc:docMk/>
            <pc:sldMk cId="152165303" sldId="406"/>
            <ac:picMk id="3" creationId="{236FD1F1-ABA7-29F7-02FE-4AC81AE06ADF}"/>
          </ac:picMkLst>
        </pc:picChg>
        <pc:picChg chg="del mod">
          <ac:chgData name="Belaid, Sirine" userId="S::belaids@upmc.edu::5dcb4cf5-c058-49ea-93f8-4f4e6c877fcd" providerId="AD" clId="Web-{E94FA9D8-49E0-2317-5951-4F4429BD9715}" dt="2024-12-30T02:53:16.822" v="352"/>
          <ac:picMkLst>
            <pc:docMk/>
            <pc:sldMk cId="152165303" sldId="406"/>
            <ac:picMk id="5" creationId="{77C434E4-DD0E-564F-6170-2BF71D0ADAC3}"/>
          </ac:picMkLst>
        </pc:picChg>
        <pc:picChg chg="del">
          <ac:chgData name="Belaid, Sirine" userId="S::belaids@upmc.edu::5dcb4cf5-c058-49ea-93f8-4f4e6c877fcd" providerId="AD" clId="Web-{E94FA9D8-49E0-2317-5951-4F4429BD9715}" dt="2024-12-30T02:45:50.818" v="330"/>
          <ac:picMkLst>
            <pc:docMk/>
            <pc:sldMk cId="152165303" sldId="406"/>
            <ac:picMk id="6" creationId="{18F390FB-E2D9-F372-1A78-41B03A76A0F1}"/>
          </ac:picMkLst>
        </pc:picChg>
        <pc:picChg chg="del mod">
          <ac:chgData name="Belaid, Sirine" userId="S::belaids@upmc.edu::5dcb4cf5-c058-49ea-93f8-4f4e6c877fcd" providerId="AD" clId="Web-{E94FA9D8-49E0-2317-5951-4F4429BD9715}" dt="2024-12-30T02:53:18.322" v="353"/>
          <ac:picMkLst>
            <pc:docMk/>
            <pc:sldMk cId="152165303" sldId="406"/>
            <ac:picMk id="7" creationId="{37D3EEB2-EB6C-A8DC-25FE-1C95281E812F}"/>
          </ac:picMkLst>
        </pc:picChg>
      </pc:sldChg>
      <pc:sldChg chg="addSp delSp modSp new">
        <pc:chgData name="Belaid, Sirine" userId="S::belaids@upmc.edu::5dcb4cf5-c058-49ea-93f8-4f4e6c877fcd" providerId="AD" clId="Web-{E94FA9D8-49E0-2317-5951-4F4429BD9715}" dt="2024-12-30T03:07:23.768" v="458" actId="14100"/>
        <pc:sldMkLst>
          <pc:docMk/>
          <pc:sldMk cId="4024612803" sldId="406"/>
        </pc:sldMkLst>
        <pc:spChg chg="add mod">
          <ac:chgData name="Belaid, Sirine" userId="S::belaids@upmc.edu::5dcb4cf5-c058-49ea-93f8-4f4e6c877fcd" providerId="AD" clId="Web-{E94FA9D8-49E0-2317-5951-4F4429BD9715}" dt="2024-12-30T03:06:23.327" v="447" actId="14100"/>
          <ac:spMkLst>
            <pc:docMk/>
            <pc:sldMk cId="4024612803" sldId="406"/>
            <ac:spMk id="8" creationId="{E3D3F812-6604-6BF9-4666-3481E21BF8FE}"/>
          </ac:spMkLst>
        </pc:spChg>
        <pc:spChg chg="add mod">
          <ac:chgData name="Belaid, Sirine" userId="S::belaids@upmc.edu::5dcb4cf5-c058-49ea-93f8-4f4e6c877fcd" providerId="AD" clId="Web-{E94FA9D8-49E0-2317-5951-4F4429BD9715}" dt="2024-12-30T03:06:43.063" v="451" actId="14100"/>
          <ac:spMkLst>
            <pc:docMk/>
            <pc:sldMk cId="4024612803" sldId="406"/>
            <ac:spMk id="10" creationId="{CFBAFAD5-D99E-1517-C5DB-FAB3022ACDCA}"/>
          </ac:spMkLst>
        </pc:spChg>
        <pc:spChg chg="add mod">
          <ac:chgData name="Belaid, Sirine" userId="S::belaids@upmc.edu::5dcb4cf5-c058-49ea-93f8-4f4e6c877fcd" providerId="AD" clId="Web-{E94FA9D8-49E0-2317-5951-4F4429BD9715}" dt="2024-12-30T03:06:59.282" v="454" actId="14100"/>
          <ac:spMkLst>
            <pc:docMk/>
            <pc:sldMk cId="4024612803" sldId="406"/>
            <ac:spMk id="12" creationId="{04B0F0CD-0811-4281-E88D-E5890E838C61}"/>
          </ac:spMkLst>
        </pc:spChg>
        <pc:spChg chg="add mod">
          <ac:chgData name="Belaid, Sirine" userId="S::belaids@upmc.edu::5dcb4cf5-c058-49ea-93f8-4f4e6c877fcd" providerId="AD" clId="Web-{E94FA9D8-49E0-2317-5951-4F4429BD9715}" dt="2024-12-30T03:07:23.768" v="458" actId="14100"/>
          <ac:spMkLst>
            <pc:docMk/>
            <pc:sldMk cId="4024612803" sldId="406"/>
            <ac:spMk id="13" creationId="{FE9FDF70-09B5-F4A7-8827-ED2DFB45D6C2}"/>
          </ac:spMkLst>
        </pc:spChg>
        <pc:picChg chg="add mod">
          <ac:chgData name="Belaid, Sirine" userId="S::belaids@upmc.edu::5dcb4cf5-c058-49ea-93f8-4f4e6c877fcd" providerId="AD" clId="Web-{E94FA9D8-49E0-2317-5951-4F4429BD9715}" dt="2024-12-30T03:05:17.762" v="432" actId="14100"/>
          <ac:picMkLst>
            <pc:docMk/>
            <pc:sldMk cId="4024612803" sldId="406"/>
            <ac:picMk id="2" creationId="{C4F4D9DA-102C-7B31-F3F2-EF5B07F111CA}"/>
          </ac:picMkLst>
        </pc:picChg>
        <pc:picChg chg="add del mod">
          <ac:chgData name="Belaid, Sirine" userId="S::belaids@upmc.edu::5dcb4cf5-c058-49ea-93f8-4f4e6c877fcd" providerId="AD" clId="Web-{E94FA9D8-49E0-2317-5951-4F4429BD9715}" dt="2024-12-30T03:01:16.985" v="406"/>
          <ac:picMkLst>
            <pc:docMk/>
            <pc:sldMk cId="4024612803" sldId="406"/>
            <ac:picMk id="3" creationId="{6F1A08B4-CEB1-8E4C-1118-9E379591721B}"/>
          </ac:picMkLst>
        </pc:picChg>
        <pc:picChg chg="add del mod">
          <ac:chgData name="Belaid, Sirine" userId="S::belaids@upmc.edu::5dcb4cf5-c058-49ea-93f8-4f4e6c877fcd" providerId="AD" clId="Web-{E94FA9D8-49E0-2317-5951-4F4429BD9715}" dt="2024-12-30T03:02:27.348" v="414"/>
          <ac:picMkLst>
            <pc:docMk/>
            <pc:sldMk cId="4024612803" sldId="406"/>
            <ac:picMk id="4" creationId="{D18508F5-CEE3-8FCF-43B4-6D8B61080257}"/>
          </ac:picMkLst>
        </pc:picChg>
        <pc:picChg chg="add mod">
          <ac:chgData name="Belaid, Sirine" userId="S::belaids@upmc.edu::5dcb4cf5-c058-49ea-93f8-4f4e6c877fcd" providerId="AD" clId="Web-{E94FA9D8-49E0-2317-5951-4F4429BD9715}" dt="2024-12-30T03:05:36.997" v="436" actId="14100"/>
          <ac:picMkLst>
            <pc:docMk/>
            <pc:sldMk cId="4024612803" sldId="406"/>
            <ac:picMk id="5" creationId="{95D6F78D-C771-AB16-76C3-8685F1DD27FE}"/>
          </ac:picMkLst>
        </pc:picChg>
        <pc:picChg chg="add mod">
          <ac:chgData name="Belaid, Sirine" userId="S::belaids@upmc.edu::5dcb4cf5-c058-49ea-93f8-4f4e6c877fcd" providerId="AD" clId="Web-{E94FA9D8-49E0-2317-5951-4F4429BD9715}" dt="2024-12-30T03:05:49.279" v="442" actId="14100"/>
          <ac:picMkLst>
            <pc:docMk/>
            <pc:sldMk cId="4024612803" sldId="406"/>
            <ac:picMk id="6" creationId="{25809557-1AA2-1F3F-4683-C25C554C2EEB}"/>
          </ac:picMkLst>
        </pc:picChg>
      </pc:sldChg>
    </pc:docChg>
  </pc:docChgLst>
  <pc:docChgLst>
    <pc:chgData name="Belaid, Sirine" userId="S::belaids@upmc.edu::5dcb4cf5-c058-49ea-93f8-4f4e6c877fcd" providerId="AD" clId="Web-{43104894-1DCD-7BF9-9117-2C230FA985B3}"/>
    <pc:docChg chg="modSld">
      <pc:chgData name="Belaid, Sirine" userId="S::belaids@upmc.edu::5dcb4cf5-c058-49ea-93f8-4f4e6c877fcd" providerId="AD" clId="Web-{43104894-1DCD-7BF9-9117-2C230FA985B3}" dt="2025-05-09T20:36:39.162" v="27"/>
      <pc:docMkLst>
        <pc:docMk/>
      </pc:docMkLst>
      <pc:sldChg chg="modNotes">
        <pc:chgData name="Belaid, Sirine" userId="S::belaids@upmc.edu::5dcb4cf5-c058-49ea-93f8-4f4e6c877fcd" providerId="AD" clId="Web-{43104894-1DCD-7BF9-9117-2C230FA985B3}" dt="2025-05-09T20:31:27.620" v="24"/>
        <pc:sldMkLst>
          <pc:docMk/>
          <pc:sldMk cId="1929808205" sldId="284"/>
        </pc:sldMkLst>
      </pc:sldChg>
      <pc:sldChg chg="modNotes">
        <pc:chgData name="Belaid, Sirine" userId="S::belaids@upmc.edu::5dcb4cf5-c058-49ea-93f8-4f4e6c877fcd" providerId="AD" clId="Web-{43104894-1DCD-7BF9-9117-2C230FA985B3}" dt="2025-05-09T20:36:39.162" v="27"/>
        <pc:sldMkLst>
          <pc:docMk/>
          <pc:sldMk cId="0" sldId="349"/>
        </pc:sldMkLst>
      </pc:sldChg>
    </pc:docChg>
  </pc:docChgLst>
  <pc:docChgLst>
    <pc:chgData name="Belaid, Sirine" userId="S::belaids@upmc.edu::5dcb4cf5-c058-49ea-93f8-4f4e6c877fcd" providerId="AD" clId="Web-{B047F1F0-DDCB-62F7-3CB9-B577D267FCA3}"/>
    <pc:docChg chg="addSld modSld sldOrd">
      <pc:chgData name="Belaid, Sirine" userId="S::belaids@upmc.edu::5dcb4cf5-c058-49ea-93f8-4f4e6c877fcd" providerId="AD" clId="Web-{B047F1F0-DDCB-62F7-3CB9-B577D267FCA3}" dt="2025-02-20T21:16:21.404" v="104" actId="1076"/>
      <pc:docMkLst>
        <pc:docMk/>
      </pc:docMkLst>
      <pc:sldChg chg="modSp">
        <pc:chgData name="Belaid, Sirine" userId="S::belaids@upmc.edu::5dcb4cf5-c058-49ea-93f8-4f4e6c877fcd" providerId="AD" clId="Web-{B047F1F0-DDCB-62F7-3CB9-B577D267FCA3}" dt="2025-02-20T21:16:21.404" v="104" actId="1076"/>
        <pc:sldMkLst>
          <pc:docMk/>
          <pc:sldMk cId="2302766718" sldId="261"/>
        </pc:sldMkLst>
        <pc:spChg chg="mod">
          <ac:chgData name="Belaid, Sirine" userId="S::belaids@upmc.edu::5dcb4cf5-c058-49ea-93f8-4f4e6c877fcd" providerId="AD" clId="Web-{B047F1F0-DDCB-62F7-3CB9-B577D267FCA3}" dt="2025-02-20T21:16:21.404" v="104" actId="1076"/>
          <ac:spMkLst>
            <pc:docMk/>
            <pc:sldMk cId="2302766718" sldId="261"/>
            <ac:spMk id="15" creationId="{AB115BB4-AFD6-968C-7187-B33813FD14C1}"/>
          </ac:spMkLst>
        </pc:spChg>
      </pc:sldChg>
      <pc:sldChg chg="modSp">
        <pc:chgData name="Belaid, Sirine" userId="S::belaids@upmc.edu::5dcb4cf5-c058-49ea-93f8-4f4e6c877fcd" providerId="AD" clId="Web-{B047F1F0-DDCB-62F7-3CB9-B577D267FCA3}" dt="2025-02-18T21:13:15.014" v="80" actId="1076"/>
        <pc:sldMkLst>
          <pc:docMk/>
          <pc:sldMk cId="1691135755" sldId="279"/>
        </pc:sldMkLst>
        <pc:spChg chg="mod">
          <ac:chgData name="Belaid, Sirine" userId="S::belaids@upmc.edu::5dcb4cf5-c058-49ea-93f8-4f4e6c877fcd" providerId="AD" clId="Web-{B047F1F0-DDCB-62F7-3CB9-B577D267FCA3}" dt="2025-02-18T21:13:15.014" v="80" actId="1076"/>
          <ac:spMkLst>
            <pc:docMk/>
            <pc:sldMk cId="1691135755" sldId="279"/>
            <ac:spMk id="5" creationId="{8B453B78-8D0F-35EB-2A95-E41CE867A315}"/>
          </ac:spMkLst>
        </pc:spChg>
        <pc:spChg chg="mod">
          <ac:chgData name="Belaid, Sirine" userId="S::belaids@upmc.edu::5dcb4cf5-c058-49ea-93f8-4f4e6c877fcd" providerId="AD" clId="Web-{B047F1F0-DDCB-62F7-3CB9-B577D267FCA3}" dt="2025-02-18T21:13:07.467" v="79" actId="1076"/>
          <ac:spMkLst>
            <pc:docMk/>
            <pc:sldMk cId="1691135755" sldId="279"/>
            <ac:spMk id="8" creationId="{4154C069-3066-A58E-282A-AA608DBD0C9A}"/>
          </ac:spMkLst>
        </pc:spChg>
      </pc:sldChg>
      <pc:sldChg chg="modSp">
        <pc:chgData name="Belaid, Sirine" userId="S::belaids@upmc.edu::5dcb4cf5-c058-49ea-93f8-4f4e6c877fcd" providerId="AD" clId="Web-{B047F1F0-DDCB-62F7-3CB9-B577D267FCA3}" dt="2025-02-11T21:29:17.950" v="68" actId="20577"/>
        <pc:sldMkLst>
          <pc:docMk/>
          <pc:sldMk cId="1929808205" sldId="284"/>
        </pc:sldMkLst>
        <pc:spChg chg="mod">
          <ac:chgData name="Belaid, Sirine" userId="S::belaids@upmc.edu::5dcb4cf5-c058-49ea-93f8-4f4e6c877fcd" providerId="AD" clId="Web-{B047F1F0-DDCB-62F7-3CB9-B577D267FCA3}" dt="2025-02-11T21:29:17.950" v="68" actId="20577"/>
          <ac:spMkLst>
            <pc:docMk/>
            <pc:sldMk cId="1929808205" sldId="284"/>
            <ac:spMk id="2" creationId="{12FEC93E-BAE3-8E25-0A92-C71506366C6D}"/>
          </ac:spMkLst>
        </pc:spChg>
        <pc:spChg chg="mod">
          <ac:chgData name="Belaid, Sirine" userId="S::belaids@upmc.edu::5dcb4cf5-c058-49ea-93f8-4f4e6c877fcd" providerId="AD" clId="Web-{B047F1F0-DDCB-62F7-3CB9-B577D267FCA3}" dt="2025-02-11T21:28:07.323" v="65" actId="20577"/>
          <ac:spMkLst>
            <pc:docMk/>
            <pc:sldMk cId="1929808205" sldId="284"/>
            <ac:spMk id="3" creationId="{58FCD493-5D8B-98D4-345B-FD2F49D6AADC}"/>
          </ac:spMkLst>
        </pc:spChg>
      </pc:sldChg>
      <pc:sldChg chg="modSp">
        <pc:chgData name="Belaid, Sirine" userId="S::belaids@upmc.edu::5dcb4cf5-c058-49ea-93f8-4f4e6c877fcd" providerId="AD" clId="Web-{B047F1F0-DDCB-62F7-3CB9-B577D267FCA3}" dt="2025-02-11T21:13:20.188" v="1" actId="1076"/>
        <pc:sldMkLst>
          <pc:docMk/>
          <pc:sldMk cId="4036016796" sldId="404"/>
        </pc:sldMkLst>
        <pc:spChg chg="mod">
          <ac:chgData name="Belaid, Sirine" userId="S::belaids@upmc.edu::5dcb4cf5-c058-49ea-93f8-4f4e6c877fcd" providerId="AD" clId="Web-{B047F1F0-DDCB-62F7-3CB9-B577D267FCA3}" dt="2025-02-11T21:13:20.188" v="1" actId="1076"/>
          <ac:spMkLst>
            <pc:docMk/>
            <pc:sldMk cId="4036016796" sldId="404"/>
            <ac:spMk id="10" creationId="{47C246D0-D2E0-84EF-151E-7CD30CFA3F7E}"/>
          </ac:spMkLst>
        </pc:spChg>
      </pc:sldChg>
      <pc:sldChg chg="modSp new ord">
        <pc:chgData name="Belaid, Sirine" userId="S::belaids@upmc.edu::5dcb4cf5-c058-49ea-93f8-4f4e6c877fcd" providerId="AD" clId="Web-{B047F1F0-DDCB-62F7-3CB9-B577D267FCA3}" dt="2025-02-20T21:15:59.044" v="102"/>
        <pc:sldMkLst>
          <pc:docMk/>
          <pc:sldMk cId="3397468027" sldId="408"/>
        </pc:sldMkLst>
        <pc:spChg chg="mod">
          <ac:chgData name="Belaid, Sirine" userId="S::belaids@upmc.edu::5dcb4cf5-c058-49ea-93f8-4f4e6c877fcd" providerId="AD" clId="Web-{B047F1F0-DDCB-62F7-3CB9-B577D267FCA3}" dt="2025-02-20T21:14:56.120" v="89" actId="20577"/>
          <ac:spMkLst>
            <pc:docMk/>
            <pc:sldMk cId="3397468027" sldId="408"/>
            <ac:spMk id="2" creationId="{858F381A-0C46-8E52-F837-E4D708B7854E}"/>
          </ac:spMkLst>
        </pc:spChg>
        <pc:spChg chg="mod">
          <ac:chgData name="Belaid, Sirine" userId="S::belaids@upmc.edu::5dcb4cf5-c058-49ea-93f8-4f4e6c877fcd" providerId="AD" clId="Web-{B047F1F0-DDCB-62F7-3CB9-B577D267FCA3}" dt="2025-02-20T21:15:49.637" v="101" actId="1076"/>
          <ac:spMkLst>
            <pc:docMk/>
            <pc:sldMk cId="3397468027" sldId="408"/>
            <ac:spMk id="3" creationId="{FDF5D10B-DEF1-C7DF-56E8-EA874D688EE6}"/>
          </ac:spMkLst>
        </pc:spChg>
      </pc:sldChg>
    </pc:docChg>
  </pc:docChgLst>
  <pc:docChgLst>
    <pc:chgData name="Belaid, Sirine" userId="S::belaids@upmc.edu::5dcb4cf5-c058-49ea-93f8-4f4e6c877fcd" providerId="AD" clId="Web-{1A2DEE3B-6222-657C-1E5D-4D364EB83815}"/>
    <pc:docChg chg="addSld modSld">
      <pc:chgData name="Belaid, Sirine" userId="S::belaids@upmc.edu::5dcb4cf5-c058-49ea-93f8-4f4e6c877fcd" providerId="AD" clId="Web-{1A2DEE3B-6222-657C-1E5D-4D364EB83815}" dt="2025-01-14T23:21:57.630" v="3"/>
      <pc:docMkLst>
        <pc:docMk/>
      </pc:docMkLst>
      <pc:sldChg chg="addSp modSp new mod setBg">
        <pc:chgData name="Belaid, Sirine" userId="S::belaids@upmc.edu::5dcb4cf5-c058-49ea-93f8-4f4e6c877fcd" providerId="AD" clId="Web-{1A2DEE3B-6222-657C-1E5D-4D364EB83815}" dt="2025-01-14T23:21:57.630" v="3"/>
        <pc:sldMkLst>
          <pc:docMk/>
          <pc:sldMk cId="1359416691" sldId="407"/>
        </pc:sldMkLst>
        <pc:picChg chg="add mod">
          <ac:chgData name="Belaid, Sirine" userId="S::belaids@upmc.edu::5dcb4cf5-c058-49ea-93f8-4f4e6c877fcd" providerId="AD" clId="Web-{1A2DEE3B-6222-657C-1E5D-4D364EB83815}" dt="2025-01-14T23:21:57.630" v="3"/>
          <ac:picMkLst>
            <pc:docMk/>
            <pc:sldMk cId="1359416691" sldId="407"/>
            <ac:picMk id="2" creationId="{C901896E-134B-238E-D366-E81B7585D333}"/>
          </ac:picMkLst>
        </pc:pic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3F9C946-9A1A-4451-B494-30093D2535BD}" type="doc">
      <dgm:prSet loTypeId="urn:microsoft.com/office/officeart/2005/8/layout/default" loCatId="list" qsTypeId="urn:microsoft.com/office/officeart/2005/8/quickstyle/simple1" qsCatId="simple" csTypeId="urn:microsoft.com/office/officeart/2005/8/colors/colorful1" csCatId="colorful"/>
      <dgm:spPr/>
      <dgm:t>
        <a:bodyPr/>
        <a:lstStyle/>
        <a:p>
          <a:endParaRPr lang="en-US"/>
        </a:p>
      </dgm:t>
    </dgm:pt>
    <dgm:pt modelId="{E4BA5944-0CC7-4D44-BFD1-7B79019E1B6D}">
      <dgm:prSet/>
      <dgm:spPr/>
      <dgm:t>
        <a:bodyPr/>
        <a:lstStyle/>
        <a:p>
          <a:r>
            <a:rPr lang="en-US"/>
            <a:t>Examine patient (hydration, febrile?, septic?)</a:t>
          </a:r>
        </a:p>
      </dgm:t>
    </dgm:pt>
    <dgm:pt modelId="{D93868FC-D9A9-4C4E-A773-75D066330319}" type="parTrans" cxnId="{6B86D13A-EC42-4456-BFDE-049171897133}">
      <dgm:prSet/>
      <dgm:spPr/>
      <dgm:t>
        <a:bodyPr/>
        <a:lstStyle/>
        <a:p>
          <a:endParaRPr lang="en-US"/>
        </a:p>
      </dgm:t>
    </dgm:pt>
    <dgm:pt modelId="{347463DD-7C00-43BA-92D3-70CB74205D3F}" type="sibTrans" cxnId="{6B86D13A-EC42-4456-BFDE-049171897133}">
      <dgm:prSet/>
      <dgm:spPr/>
      <dgm:t>
        <a:bodyPr/>
        <a:lstStyle/>
        <a:p>
          <a:endParaRPr lang="en-US"/>
        </a:p>
      </dgm:t>
    </dgm:pt>
    <dgm:pt modelId="{F785FD7B-2C91-466A-A0B1-904DF140096C}">
      <dgm:prSet/>
      <dgm:spPr/>
      <dgm:t>
        <a:bodyPr/>
        <a:lstStyle/>
        <a:p>
          <a:r>
            <a:rPr lang="en-US"/>
            <a:t>With exam and Cr/BUN, assess need for NS bolus</a:t>
          </a:r>
        </a:p>
      </dgm:t>
    </dgm:pt>
    <dgm:pt modelId="{3DD18EB9-65E6-46F7-B620-1E08FA01B429}" type="parTrans" cxnId="{E6FC48A2-BD1A-4B3C-B84C-E5DFF5512CD2}">
      <dgm:prSet/>
      <dgm:spPr/>
      <dgm:t>
        <a:bodyPr/>
        <a:lstStyle/>
        <a:p>
          <a:endParaRPr lang="en-US"/>
        </a:p>
      </dgm:t>
    </dgm:pt>
    <dgm:pt modelId="{B42B541E-9172-4CEF-B29E-CB24090E8033}" type="sibTrans" cxnId="{E6FC48A2-BD1A-4B3C-B84C-E5DFF5512CD2}">
      <dgm:prSet/>
      <dgm:spPr/>
      <dgm:t>
        <a:bodyPr/>
        <a:lstStyle/>
        <a:p>
          <a:endParaRPr lang="en-US"/>
        </a:p>
      </dgm:t>
    </dgm:pt>
    <dgm:pt modelId="{55568E7B-414E-411D-BC2A-0179840B9C64}">
      <dgm:prSet/>
      <dgm:spPr/>
      <dgm:t>
        <a:bodyPr/>
        <a:lstStyle/>
        <a:p>
          <a:r>
            <a:rPr lang="en-US"/>
            <a:t>Reassess patient after each NS bolus</a:t>
          </a:r>
        </a:p>
      </dgm:t>
    </dgm:pt>
    <dgm:pt modelId="{5EA6E31D-39D4-4DF6-B8E9-15EB9EF6A13E}" type="parTrans" cxnId="{C34A231E-D8C4-4DC9-B16B-3746B10F4F7B}">
      <dgm:prSet/>
      <dgm:spPr/>
      <dgm:t>
        <a:bodyPr/>
        <a:lstStyle/>
        <a:p>
          <a:endParaRPr lang="en-US"/>
        </a:p>
      </dgm:t>
    </dgm:pt>
    <dgm:pt modelId="{50F51727-7CE0-416C-8873-C7FF733C785B}" type="sibTrans" cxnId="{C34A231E-D8C4-4DC9-B16B-3746B10F4F7B}">
      <dgm:prSet/>
      <dgm:spPr/>
      <dgm:t>
        <a:bodyPr/>
        <a:lstStyle/>
        <a:p>
          <a:endParaRPr lang="en-US"/>
        </a:p>
      </dgm:t>
    </dgm:pt>
    <dgm:pt modelId="{5D72D5E8-8D8F-435E-80A6-0E2482FB5350}">
      <dgm:prSet/>
      <dgm:spPr/>
      <dgm:t>
        <a:bodyPr/>
        <a:lstStyle/>
        <a:p>
          <a:r>
            <a:rPr lang="en-US"/>
            <a:t>Check BMP, Mg, PHO4 (among others) </a:t>
          </a:r>
        </a:p>
      </dgm:t>
    </dgm:pt>
    <dgm:pt modelId="{9F7CF899-A48F-4164-A308-7110CA0FE15E}" type="parTrans" cxnId="{E7BF95D1-4075-4365-B87C-C2407FE1C772}">
      <dgm:prSet/>
      <dgm:spPr/>
      <dgm:t>
        <a:bodyPr/>
        <a:lstStyle/>
        <a:p>
          <a:endParaRPr lang="en-US"/>
        </a:p>
      </dgm:t>
    </dgm:pt>
    <dgm:pt modelId="{65CDBEB3-1AE6-49DF-A693-61F069A3D5AB}" type="sibTrans" cxnId="{E7BF95D1-4075-4365-B87C-C2407FE1C772}">
      <dgm:prSet/>
      <dgm:spPr/>
      <dgm:t>
        <a:bodyPr/>
        <a:lstStyle/>
        <a:p>
          <a:endParaRPr lang="en-US"/>
        </a:p>
      </dgm:t>
    </dgm:pt>
    <dgm:pt modelId="{95E78F57-AFFD-4980-B0CA-B1B9125F5E19}">
      <dgm:prSet/>
      <dgm:spPr/>
      <dgm:t>
        <a:bodyPr/>
        <a:lstStyle/>
        <a:p>
          <a:r>
            <a:rPr lang="en-US"/>
            <a:t>Assess need for lyte replacement </a:t>
          </a:r>
        </a:p>
      </dgm:t>
    </dgm:pt>
    <dgm:pt modelId="{E50F12E5-3447-4054-8B1A-B091E769752C}" type="parTrans" cxnId="{92A1D2B7-A970-4D31-9E8E-57D79A426D8B}">
      <dgm:prSet/>
      <dgm:spPr/>
      <dgm:t>
        <a:bodyPr/>
        <a:lstStyle/>
        <a:p>
          <a:endParaRPr lang="en-US"/>
        </a:p>
      </dgm:t>
    </dgm:pt>
    <dgm:pt modelId="{421D3875-AEC6-4664-B15B-8296374FF792}" type="sibTrans" cxnId="{92A1D2B7-A970-4D31-9E8E-57D79A426D8B}">
      <dgm:prSet/>
      <dgm:spPr/>
      <dgm:t>
        <a:bodyPr/>
        <a:lstStyle/>
        <a:p>
          <a:endParaRPr lang="en-US"/>
        </a:p>
      </dgm:t>
    </dgm:pt>
    <dgm:pt modelId="{C4EE4CD8-6647-41F8-ADD2-36D121158B9A}">
      <dgm:prSet/>
      <dgm:spPr/>
      <dgm:t>
        <a:bodyPr/>
        <a:lstStyle/>
        <a:p>
          <a:r>
            <a:rPr lang="en-US"/>
            <a:t>Recheck labs after lyte replacement</a:t>
          </a:r>
        </a:p>
      </dgm:t>
    </dgm:pt>
    <dgm:pt modelId="{03A61FDD-0B6B-4343-B8A2-BA61A4D9DB83}" type="parTrans" cxnId="{938CB45C-DB64-486F-8196-C34E83C33C07}">
      <dgm:prSet/>
      <dgm:spPr/>
      <dgm:t>
        <a:bodyPr/>
        <a:lstStyle/>
        <a:p>
          <a:endParaRPr lang="en-US"/>
        </a:p>
      </dgm:t>
    </dgm:pt>
    <dgm:pt modelId="{C3C4394F-EC6E-4FE0-8E04-94833FD0FB9A}" type="sibTrans" cxnId="{938CB45C-DB64-486F-8196-C34E83C33C07}">
      <dgm:prSet/>
      <dgm:spPr/>
      <dgm:t>
        <a:bodyPr/>
        <a:lstStyle/>
        <a:p>
          <a:endParaRPr lang="en-US"/>
        </a:p>
      </dgm:t>
    </dgm:pt>
    <dgm:pt modelId="{AD6D6876-DA43-4DCC-A21D-30BCA326E20A}">
      <dgm:prSet/>
      <dgm:spPr/>
      <dgm:t>
        <a:bodyPr/>
        <a:lstStyle/>
        <a:p>
          <a:r>
            <a:rPr lang="en-US"/>
            <a:t>Central vs Peripheral access </a:t>
          </a:r>
        </a:p>
      </dgm:t>
    </dgm:pt>
    <dgm:pt modelId="{01F2F3B2-BE0F-4E75-812B-4F0E89E05D36}" type="parTrans" cxnId="{099F6DB9-3B5F-42A9-8808-DF341115B0BF}">
      <dgm:prSet/>
      <dgm:spPr/>
      <dgm:t>
        <a:bodyPr/>
        <a:lstStyle/>
        <a:p>
          <a:endParaRPr lang="en-US"/>
        </a:p>
      </dgm:t>
    </dgm:pt>
    <dgm:pt modelId="{0DE1B0F2-8115-4426-AACD-9CC033243963}" type="sibTrans" cxnId="{099F6DB9-3B5F-42A9-8808-DF341115B0BF}">
      <dgm:prSet/>
      <dgm:spPr/>
      <dgm:t>
        <a:bodyPr/>
        <a:lstStyle/>
        <a:p>
          <a:endParaRPr lang="en-US"/>
        </a:p>
      </dgm:t>
    </dgm:pt>
    <dgm:pt modelId="{AF2D2B6C-5493-4916-BB05-CEA24C9A6923}">
      <dgm:prSet/>
      <dgm:spPr/>
      <dgm:t>
        <a:bodyPr/>
        <a:lstStyle/>
        <a:p>
          <a:r>
            <a:rPr lang="en-US"/>
            <a:t>Parenteral % vs Enteral % </a:t>
          </a:r>
        </a:p>
      </dgm:t>
    </dgm:pt>
    <dgm:pt modelId="{A9DA3831-F86B-4A4A-83D9-6E81B760DD90}" type="parTrans" cxnId="{794D8EF8-453C-446D-8782-6451ED3DBEED}">
      <dgm:prSet/>
      <dgm:spPr/>
      <dgm:t>
        <a:bodyPr/>
        <a:lstStyle/>
        <a:p>
          <a:endParaRPr lang="en-US"/>
        </a:p>
      </dgm:t>
    </dgm:pt>
    <dgm:pt modelId="{3CF8F308-D947-4284-B5F8-39DD2413FABB}" type="sibTrans" cxnId="{794D8EF8-453C-446D-8782-6451ED3DBEED}">
      <dgm:prSet/>
      <dgm:spPr/>
      <dgm:t>
        <a:bodyPr/>
        <a:lstStyle/>
        <a:p>
          <a:endParaRPr lang="en-US"/>
        </a:p>
      </dgm:t>
    </dgm:pt>
    <dgm:pt modelId="{24A5196C-A549-4E0B-B6CE-95CE647F13D5}" type="pres">
      <dgm:prSet presAssocID="{23F9C946-9A1A-4451-B494-30093D2535BD}" presName="diagram" presStyleCnt="0">
        <dgm:presLayoutVars>
          <dgm:dir/>
          <dgm:resizeHandles val="exact"/>
        </dgm:presLayoutVars>
      </dgm:prSet>
      <dgm:spPr/>
    </dgm:pt>
    <dgm:pt modelId="{11CF527D-BDB2-4238-A196-B199C594F971}" type="pres">
      <dgm:prSet presAssocID="{E4BA5944-0CC7-4D44-BFD1-7B79019E1B6D}" presName="node" presStyleLbl="node1" presStyleIdx="0" presStyleCnt="8">
        <dgm:presLayoutVars>
          <dgm:bulletEnabled val="1"/>
        </dgm:presLayoutVars>
      </dgm:prSet>
      <dgm:spPr/>
    </dgm:pt>
    <dgm:pt modelId="{A65B2005-1FEE-401C-99DC-922FBACB7983}" type="pres">
      <dgm:prSet presAssocID="{347463DD-7C00-43BA-92D3-70CB74205D3F}" presName="sibTrans" presStyleCnt="0"/>
      <dgm:spPr/>
    </dgm:pt>
    <dgm:pt modelId="{2CCEF345-5086-4A45-BA0B-D432D2B3EBFF}" type="pres">
      <dgm:prSet presAssocID="{F785FD7B-2C91-466A-A0B1-904DF140096C}" presName="node" presStyleLbl="node1" presStyleIdx="1" presStyleCnt="8">
        <dgm:presLayoutVars>
          <dgm:bulletEnabled val="1"/>
        </dgm:presLayoutVars>
      </dgm:prSet>
      <dgm:spPr/>
    </dgm:pt>
    <dgm:pt modelId="{3D70917C-C590-40AD-9567-28822D7AAB25}" type="pres">
      <dgm:prSet presAssocID="{B42B541E-9172-4CEF-B29E-CB24090E8033}" presName="sibTrans" presStyleCnt="0"/>
      <dgm:spPr/>
    </dgm:pt>
    <dgm:pt modelId="{915B4FB4-2720-4F65-9AA2-AD3C8CBF472E}" type="pres">
      <dgm:prSet presAssocID="{55568E7B-414E-411D-BC2A-0179840B9C64}" presName="node" presStyleLbl="node1" presStyleIdx="2" presStyleCnt="8">
        <dgm:presLayoutVars>
          <dgm:bulletEnabled val="1"/>
        </dgm:presLayoutVars>
      </dgm:prSet>
      <dgm:spPr/>
    </dgm:pt>
    <dgm:pt modelId="{B2703703-00B7-406A-A3B9-AB6C83E74011}" type="pres">
      <dgm:prSet presAssocID="{50F51727-7CE0-416C-8873-C7FF733C785B}" presName="sibTrans" presStyleCnt="0"/>
      <dgm:spPr/>
    </dgm:pt>
    <dgm:pt modelId="{714D7775-5DA0-4FCB-8A6B-AD9086E2766E}" type="pres">
      <dgm:prSet presAssocID="{5D72D5E8-8D8F-435E-80A6-0E2482FB5350}" presName="node" presStyleLbl="node1" presStyleIdx="3" presStyleCnt="8">
        <dgm:presLayoutVars>
          <dgm:bulletEnabled val="1"/>
        </dgm:presLayoutVars>
      </dgm:prSet>
      <dgm:spPr/>
    </dgm:pt>
    <dgm:pt modelId="{39B61D3A-8927-40A7-88A3-8BDD00B69C44}" type="pres">
      <dgm:prSet presAssocID="{65CDBEB3-1AE6-49DF-A693-61F069A3D5AB}" presName="sibTrans" presStyleCnt="0"/>
      <dgm:spPr/>
    </dgm:pt>
    <dgm:pt modelId="{35011309-6AAA-4DB5-8756-CCA8CCC6FD9E}" type="pres">
      <dgm:prSet presAssocID="{95E78F57-AFFD-4980-B0CA-B1B9125F5E19}" presName="node" presStyleLbl="node1" presStyleIdx="4" presStyleCnt="8">
        <dgm:presLayoutVars>
          <dgm:bulletEnabled val="1"/>
        </dgm:presLayoutVars>
      </dgm:prSet>
      <dgm:spPr/>
    </dgm:pt>
    <dgm:pt modelId="{2DBDA84E-CFB3-4573-9B9F-B92AFDEA0728}" type="pres">
      <dgm:prSet presAssocID="{421D3875-AEC6-4664-B15B-8296374FF792}" presName="sibTrans" presStyleCnt="0"/>
      <dgm:spPr/>
    </dgm:pt>
    <dgm:pt modelId="{49713C90-C351-4762-9FC6-5CE27B4BC4CA}" type="pres">
      <dgm:prSet presAssocID="{C4EE4CD8-6647-41F8-ADD2-36D121158B9A}" presName="node" presStyleLbl="node1" presStyleIdx="5" presStyleCnt="8">
        <dgm:presLayoutVars>
          <dgm:bulletEnabled val="1"/>
        </dgm:presLayoutVars>
      </dgm:prSet>
      <dgm:spPr/>
    </dgm:pt>
    <dgm:pt modelId="{ABBBB923-93AA-4750-A0DC-62FB087E7DE7}" type="pres">
      <dgm:prSet presAssocID="{C3C4394F-EC6E-4FE0-8E04-94833FD0FB9A}" presName="sibTrans" presStyleCnt="0"/>
      <dgm:spPr/>
    </dgm:pt>
    <dgm:pt modelId="{1DC6F5A5-4EA4-4DD5-8073-9ECC4DDFA32B}" type="pres">
      <dgm:prSet presAssocID="{AD6D6876-DA43-4DCC-A21D-30BCA326E20A}" presName="node" presStyleLbl="node1" presStyleIdx="6" presStyleCnt="8">
        <dgm:presLayoutVars>
          <dgm:bulletEnabled val="1"/>
        </dgm:presLayoutVars>
      </dgm:prSet>
      <dgm:spPr/>
    </dgm:pt>
    <dgm:pt modelId="{C2A63799-601B-403E-AF05-E7BB692D1042}" type="pres">
      <dgm:prSet presAssocID="{0DE1B0F2-8115-4426-AACD-9CC033243963}" presName="sibTrans" presStyleCnt="0"/>
      <dgm:spPr/>
    </dgm:pt>
    <dgm:pt modelId="{4983FC67-8604-4C99-9A3B-E77D2478F913}" type="pres">
      <dgm:prSet presAssocID="{AF2D2B6C-5493-4916-BB05-CEA24C9A6923}" presName="node" presStyleLbl="node1" presStyleIdx="7" presStyleCnt="8">
        <dgm:presLayoutVars>
          <dgm:bulletEnabled val="1"/>
        </dgm:presLayoutVars>
      </dgm:prSet>
      <dgm:spPr/>
    </dgm:pt>
  </dgm:ptLst>
  <dgm:cxnLst>
    <dgm:cxn modelId="{C34A231E-D8C4-4DC9-B16B-3746B10F4F7B}" srcId="{23F9C946-9A1A-4451-B494-30093D2535BD}" destId="{55568E7B-414E-411D-BC2A-0179840B9C64}" srcOrd="2" destOrd="0" parTransId="{5EA6E31D-39D4-4DF6-B8E9-15EB9EF6A13E}" sibTransId="{50F51727-7CE0-416C-8873-C7FF733C785B}"/>
    <dgm:cxn modelId="{CA747837-F586-41F9-8673-BD7868BBF553}" type="presOf" srcId="{95E78F57-AFFD-4980-B0CA-B1B9125F5E19}" destId="{35011309-6AAA-4DB5-8756-CCA8CCC6FD9E}" srcOrd="0" destOrd="0" presId="urn:microsoft.com/office/officeart/2005/8/layout/default"/>
    <dgm:cxn modelId="{38D5CD37-2EA8-4C83-B007-2741688BA101}" type="presOf" srcId="{AF2D2B6C-5493-4916-BB05-CEA24C9A6923}" destId="{4983FC67-8604-4C99-9A3B-E77D2478F913}" srcOrd="0" destOrd="0" presId="urn:microsoft.com/office/officeart/2005/8/layout/default"/>
    <dgm:cxn modelId="{6B86D13A-EC42-4456-BFDE-049171897133}" srcId="{23F9C946-9A1A-4451-B494-30093D2535BD}" destId="{E4BA5944-0CC7-4D44-BFD1-7B79019E1B6D}" srcOrd="0" destOrd="0" parTransId="{D93868FC-D9A9-4C4E-A773-75D066330319}" sibTransId="{347463DD-7C00-43BA-92D3-70CB74205D3F}"/>
    <dgm:cxn modelId="{938CB45C-DB64-486F-8196-C34E83C33C07}" srcId="{23F9C946-9A1A-4451-B494-30093D2535BD}" destId="{C4EE4CD8-6647-41F8-ADD2-36D121158B9A}" srcOrd="5" destOrd="0" parTransId="{03A61FDD-0B6B-4343-B8A2-BA61A4D9DB83}" sibTransId="{C3C4394F-EC6E-4FE0-8E04-94833FD0FB9A}"/>
    <dgm:cxn modelId="{DA178444-F2CD-420B-842E-E8F064493954}" type="presOf" srcId="{55568E7B-414E-411D-BC2A-0179840B9C64}" destId="{915B4FB4-2720-4F65-9AA2-AD3C8CBF472E}" srcOrd="0" destOrd="0" presId="urn:microsoft.com/office/officeart/2005/8/layout/default"/>
    <dgm:cxn modelId="{AC96146B-BD7E-4F36-A047-D1DA742E1949}" type="presOf" srcId="{23F9C946-9A1A-4451-B494-30093D2535BD}" destId="{24A5196C-A549-4E0B-B6CE-95CE647F13D5}" srcOrd="0" destOrd="0" presId="urn:microsoft.com/office/officeart/2005/8/layout/default"/>
    <dgm:cxn modelId="{E6FC48A2-BD1A-4B3C-B84C-E5DFF5512CD2}" srcId="{23F9C946-9A1A-4451-B494-30093D2535BD}" destId="{F785FD7B-2C91-466A-A0B1-904DF140096C}" srcOrd="1" destOrd="0" parTransId="{3DD18EB9-65E6-46F7-B620-1E08FA01B429}" sibTransId="{B42B541E-9172-4CEF-B29E-CB24090E8033}"/>
    <dgm:cxn modelId="{4BF186A3-51E4-4357-A004-0234DC1C9CA4}" type="presOf" srcId="{AD6D6876-DA43-4DCC-A21D-30BCA326E20A}" destId="{1DC6F5A5-4EA4-4DD5-8073-9ECC4DDFA32B}" srcOrd="0" destOrd="0" presId="urn:microsoft.com/office/officeart/2005/8/layout/default"/>
    <dgm:cxn modelId="{92A1D2B7-A970-4D31-9E8E-57D79A426D8B}" srcId="{23F9C946-9A1A-4451-B494-30093D2535BD}" destId="{95E78F57-AFFD-4980-B0CA-B1B9125F5E19}" srcOrd="4" destOrd="0" parTransId="{E50F12E5-3447-4054-8B1A-B091E769752C}" sibTransId="{421D3875-AEC6-4664-B15B-8296374FF792}"/>
    <dgm:cxn modelId="{099F6DB9-3B5F-42A9-8808-DF341115B0BF}" srcId="{23F9C946-9A1A-4451-B494-30093D2535BD}" destId="{AD6D6876-DA43-4DCC-A21D-30BCA326E20A}" srcOrd="6" destOrd="0" parTransId="{01F2F3B2-BE0F-4E75-812B-4F0E89E05D36}" sibTransId="{0DE1B0F2-8115-4426-AACD-9CC033243963}"/>
    <dgm:cxn modelId="{8A1FF7BC-7B6C-41E6-AF4E-FD4646F68119}" type="presOf" srcId="{E4BA5944-0CC7-4D44-BFD1-7B79019E1B6D}" destId="{11CF527D-BDB2-4238-A196-B199C594F971}" srcOrd="0" destOrd="0" presId="urn:microsoft.com/office/officeart/2005/8/layout/default"/>
    <dgm:cxn modelId="{8C96AAC1-D714-411C-8BFE-A023BBA72627}" type="presOf" srcId="{F785FD7B-2C91-466A-A0B1-904DF140096C}" destId="{2CCEF345-5086-4A45-BA0B-D432D2B3EBFF}" srcOrd="0" destOrd="0" presId="urn:microsoft.com/office/officeart/2005/8/layout/default"/>
    <dgm:cxn modelId="{E7BF95D1-4075-4365-B87C-C2407FE1C772}" srcId="{23F9C946-9A1A-4451-B494-30093D2535BD}" destId="{5D72D5E8-8D8F-435E-80A6-0E2482FB5350}" srcOrd="3" destOrd="0" parTransId="{9F7CF899-A48F-4164-A308-7110CA0FE15E}" sibTransId="{65CDBEB3-1AE6-49DF-A693-61F069A3D5AB}"/>
    <dgm:cxn modelId="{A8668CED-8C26-40F9-A39F-29413F60252B}" type="presOf" srcId="{5D72D5E8-8D8F-435E-80A6-0E2482FB5350}" destId="{714D7775-5DA0-4FCB-8A6B-AD9086E2766E}" srcOrd="0" destOrd="0" presId="urn:microsoft.com/office/officeart/2005/8/layout/default"/>
    <dgm:cxn modelId="{93766FF1-C570-4176-B4BB-CBBCFA7EB51D}" type="presOf" srcId="{C4EE4CD8-6647-41F8-ADD2-36D121158B9A}" destId="{49713C90-C351-4762-9FC6-5CE27B4BC4CA}" srcOrd="0" destOrd="0" presId="urn:microsoft.com/office/officeart/2005/8/layout/default"/>
    <dgm:cxn modelId="{794D8EF8-453C-446D-8782-6451ED3DBEED}" srcId="{23F9C946-9A1A-4451-B494-30093D2535BD}" destId="{AF2D2B6C-5493-4916-BB05-CEA24C9A6923}" srcOrd="7" destOrd="0" parTransId="{A9DA3831-F86B-4A4A-83D9-6E81B760DD90}" sibTransId="{3CF8F308-D947-4284-B5F8-39DD2413FABB}"/>
    <dgm:cxn modelId="{9B7F3EFB-EFE9-45AB-8356-170298BB4111}" type="presParOf" srcId="{24A5196C-A549-4E0B-B6CE-95CE647F13D5}" destId="{11CF527D-BDB2-4238-A196-B199C594F971}" srcOrd="0" destOrd="0" presId="urn:microsoft.com/office/officeart/2005/8/layout/default"/>
    <dgm:cxn modelId="{9DD18AAD-2D52-488A-8ADF-D8A83512EB44}" type="presParOf" srcId="{24A5196C-A549-4E0B-B6CE-95CE647F13D5}" destId="{A65B2005-1FEE-401C-99DC-922FBACB7983}" srcOrd="1" destOrd="0" presId="urn:microsoft.com/office/officeart/2005/8/layout/default"/>
    <dgm:cxn modelId="{6B0FCFEC-F192-4E1F-B16C-8AA8B4979108}" type="presParOf" srcId="{24A5196C-A549-4E0B-B6CE-95CE647F13D5}" destId="{2CCEF345-5086-4A45-BA0B-D432D2B3EBFF}" srcOrd="2" destOrd="0" presId="urn:microsoft.com/office/officeart/2005/8/layout/default"/>
    <dgm:cxn modelId="{707F02C4-EB6F-44B9-AEF1-17E2025D4899}" type="presParOf" srcId="{24A5196C-A549-4E0B-B6CE-95CE647F13D5}" destId="{3D70917C-C590-40AD-9567-28822D7AAB25}" srcOrd="3" destOrd="0" presId="urn:microsoft.com/office/officeart/2005/8/layout/default"/>
    <dgm:cxn modelId="{2FFFFA05-37BC-4C6F-88DE-AFAB56E954EA}" type="presParOf" srcId="{24A5196C-A549-4E0B-B6CE-95CE647F13D5}" destId="{915B4FB4-2720-4F65-9AA2-AD3C8CBF472E}" srcOrd="4" destOrd="0" presId="urn:microsoft.com/office/officeart/2005/8/layout/default"/>
    <dgm:cxn modelId="{7AFE85FC-2920-4F1C-9728-FB60B3DE58F8}" type="presParOf" srcId="{24A5196C-A549-4E0B-B6CE-95CE647F13D5}" destId="{B2703703-00B7-406A-A3B9-AB6C83E74011}" srcOrd="5" destOrd="0" presId="urn:microsoft.com/office/officeart/2005/8/layout/default"/>
    <dgm:cxn modelId="{ED95C880-238F-42FB-871B-89C8150D896D}" type="presParOf" srcId="{24A5196C-A549-4E0B-B6CE-95CE647F13D5}" destId="{714D7775-5DA0-4FCB-8A6B-AD9086E2766E}" srcOrd="6" destOrd="0" presId="urn:microsoft.com/office/officeart/2005/8/layout/default"/>
    <dgm:cxn modelId="{E30EEC0A-43B7-42BA-8B5C-A39D37EEDBA3}" type="presParOf" srcId="{24A5196C-A549-4E0B-B6CE-95CE647F13D5}" destId="{39B61D3A-8927-40A7-88A3-8BDD00B69C44}" srcOrd="7" destOrd="0" presId="urn:microsoft.com/office/officeart/2005/8/layout/default"/>
    <dgm:cxn modelId="{5546F067-C3BD-4F55-9292-CAA146D35587}" type="presParOf" srcId="{24A5196C-A549-4E0B-B6CE-95CE647F13D5}" destId="{35011309-6AAA-4DB5-8756-CCA8CCC6FD9E}" srcOrd="8" destOrd="0" presId="urn:microsoft.com/office/officeart/2005/8/layout/default"/>
    <dgm:cxn modelId="{A8E0E405-3A8C-4BFD-A376-F0E044017027}" type="presParOf" srcId="{24A5196C-A549-4E0B-B6CE-95CE647F13D5}" destId="{2DBDA84E-CFB3-4573-9B9F-B92AFDEA0728}" srcOrd="9" destOrd="0" presId="urn:microsoft.com/office/officeart/2005/8/layout/default"/>
    <dgm:cxn modelId="{3EF13F63-5FDE-4F35-A6E9-CCF8D231EB10}" type="presParOf" srcId="{24A5196C-A549-4E0B-B6CE-95CE647F13D5}" destId="{49713C90-C351-4762-9FC6-5CE27B4BC4CA}" srcOrd="10" destOrd="0" presId="urn:microsoft.com/office/officeart/2005/8/layout/default"/>
    <dgm:cxn modelId="{F45D6C44-C4AE-48BD-BBF5-E6E801A04913}" type="presParOf" srcId="{24A5196C-A549-4E0B-B6CE-95CE647F13D5}" destId="{ABBBB923-93AA-4750-A0DC-62FB087E7DE7}" srcOrd="11" destOrd="0" presId="urn:microsoft.com/office/officeart/2005/8/layout/default"/>
    <dgm:cxn modelId="{6CC7B313-F9CC-40AF-AFD3-BA29FE6DBD01}" type="presParOf" srcId="{24A5196C-A549-4E0B-B6CE-95CE647F13D5}" destId="{1DC6F5A5-4EA4-4DD5-8073-9ECC4DDFA32B}" srcOrd="12" destOrd="0" presId="urn:microsoft.com/office/officeart/2005/8/layout/default"/>
    <dgm:cxn modelId="{F7F8C7F6-F82A-40FB-9801-D65B76F7A9D2}" type="presParOf" srcId="{24A5196C-A549-4E0B-B6CE-95CE647F13D5}" destId="{C2A63799-601B-403E-AF05-E7BB692D1042}" srcOrd="13" destOrd="0" presId="urn:microsoft.com/office/officeart/2005/8/layout/default"/>
    <dgm:cxn modelId="{1FBD65DA-3604-42F3-BCE6-604F1928DFB4}" type="presParOf" srcId="{24A5196C-A549-4E0B-B6CE-95CE647F13D5}" destId="{4983FC67-8604-4C99-9A3B-E77D2478F913}" srcOrd="14" destOrd="0" presId="urn:microsoft.com/office/officeart/2005/8/layout/defaul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1CF527D-BDB2-4238-A196-B199C594F971}">
      <dsp:nvSpPr>
        <dsp:cNvPr id="0" name=""/>
        <dsp:cNvSpPr/>
      </dsp:nvSpPr>
      <dsp:spPr>
        <a:xfrm>
          <a:off x="3080" y="385801"/>
          <a:ext cx="2444055" cy="1466433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Examine patient (hydration, febrile?, septic?)</a:t>
          </a:r>
        </a:p>
      </dsp:txBody>
      <dsp:txXfrm>
        <a:off x="3080" y="385801"/>
        <a:ext cx="2444055" cy="1466433"/>
      </dsp:txXfrm>
    </dsp:sp>
    <dsp:sp modelId="{2CCEF345-5086-4A45-BA0B-D432D2B3EBFF}">
      <dsp:nvSpPr>
        <dsp:cNvPr id="0" name=""/>
        <dsp:cNvSpPr/>
      </dsp:nvSpPr>
      <dsp:spPr>
        <a:xfrm>
          <a:off x="2691541" y="385801"/>
          <a:ext cx="2444055" cy="1466433"/>
        </a:xfrm>
        <a:prstGeom prst="rect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With exam and Cr/BUN, assess need for NS bolus</a:t>
          </a:r>
        </a:p>
      </dsp:txBody>
      <dsp:txXfrm>
        <a:off x="2691541" y="385801"/>
        <a:ext cx="2444055" cy="1466433"/>
      </dsp:txXfrm>
    </dsp:sp>
    <dsp:sp modelId="{915B4FB4-2720-4F65-9AA2-AD3C8CBF472E}">
      <dsp:nvSpPr>
        <dsp:cNvPr id="0" name=""/>
        <dsp:cNvSpPr/>
      </dsp:nvSpPr>
      <dsp:spPr>
        <a:xfrm>
          <a:off x="5380002" y="385801"/>
          <a:ext cx="2444055" cy="1466433"/>
        </a:xfrm>
        <a:prstGeom prst="rect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Reassess patient after each NS bolus</a:t>
          </a:r>
        </a:p>
      </dsp:txBody>
      <dsp:txXfrm>
        <a:off x="5380002" y="385801"/>
        <a:ext cx="2444055" cy="1466433"/>
      </dsp:txXfrm>
    </dsp:sp>
    <dsp:sp modelId="{714D7775-5DA0-4FCB-8A6B-AD9086E2766E}">
      <dsp:nvSpPr>
        <dsp:cNvPr id="0" name=""/>
        <dsp:cNvSpPr/>
      </dsp:nvSpPr>
      <dsp:spPr>
        <a:xfrm>
          <a:off x="8068463" y="385801"/>
          <a:ext cx="2444055" cy="1466433"/>
        </a:xfrm>
        <a:prstGeom prst="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Check BMP, Mg, PHO4 (among others) </a:t>
          </a:r>
        </a:p>
      </dsp:txBody>
      <dsp:txXfrm>
        <a:off x="8068463" y="385801"/>
        <a:ext cx="2444055" cy="1466433"/>
      </dsp:txXfrm>
    </dsp:sp>
    <dsp:sp modelId="{35011309-6AAA-4DB5-8756-CCA8CCC6FD9E}">
      <dsp:nvSpPr>
        <dsp:cNvPr id="0" name=""/>
        <dsp:cNvSpPr/>
      </dsp:nvSpPr>
      <dsp:spPr>
        <a:xfrm>
          <a:off x="3080" y="2096640"/>
          <a:ext cx="2444055" cy="1466433"/>
        </a:xfrm>
        <a:prstGeom prst="rect">
          <a:avLst/>
        </a:prstGeom>
        <a:solidFill>
          <a:schemeClr val="accent6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Assess need for lyte replacement </a:t>
          </a:r>
        </a:p>
      </dsp:txBody>
      <dsp:txXfrm>
        <a:off x="3080" y="2096640"/>
        <a:ext cx="2444055" cy="1466433"/>
      </dsp:txXfrm>
    </dsp:sp>
    <dsp:sp modelId="{49713C90-C351-4762-9FC6-5CE27B4BC4CA}">
      <dsp:nvSpPr>
        <dsp:cNvPr id="0" name=""/>
        <dsp:cNvSpPr/>
      </dsp:nvSpPr>
      <dsp:spPr>
        <a:xfrm>
          <a:off x="2691541" y="2096640"/>
          <a:ext cx="2444055" cy="1466433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Recheck labs after lyte replacement</a:t>
          </a:r>
        </a:p>
      </dsp:txBody>
      <dsp:txXfrm>
        <a:off x="2691541" y="2096640"/>
        <a:ext cx="2444055" cy="1466433"/>
      </dsp:txXfrm>
    </dsp:sp>
    <dsp:sp modelId="{1DC6F5A5-4EA4-4DD5-8073-9ECC4DDFA32B}">
      <dsp:nvSpPr>
        <dsp:cNvPr id="0" name=""/>
        <dsp:cNvSpPr/>
      </dsp:nvSpPr>
      <dsp:spPr>
        <a:xfrm>
          <a:off x="5380002" y="2096640"/>
          <a:ext cx="2444055" cy="1466433"/>
        </a:xfrm>
        <a:prstGeom prst="rect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Central vs Peripheral access </a:t>
          </a:r>
        </a:p>
      </dsp:txBody>
      <dsp:txXfrm>
        <a:off x="5380002" y="2096640"/>
        <a:ext cx="2444055" cy="1466433"/>
      </dsp:txXfrm>
    </dsp:sp>
    <dsp:sp modelId="{4983FC67-8604-4C99-9A3B-E77D2478F913}">
      <dsp:nvSpPr>
        <dsp:cNvPr id="0" name=""/>
        <dsp:cNvSpPr/>
      </dsp:nvSpPr>
      <dsp:spPr>
        <a:xfrm>
          <a:off x="8068463" y="2096640"/>
          <a:ext cx="2444055" cy="1466433"/>
        </a:xfrm>
        <a:prstGeom prst="rect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/>
            <a:t>Parenteral % vs Enteral % </a:t>
          </a:r>
        </a:p>
      </dsp:txBody>
      <dsp:txXfrm>
        <a:off x="8068463" y="2096640"/>
        <a:ext cx="2444055" cy="146643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default">
  <dgm:title val=""/>
  <dgm:desc val=""/>
  <dgm:catLst>
    <dgm:cat type="list" pri="4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diagram">
    <dgm:varLst>
      <dgm:dir/>
      <dgm:resizeHandles val="exact"/>
    </dgm:varLst>
    <dgm:choose name="Name0">
      <dgm:if name="Name1" func="var" arg="dir" op="equ" val="norm">
        <dgm:alg type="snake">
          <dgm:param type="grDir" val="tL"/>
          <dgm:param type="flowDir" val="row"/>
          <dgm:param type="contDir" val="sameDir"/>
          <dgm:param type="off" val="ctr"/>
        </dgm:alg>
      </dgm:if>
      <dgm:else name="Name2">
        <dgm:alg type="snake">
          <dgm:param type="grDir" val="tR"/>
          <dgm:param type="flowDir" val="row"/>
          <dgm:param type="contDir" val="sameDir"/>
          <dgm:param type="off" val="ct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node" refType="w"/>
      <dgm:constr type="h" for="ch" forName="node" refType="w" refFor="ch" refForName="node" fact="0.6"/>
      <dgm:constr type="w" for="ch" forName="sibTrans" refType="w" refFor="ch" refForName="node" fact="0.1"/>
      <dgm:constr type="sp" refType="w" refFor="ch" refForName="sibTrans"/>
      <dgm:constr type="primFontSz" for="ch" forName="node" op="equ" val="65"/>
    </dgm:constrLst>
    <dgm:ruleLst/>
    <dgm:forEach name="Name3" axis="ch" ptType="node">
      <dgm:layoutNode name="node">
        <dgm:varLst>
          <dgm:bulletEnabled val="1"/>
        </dgm:varLst>
        <dgm:alg type="tx"/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3"/>
          <dgm:constr type="rMarg" refType="primFontSz" fact="0.3"/>
          <dgm:constr type="tMarg" refType="primFontSz" fact="0.3"/>
          <dgm:constr type="bMarg" refType="primFontSz" fact="0.3"/>
        </dgm:constrLst>
        <dgm:ruleLst>
          <dgm:rule type="primFontSz" val="5" fact="NaN" max="NaN"/>
        </dgm:ruleLst>
      </dgm:layoutNode>
      <dgm:forEach name="Name4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A58C7F-ACB3-41BD-BD99-9284E830DF03}" type="datetimeFigureOut">
              <a:t>5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FF64F-F7DE-42F2-ADF5-FCF6457B073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767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06601F-3A51-494E-B4DA-8AE7D58CBF0E}" type="slidenum"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2373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Trophamine</a:t>
            </a:r>
            <a:r>
              <a:rPr lang="en-US" dirty="0"/>
              <a:t> for infants/</a:t>
            </a:r>
            <a:r>
              <a:rPr lang="en-US" dirty="0" err="1"/>
              <a:t>premies</a:t>
            </a:r>
            <a:r>
              <a:rPr lang="en-US" dirty="0"/>
              <a:t>, similar to BM (cysteine essential AA). </a:t>
            </a:r>
            <a:r>
              <a:rPr lang="en-US" dirty="0" err="1"/>
              <a:t>Aminosyn</a:t>
            </a:r>
            <a:r>
              <a:rPr lang="en-US" dirty="0"/>
              <a:t> –PF (for renal failure)</a:t>
            </a:r>
          </a:p>
          <a:p>
            <a:r>
              <a:rPr lang="en-US" dirty="0" err="1"/>
              <a:t>Travasol</a:t>
            </a:r>
            <a:r>
              <a:rPr lang="en-US" dirty="0"/>
              <a:t> (standard) for children and adults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06601F-3A51-494E-B4DA-8AE7D58CBF0E}" type="slidenum">
              <a:rPr lang="en-US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417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jpe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4.png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8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1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png"/><Relationship Id="rId4" Type="http://schemas.openxmlformats.org/officeDocument/2006/relationships/image" Target="../media/image4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TPN Workshop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By: Sirine Belaid 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00D8A194-5B46-C07E-6F73-16CE0E6957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8454" y="1854530"/>
            <a:ext cx="8430295" cy="36830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63317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E5F539E8-8A1B-873C-F616-9EE00D7D9F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5140" y="1419315"/>
            <a:ext cx="8720070" cy="3635439"/>
          </a:xfrm>
          <a:prstGeom prst="rect">
            <a:avLst/>
          </a:prstGeom>
        </p:spPr>
      </p:pic>
      <p:sp>
        <p:nvSpPr>
          <p:cNvPr id="4" name="Flowchart: Process 3">
            <a:extLst>
              <a:ext uri="{FF2B5EF4-FFF2-40B4-BE49-F238E27FC236}">
                <a16:creationId xmlns:a16="http://schemas.microsoft.com/office/drawing/2014/main" id="{CD39DF3C-48CA-1D04-F69B-80A55457EC9D}"/>
              </a:ext>
            </a:extLst>
          </p:cNvPr>
          <p:cNvSpPr/>
          <p:nvPr/>
        </p:nvSpPr>
        <p:spPr>
          <a:xfrm>
            <a:off x="5021662" y="4109055"/>
            <a:ext cx="4891218" cy="23239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9435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8D90AB9F-86EF-3500-3530-46687F20E6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311" y="1007144"/>
            <a:ext cx="11301932" cy="5042218"/>
          </a:xfrm>
          <a:prstGeom prst="rect">
            <a:avLst/>
          </a:prstGeom>
        </p:spPr>
      </p:pic>
      <p:sp>
        <p:nvSpPr>
          <p:cNvPr id="4" name="Flowchart: Process 3">
            <a:extLst>
              <a:ext uri="{FF2B5EF4-FFF2-40B4-BE49-F238E27FC236}">
                <a16:creationId xmlns:a16="http://schemas.microsoft.com/office/drawing/2014/main" id="{78CD1E7D-0379-EFA8-8800-1E96386F0F9E}"/>
              </a:ext>
            </a:extLst>
          </p:cNvPr>
          <p:cNvSpPr/>
          <p:nvPr/>
        </p:nvSpPr>
        <p:spPr>
          <a:xfrm>
            <a:off x="4590087" y="1735391"/>
            <a:ext cx="4587767" cy="21216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BB68E6D0-D34C-777C-060A-88BD13B8E5D4}"/>
              </a:ext>
            </a:extLst>
          </p:cNvPr>
          <p:cNvSpPr/>
          <p:nvPr/>
        </p:nvSpPr>
        <p:spPr>
          <a:xfrm>
            <a:off x="665448" y="1721905"/>
            <a:ext cx="3926919" cy="3887299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0172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031F6F2D-15CB-C5FE-64DD-76E4EBEF07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897" y="912144"/>
            <a:ext cx="10027379" cy="2940323"/>
          </a:xfrm>
          <a:prstGeom prst="rect">
            <a:avLst/>
          </a:prstGeom>
        </p:spPr>
      </p:pic>
      <p:pic>
        <p:nvPicPr>
          <p:cNvPr id="3" name="Picture 2" descr="A black and blue rectangle with black text&#10;&#10;Description automatically generated">
            <a:extLst>
              <a:ext uri="{FF2B5EF4-FFF2-40B4-BE49-F238E27FC236}">
                <a16:creationId xmlns:a16="http://schemas.microsoft.com/office/drawing/2014/main" id="{8A13BC03-44D4-0458-BA9C-98228A9AD5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7" y="4704225"/>
            <a:ext cx="12590481" cy="1461910"/>
          </a:xfrm>
          <a:prstGeom prst="rect">
            <a:avLst/>
          </a:prstGeom>
        </p:spPr>
      </p:pic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34BC02AE-5590-32FE-3F7D-A71DBFD4767C}"/>
              </a:ext>
            </a:extLst>
          </p:cNvPr>
          <p:cNvSpPr/>
          <p:nvPr/>
        </p:nvSpPr>
        <p:spPr>
          <a:xfrm>
            <a:off x="125981" y="5295886"/>
            <a:ext cx="6624261" cy="299830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7567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DC1F1B1C-BF2D-A3A7-56ED-95B330C6E4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311" y="1007144"/>
            <a:ext cx="11301932" cy="5042218"/>
          </a:xfrm>
          <a:prstGeom prst="rect">
            <a:avLst/>
          </a:prstGeom>
        </p:spPr>
      </p:pic>
      <p:sp>
        <p:nvSpPr>
          <p:cNvPr id="2" name="Flowchart: Process 1">
            <a:extLst>
              <a:ext uri="{FF2B5EF4-FFF2-40B4-BE49-F238E27FC236}">
                <a16:creationId xmlns:a16="http://schemas.microsoft.com/office/drawing/2014/main" id="{AEE9AC63-952D-F366-B0F7-9D249E1B3F01}"/>
              </a:ext>
            </a:extLst>
          </p:cNvPr>
          <p:cNvSpPr/>
          <p:nvPr/>
        </p:nvSpPr>
        <p:spPr>
          <a:xfrm>
            <a:off x="591273" y="1020596"/>
            <a:ext cx="1141909" cy="35377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2581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7EB9E41C-CE66-D2EC-060F-EE1D475604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697" y="329186"/>
            <a:ext cx="7965781" cy="3798367"/>
          </a:xfrm>
          <a:prstGeom prst="rect">
            <a:avLst/>
          </a:prstGeom>
        </p:spPr>
      </p:pic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68F65515-2D4E-1C69-A3EE-F7D7FAEC23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8403" y="2736878"/>
            <a:ext cx="7626403" cy="3657439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CA7DD2B3-30A0-A3E4-BA9E-7844C3FD1FAA}"/>
              </a:ext>
            </a:extLst>
          </p:cNvPr>
          <p:cNvSpPr/>
          <p:nvPr/>
        </p:nvSpPr>
        <p:spPr>
          <a:xfrm>
            <a:off x="101065" y="1152779"/>
            <a:ext cx="1253935" cy="49550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77234ED6-0442-DB89-56F4-BCB0248887EF}"/>
              </a:ext>
            </a:extLst>
          </p:cNvPr>
          <p:cNvSpPr/>
          <p:nvPr/>
        </p:nvSpPr>
        <p:spPr>
          <a:xfrm>
            <a:off x="4484250" y="3519699"/>
            <a:ext cx="1253935" cy="49550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16847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A066D-6368-016B-92A4-33AFDAE81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6644" y="2982736"/>
            <a:ext cx="10515600" cy="1325563"/>
          </a:xfrm>
        </p:spPr>
        <p:txBody>
          <a:bodyPr/>
          <a:lstStyle/>
          <a:p>
            <a:r>
              <a:rPr lang="en-US" dirty="0"/>
              <a:t>Order Lipid: </a:t>
            </a:r>
          </a:p>
        </p:txBody>
      </p:sp>
      <p:pic>
        <p:nvPicPr>
          <p:cNvPr id="4" name="Picture 3" descr="A close-up of a medical form&#10;&#10;Description automatically generated">
            <a:extLst>
              <a:ext uri="{FF2B5EF4-FFF2-40B4-BE49-F238E27FC236}">
                <a16:creationId xmlns:a16="http://schemas.microsoft.com/office/drawing/2014/main" id="{732CD579-E6AB-D084-B1A7-6F62D0CDB0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1577" y="203105"/>
            <a:ext cx="6065125" cy="6458430"/>
          </a:xfrm>
          <a:prstGeom prst="rect">
            <a:avLst/>
          </a:prstGeom>
        </p:spPr>
      </p:pic>
      <p:sp>
        <p:nvSpPr>
          <p:cNvPr id="6" name="Flowchart: Process 5">
            <a:extLst>
              <a:ext uri="{FF2B5EF4-FFF2-40B4-BE49-F238E27FC236}">
                <a16:creationId xmlns:a16="http://schemas.microsoft.com/office/drawing/2014/main" id="{33A021EB-33D7-6BA1-5AF7-3FFF2FEFC68C}"/>
              </a:ext>
            </a:extLst>
          </p:cNvPr>
          <p:cNvSpPr/>
          <p:nvPr/>
        </p:nvSpPr>
        <p:spPr>
          <a:xfrm>
            <a:off x="4570981" y="5239443"/>
            <a:ext cx="5580040" cy="694939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737E187-B4B9-4F1C-F620-DAFFFA253E47}"/>
              </a:ext>
            </a:extLst>
          </p:cNvPr>
          <p:cNvSpPr/>
          <p:nvPr/>
        </p:nvSpPr>
        <p:spPr>
          <a:xfrm>
            <a:off x="8068892" y="316843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714D9FF-F973-F9DE-2C8E-9D57AA952318}"/>
              </a:ext>
            </a:extLst>
          </p:cNvPr>
          <p:cNvSpPr/>
          <p:nvPr/>
        </p:nvSpPr>
        <p:spPr>
          <a:xfrm>
            <a:off x="8068892" y="749531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B21DD64-0211-1F52-DFFE-03D8887A6B96}"/>
              </a:ext>
            </a:extLst>
          </p:cNvPr>
          <p:cNvSpPr/>
          <p:nvPr/>
        </p:nvSpPr>
        <p:spPr>
          <a:xfrm>
            <a:off x="8068892" y="1070317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35026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1335E-0275-7F85-1A60-B2E9C5BFC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2644" y="-390"/>
            <a:ext cx="10515600" cy="1325563"/>
          </a:xfrm>
        </p:spPr>
        <p:txBody>
          <a:bodyPr/>
          <a:lstStyle/>
          <a:p>
            <a:r>
              <a:rPr lang="en-US"/>
              <a:t>Order Lipid:</a:t>
            </a:r>
          </a:p>
        </p:txBody>
      </p:sp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9CA5B310-D03A-7329-33CD-95586F092B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75831"/>
            <a:ext cx="8644537" cy="2148407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4A8D6F5F-34DB-D300-210A-6B40BA20F7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8009" y="1971292"/>
            <a:ext cx="7415092" cy="4759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17991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A7D018EA-1425-8A40-131E-D968305371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685" y="193511"/>
            <a:ext cx="8206529" cy="2178902"/>
          </a:xfrm>
          <a:prstGeom prst="rect">
            <a:avLst/>
          </a:prstGeom>
        </p:spPr>
      </p:pic>
      <p:pic>
        <p:nvPicPr>
          <p:cNvPr id="4" name="Picture 3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29B50A29-AA21-E924-00DF-7F71861CD3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2345" y="2525502"/>
            <a:ext cx="8698605" cy="1476006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D0A40B72-A448-7CED-0238-F94A2B9AF5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071" y="4413029"/>
            <a:ext cx="5763296" cy="2171715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2103AE8E-BE3F-8E84-1183-5AB00DBDB2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09904" y="4432216"/>
            <a:ext cx="6396507" cy="2078914"/>
          </a:xfrm>
          <a:prstGeom prst="rect">
            <a:avLst/>
          </a:prstGeom>
        </p:spPr>
      </p:pic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BDBA37F0-C05B-C612-7BBC-677D817BBDEC}"/>
              </a:ext>
            </a:extLst>
          </p:cNvPr>
          <p:cNvSpPr/>
          <p:nvPr/>
        </p:nvSpPr>
        <p:spPr>
          <a:xfrm>
            <a:off x="3976440" y="1364506"/>
            <a:ext cx="3542546" cy="19193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lowchart: Process 8">
            <a:extLst>
              <a:ext uri="{FF2B5EF4-FFF2-40B4-BE49-F238E27FC236}">
                <a16:creationId xmlns:a16="http://schemas.microsoft.com/office/drawing/2014/main" id="{622AC965-8D71-CCBD-E839-502951156F24}"/>
              </a:ext>
            </a:extLst>
          </p:cNvPr>
          <p:cNvSpPr/>
          <p:nvPr/>
        </p:nvSpPr>
        <p:spPr>
          <a:xfrm>
            <a:off x="5318370" y="2821073"/>
            <a:ext cx="5956669" cy="218911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B53EBF3C-41B4-4216-F114-66A91415C91C}"/>
              </a:ext>
            </a:extLst>
          </p:cNvPr>
          <p:cNvSpPr/>
          <p:nvPr/>
        </p:nvSpPr>
        <p:spPr>
          <a:xfrm>
            <a:off x="-85" y="4430053"/>
            <a:ext cx="647033" cy="55619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A96E9AD8-572F-C963-522A-826169E2B2ED}"/>
              </a:ext>
            </a:extLst>
          </p:cNvPr>
          <p:cNvSpPr/>
          <p:nvPr/>
        </p:nvSpPr>
        <p:spPr>
          <a:xfrm>
            <a:off x="80835" y="5225770"/>
            <a:ext cx="1253935" cy="49550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58A84396-DC60-9114-B31C-4A25ACB00665}"/>
              </a:ext>
            </a:extLst>
          </p:cNvPr>
          <p:cNvSpPr/>
          <p:nvPr/>
        </p:nvSpPr>
        <p:spPr>
          <a:xfrm>
            <a:off x="5617136" y="5252744"/>
            <a:ext cx="1253935" cy="49550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02232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4EFCF-191A-6287-E565-C9AC7EAFA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2298" y="182675"/>
            <a:ext cx="10515600" cy="1325563"/>
          </a:xfrm>
        </p:spPr>
        <p:txBody>
          <a:bodyPr/>
          <a:lstStyle/>
          <a:p>
            <a:r>
              <a:rPr lang="en-US"/>
              <a:t>If Ordering Other Lipids</a:t>
            </a:r>
          </a:p>
        </p:txBody>
      </p:sp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EB09960A-C6BF-FCA2-9E9D-924DCF6282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03" y="1957658"/>
            <a:ext cx="6096000" cy="1204489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1E0460D6-FEFB-2DA3-0F87-6FA17228C7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0536" y="937493"/>
            <a:ext cx="6096000" cy="2582475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395BE260-6AD7-CFCD-F3E8-16A2EC444A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225" y="4850549"/>
            <a:ext cx="6096000" cy="1420999"/>
          </a:xfrm>
          <a:prstGeom prst="rect">
            <a:avLst/>
          </a:prstGeom>
        </p:spPr>
      </p:pic>
      <p:pic>
        <p:nvPicPr>
          <p:cNvPr id="7" name="Picture 6" descr="A screenshot of a medical report&#10;&#10;Description automatically generated">
            <a:extLst>
              <a:ext uri="{FF2B5EF4-FFF2-40B4-BE49-F238E27FC236}">
                <a16:creationId xmlns:a16="http://schemas.microsoft.com/office/drawing/2014/main" id="{4CB0D616-5E4B-6E5F-C929-7FC16D4524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98326" y="4209791"/>
            <a:ext cx="6096000" cy="2429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7701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AC552-72AD-DD2B-882E-695954EA90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PN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34ABDD-866E-E12A-98AB-40B175ED153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0699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6163-41C0-84F5-5AA7-1C10CAB73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54" y="2765910"/>
            <a:ext cx="9993489" cy="1325563"/>
          </a:xfrm>
        </p:spPr>
        <p:txBody>
          <a:bodyPr/>
          <a:lstStyle/>
          <a:p>
            <a:r>
              <a:rPr lang="en-US" dirty="0"/>
              <a:t>Don't Forget Extra Hydration</a:t>
            </a:r>
          </a:p>
        </p:txBody>
      </p:sp>
      <p:pic>
        <p:nvPicPr>
          <p:cNvPr id="8" name="Picture 7" descr="A close-up of a medical form&#10;&#10;Description automatically generated">
            <a:extLst>
              <a:ext uri="{FF2B5EF4-FFF2-40B4-BE49-F238E27FC236}">
                <a16:creationId xmlns:a16="http://schemas.microsoft.com/office/drawing/2014/main" id="{D227208A-0367-7B37-DBBF-C6D89A45CD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3520" y="428881"/>
            <a:ext cx="5677070" cy="6042154"/>
          </a:xfrm>
          <a:prstGeom prst="rect">
            <a:avLst/>
          </a:prstGeom>
        </p:spPr>
      </p:pic>
      <p:sp>
        <p:nvSpPr>
          <p:cNvPr id="11" name="Flowchart: Process 10">
            <a:extLst>
              <a:ext uri="{FF2B5EF4-FFF2-40B4-BE49-F238E27FC236}">
                <a16:creationId xmlns:a16="http://schemas.microsoft.com/office/drawing/2014/main" id="{59756321-B5F1-65EF-7F78-165D686A3807}"/>
              </a:ext>
            </a:extLst>
          </p:cNvPr>
          <p:cNvSpPr/>
          <p:nvPr/>
        </p:nvSpPr>
        <p:spPr>
          <a:xfrm>
            <a:off x="6687648" y="5775665"/>
            <a:ext cx="5389541" cy="687884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E38F8BF-0211-609D-877C-7793EC8C03CA}"/>
              </a:ext>
            </a:extLst>
          </p:cNvPr>
          <p:cNvSpPr/>
          <p:nvPr/>
        </p:nvSpPr>
        <p:spPr>
          <a:xfrm>
            <a:off x="9997871" y="526793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858643D-EBF6-A457-7006-6C7ABB799401}"/>
              </a:ext>
            </a:extLst>
          </p:cNvPr>
          <p:cNvSpPr/>
          <p:nvPr/>
        </p:nvSpPr>
        <p:spPr>
          <a:xfrm>
            <a:off x="9997871" y="953087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2D721BA-F51C-1A42-BB31-BE0F0501BF15}"/>
              </a:ext>
            </a:extLst>
          </p:cNvPr>
          <p:cNvSpPr/>
          <p:nvPr/>
        </p:nvSpPr>
        <p:spPr>
          <a:xfrm>
            <a:off x="9997871" y="1230177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20349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6163-41C0-84F5-5AA7-1C10CAB73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1276" y="133"/>
            <a:ext cx="10515600" cy="1325563"/>
          </a:xfrm>
        </p:spPr>
        <p:txBody>
          <a:bodyPr/>
          <a:lstStyle/>
          <a:p>
            <a:r>
              <a:rPr lang="en-US"/>
              <a:t>Don't Forget Extra Hydration:</a:t>
            </a:r>
          </a:p>
        </p:txBody>
      </p:sp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2E5E6F8F-2001-B58C-04D3-3E94465290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874" y="1502494"/>
            <a:ext cx="6096000" cy="3677055"/>
          </a:xfrm>
          <a:prstGeom prst="rect">
            <a:avLst/>
          </a:prstGeom>
        </p:spPr>
      </p:pic>
      <p:pic>
        <p:nvPicPr>
          <p:cNvPr id="5" name="Picture 4" descr="A screenshot of a medical report&#10;&#10;Description automatically generated">
            <a:extLst>
              <a:ext uri="{FF2B5EF4-FFF2-40B4-BE49-F238E27FC236}">
                <a16:creationId xmlns:a16="http://schemas.microsoft.com/office/drawing/2014/main" id="{55E18AF8-C29D-D359-1718-D4962B6244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4203" y="1712789"/>
            <a:ext cx="6096000" cy="2038471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D6EBE4EA-0D21-7864-4E0F-865BFE58FC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9076" y="4980941"/>
            <a:ext cx="6096000" cy="1514475"/>
          </a:xfrm>
          <a:prstGeom prst="rect">
            <a:avLst/>
          </a:prstGeom>
        </p:spPr>
      </p:pic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8A7B1E0F-CFB0-DFF9-80E9-168D43CF19E7}"/>
              </a:ext>
            </a:extLst>
          </p:cNvPr>
          <p:cNvSpPr/>
          <p:nvPr/>
        </p:nvSpPr>
        <p:spPr>
          <a:xfrm>
            <a:off x="139467" y="1506117"/>
            <a:ext cx="1506051" cy="286344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lowchart: Process 8">
            <a:extLst>
              <a:ext uri="{FF2B5EF4-FFF2-40B4-BE49-F238E27FC236}">
                <a16:creationId xmlns:a16="http://schemas.microsoft.com/office/drawing/2014/main" id="{44520E45-38F9-1C14-504C-EF35711E769E}"/>
              </a:ext>
            </a:extLst>
          </p:cNvPr>
          <p:cNvSpPr/>
          <p:nvPr/>
        </p:nvSpPr>
        <p:spPr>
          <a:xfrm>
            <a:off x="7307661" y="5848842"/>
            <a:ext cx="4189908" cy="19193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74646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0022D-BB98-C63F-C7FF-4BA035443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PN-Like Fluids 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BFF93B-2B38-F1BA-1732-585ACEA2782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01352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3824F-ECD1-10CA-7CE8-EE77DB7B4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en-US" sz="5400"/>
              <a:t>First Thing First:</a:t>
            </a:r>
          </a:p>
        </p:txBody>
      </p:sp>
      <p:graphicFrame>
        <p:nvGraphicFramePr>
          <p:cNvPr id="18" name="Content Placeholder 2">
            <a:extLst>
              <a:ext uri="{FF2B5EF4-FFF2-40B4-BE49-F238E27FC236}">
                <a16:creationId xmlns:a16="http://schemas.microsoft.com/office/drawing/2014/main" id="{F4A10D47-5A5C-6403-E09B-7C4037E1435B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838200" y="2228087"/>
          <a:ext cx="10515600" cy="394887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93190413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89118C-04CE-C79A-1972-1A5D750165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lculate TPN-Like Fluids </a:t>
            </a:r>
          </a:p>
        </p:txBody>
      </p:sp>
    </p:spTree>
    <p:extLst>
      <p:ext uri="{BB962C8B-B14F-4D97-AF65-F5344CB8AC3E}">
        <p14:creationId xmlns:p14="http://schemas.microsoft.com/office/powerpoint/2010/main" val="298425928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9050E2-8D86-1CE2-1DAE-D1D3F0541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5735" y="-112466"/>
            <a:ext cx="10515600" cy="1325563"/>
          </a:xfrm>
        </p:spPr>
        <p:txBody>
          <a:bodyPr/>
          <a:lstStyle/>
          <a:p>
            <a:r>
              <a:rPr lang="en-US" dirty="0"/>
              <a:t>1 - Calculate TPN-Like Fluid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C8D225-CFB3-835A-E034-CE62DC5DCF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769734" y="1814893"/>
            <a:ext cx="6007995" cy="4850394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>
              <a:buNone/>
            </a:pPr>
            <a:r>
              <a:rPr lang="en-US" b="1" u="sng" dirty="0"/>
              <a:t>Need:</a:t>
            </a:r>
          </a:p>
          <a:p>
            <a:pPr marL="0" indent="0">
              <a:buNone/>
            </a:pPr>
            <a:endParaRPr lang="en-US"/>
          </a:p>
          <a:p>
            <a:r>
              <a:rPr lang="en-US" dirty="0"/>
              <a:t>Weight </a:t>
            </a:r>
          </a:p>
          <a:p>
            <a:r>
              <a:rPr lang="en-US" dirty="0"/>
              <a:t>Dextrose conc.</a:t>
            </a:r>
          </a:p>
          <a:p>
            <a:r>
              <a:rPr lang="en-US" dirty="0"/>
              <a:t>For </a:t>
            </a:r>
            <a:r>
              <a:rPr lang="en-US" err="1"/>
              <a:t>lytes</a:t>
            </a:r>
            <a:r>
              <a:rPr lang="en-US"/>
              <a:t>, focus on Na, K, Acet </a:t>
            </a:r>
          </a:p>
          <a:p>
            <a:r>
              <a:rPr lang="en-US" dirty="0"/>
              <a:t>Total TPN volume</a:t>
            </a:r>
          </a:p>
          <a:p>
            <a:r>
              <a:rPr lang="en-US" dirty="0"/>
              <a:t>Maintenance fluid rate (based on </a:t>
            </a:r>
            <a:r>
              <a:rPr lang="en-US" dirty="0" err="1"/>
              <a:t>wt</a:t>
            </a:r>
            <a:r>
              <a:rPr lang="en-US" dirty="0"/>
              <a:t>)</a:t>
            </a:r>
          </a:p>
          <a:p>
            <a:r>
              <a:rPr lang="en-US" dirty="0"/>
              <a:t>Extra hydration or not?</a:t>
            </a:r>
          </a:p>
        </p:txBody>
      </p:sp>
      <p:pic>
        <p:nvPicPr>
          <p:cNvPr id="7" name="Picture 6" descr="A medical form with numbers and text&#10;&#10;Description automatically generated">
            <a:extLst>
              <a:ext uri="{FF2B5EF4-FFF2-40B4-BE49-F238E27FC236}">
                <a16:creationId xmlns:a16="http://schemas.microsoft.com/office/drawing/2014/main" id="{369BDD8B-8588-2E51-8B50-724FF1061E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304" y="1025879"/>
            <a:ext cx="5136005" cy="5638799"/>
          </a:xfrm>
          <a:prstGeom prst="rect">
            <a:avLst/>
          </a:prstGeom>
        </p:spPr>
      </p:pic>
      <p:sp>
        <p:nvSpPr>
          <p:cNvPr id="11" name="Oval 10">
            <a:extLst>
              <a:ext uri="{FF2B5EF4-FFF2-40B4-BE49-F238E27FC236}">
                <a16:creationId xmlns:a16="http://schemas.microsoft.com/office/drawing/2014/main" id="{D73E02A3-D443-DB0E-5656-D79320260562}"/>
              </a:ext>
            </a:extLst>
          </p:cNvPr>
          <p:cNvSpPr/>
          <p:nvPr/>
        </p:nvSpPr>
        <p:spPr>
          <a:xfrm>
            <a:off x="1593530" y="1632298"/>
            <a:ext cx="836052" cy="362997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B115BB4-AFD6-968C-7187-B33813FD14C1}"/>
              </a:ext>
            </a:extLst>
          </p:cNvPr>
          <p:cNvSpPr/>
          <p:nvPr/>
        </p:nvSpPr>
        <p:spPr>
          <a:xfrm>
            <a:off x="3567670" y="1015321"/>
            <a:ext cx="1016904" cy="1951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545EADD-59F9-0BDA-84D6-A1722CE61AC7}"/>
              </a:ext>
            </a:extLst>
          </p:cNvPr>
          <p:cNvSpPr/>
          <p:nvPr/>
        </p:nvSpPr>
        <p:spPr>
          <a:xfrm>
            <a:off x="3566647" y="1715722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lowchart: Process 22">
            <a:extLst>
              <a:ext uri="{FF2B5EF4-FFF2-40B4-BE49-F238E27FC236}">
                <a16:creationId xmlns:a16="http://schemas.microsoft.com/office/drawing/2014/main" id="{F6C05B64-5D1F-993C-809A-66E67911168C}"/>
              </a:ext>
            </a:extLst>
          </p:cNvPr>
          <p:cNvSpPr/>
          <p:nvPr/>
        </p:nvSpPr>
        <p:spPr>
          <a:xfrm>
            <a:off x="518843" y="2339171"/>
            <a:ext cx="2211357" cy="54196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Flowchart: Process 24">
            <a:extLst>
              <a:ext uri="{FF2B5EF4-FFF2-40B4-BE49-F238E27FC236}">
                <a16:creationId xmlns:a16="http://schemas.microsoft.com/office/drawing/2014/main" id="{DA9CD1DE-EE36-A229-E759-1D21D0D53582}"/>
              </a:ext>
            </a:extLst>
          </p:cNvPr>
          <p:cNvSpPr/>
          <p:nvPr/>
        </p:nvSpPr>
        <p:spPr>
          <a:xfrm>
            <a:off x="617308" y="3133639"/>
            <a:ext cx="1297007" cy="29308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Flowchart: Process 26">
            <a:extLst>
              <a:ext uri="{FF2B5EF4-FFF2-40B4-BE49-F238E27FC236}">
                <a16:creationId xmlns:a16="http://schemas.microsoft.com/office/drawing/2014/main" id="{000E27A4-2024-8802-36F2-E875F2C9E993}"/>
              </a:ext>
            </a:extLst>
          </p:cNvPr>
          <p:cNvSpPr/>
          <p:nvPr/>
        </p:nvSpPr>
        <p:spPr>
          <a:xfrm>
            <a:off x="4010781" y="5112880"/>
            <a:ext cx="1411645" cy="27960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Flowchart: Process 28">
            <a:extLst>
              <a:ext uri="{FF2B5EF4-FFF2-40B4-BE49-F238E27FC236}">
                <a16:creationId xmlns:a16="http://schemas.microsoft.com/office/drawing/2014/main" id="{47DA5E49-51D9-856D-DBAC-D9418D7F1836}"/>
              </a:ext>
            </a:extLst>
          </p:cNvPr>
          <p:cNvSpPr/>
          <p:nvPr/>
        </p:nvSpPr>
        <p:spPr>
          <a:xfrm>
            <a:off x="617309" y="3775509"/>
            <a:ext cx="1297007" cy="18613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Flowchart: Process 29">
            <a:extLst>
              <a:ext uri="{FF2B5EF4-FFF2-40B4-BE49-F238E27FC236}">
                <a16:creationId xmlns:a16="http://schemas.microsoft.com/office/drawing/2014/main" id="{2CDE898E-68FB-67B8-67D5-9CFD7F23871A}"/>
              </a:ext>
            </a:extLst>
          </p:cNvPr>
          <p:cNvSpPr/>
          <p:nvPr/>
        </p:nvSpPr>
        <p:spPr>
          <a:xfrm>
            <a:off x="617308" y="6031224"/>
            <a:ext cx="4297802" cy="17845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76671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AE76A-E90F-16DD-E8F0-6521F5FFBD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5359" y="589243"/>
            <a:ext cx="5085550" cy="1338369"/>
          </a:xfrm>
        </p:spPr>
        <p:txBody>
          <a:bodyPr/>
          <a:lstStyle/>
          <a:p>
            <a:r>
              <a:rPr lang="en-US" dirty="0"/>
              <a:t>Total TPN: 600 ml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154E4A-504B-F285-191C-FC2B0F11F3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519057" y="2350700"/>
            <a:ext cx="6475079" cy="3346011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Weight: 5.9kg</a:t>
            </a:r>
          </a:p>
          <a:p>
            <a:r>
              <a:rPr lang="en-US" dirty="0"/>
              <a:t>D15%</a:t>
            </a:r>
          </a:p>
          <a:p>
            <a:r>
              <a:rPr lang="en-US" dirty="0"/>
              <a:t>Na: 8 </a:t>
            </a:r>
            <a:r>
              <a:rPr lang="en-US" dirty="0" err="1"/>
              <a:t>mEq</a:t>
            </a:r>
            <a:r>
              <a:rPr lang="en-US" dirty="0"/>
              <a:t>/kg (47mEq), K: 2 </a:t>
            </a:r>
            <a:r>
              <a:rPr lang="en-US" dirty="0" err="1"/>
              <a:t>mEq</a:t>
            </a:r>
            <a:r>
              <a:rPr lang="en-US" dirty="0"/>
              <a:t>/kg (12mEq), Acet: 0 </a:t>
            </a:r>
            <a:r>
              <a:rPr lang="en-US" dirty="0" err="1"/>
              <a:t>mEq</a:t>
            </a:r>
            <a:r>
              <a:rPr lang="en-US" dirty="0"/>
              <a:t>/kg </a:t>
            </a:r>
          </a:p>
          <a:p>
            <a:r>
              <a:rPr lang="en-US" b="1" dirty="0"/>
              <a:t>Need to convert </a:t>
            </a:r>
            <a:r>
              <a:rPr lang="en-US" b="1" dirty="0" err="1"/>
              <a:t>lytes</a:t>
            </a:r>
            <a:r>
              <a:rPr lang="en-US" b="1" dirty="0"/>
              <a:t> from 600ml to 1000ml (1L) bag</a:t>
            </a:r>
            <a:endParaRPr lang="en-US"/>
          </a:p>
        </p:txBody>
      </p:sp>
      <p:pic>
        <p:nvPicPr>
          <p:cNvPr id="4" name="Picture 3" descr="A medical form with numbers and text&#10;&#10;Description automatically generated">
            <a:extLst>
              <a:ext uri="{FF2B5EF4-FFF2-40B4-BE49-F238E27FC236}">
                <a16:creationId xmlns:a16="http://schemas.microsoft.com/office/drawing/2014/main" id="{2C028B43-8789-C65A-00AD-048C0943AE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665" y="704851"/>
            <a:ext cx="5107782" cy="5645855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385A5BB-5602-E4F2-783F-32CDB9FB9E7B}"/>
              </a:ext>
            </a:extLst>
          </p:cNvPr>
          <p:cNvSpPr/>
          <p:nvPr/>
        </p:nvSpPr>
        <p:spPr>
          <a:xfrm>
            <a:off x="3546813" y="703045"/>
            <a:ext cx="1016904" cy="1951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8798A1F-5FDA-9339-F16C-1C42BBCA8ADB}"/>
              </a:ext>
            </a:extLst>
          </p:cNvPr>
          <p:cNvSpPr/>
          <p:nvPr/>
        </p:nvSpPr>
        <p:spPr>
          <a:xfrm>
            <a:off x="3545481" y="1405277"/>
            <a:ext cx="1016904" cy="1951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34364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CDAA9-25AE-B069-7EC7-77A005C3B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2065" y="-202168"/>
            <a:ext cx="10515600" cy="1325563"/>
          </a:xfrm>
        </p:spPr>
        <p:txBody>
          <a:bodyPr/>
          <a:lstStyle/>
          <a:p>
            <a:r>
              <a:rPr lang="en-US"/>
              <a:t>Convert to 1000 ml (1L): 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D1BCFB39-CF04-FACC-1188-03C1357FB1F6}"/>
              </a:ext>
            </a:extLst>
          </p:cNvPr>
          <p:cNvSpPr txBox="1">
            <a:spLocks/>
          </p:cNvSpPr>
          <p:nvPr/>
        </p:nvSpPr>
        <p:spPr>
          <a:xfrm>
            <a:off x="451225" y="1124330"/>
            <a:ext cx="10778137" cy="139932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/>
              <a:t>  </a:t>
            </a:r>
            <a:r>
              <a:rPr lang="en-US" sz="2800" b="1" dirty="0"/>
              <a:t>600 ml</a:t>
            </a:r>
            <a:r>
              <a:rPr lang="en-US" sz="2800" dirty="0"/>
              <a:t> bag                                             </a:t>
            </a:r>
            <a:r>
              <a:rPr lang="en-US" sz="2800" b="1" dirty="0"/>
              <a:t>1000 ml</a:t>
            </a:r>
            <a:r>
              <a:rPr lang="en-US" sz="2800" dirty="0"/>
              <a:t> bag          </a:t>
            </a:r>
          </a:p>
          <a:p>
            <a:r>
              <a:rPr lang="en-US" sz="2800" dirty="0"/>
              <a:t>Na: 8 </a:t>
            </a:r>
            <a:r>
              <a:rPr lang="en-US" sz="2800" dirty="0" err="1"/>
              <a:t>mEq</a:t>
            </a:r>
            <a:r>
              <a:rPr lang="en-US" sz="2800" dirty="0"/>
              <a:t>/kg (47 </a:t>
            </a:r>
            <a:r>
              <a:rPr lang="en-US" sz="2800" dirty="0" err="1"/>
              <a:t>mEq</a:t>
            </a:r>
            <a:r>
              <a:rPr lang="en-US" sz="2800" dirty="0"/>
              <a:t>)     --&gt;     Na: (47*1000)/600 = 78 </a:t>
            </a:r>
            <a:r>
              <a:rPr lang="en-US" sz="2800" dirty="0" err="1"/>
              <a:t>mEq</a:t>
            </a:r>
            <a:r>
              <a:rPr lang="en-US" sz="2800" dirty="0"/>
              <a:t>/L </a:t>
            </a:r>
            <a:endParaRPr lang="en-US" dirty="0"/>
          </a:p>
          <a:p>
            <a:r>
              <a:rPr lang="en-US" sz="2800" dirty="0"/>
              <a:t>K: 2 </a:t>
            </a:r>
            <a:r>
              <a:rPr lang="en-US" sz="2800" dirty="0" err="1"/>
              <a:t>mEq</a:t>
            </a:r>
            <a:r>
              <a:rPr lang="en-US" sz="2800" dirty="0"/>
              <a:t>/kg (12 </a:t>
            </a:r>
            <a:r>
              <a:rPr lang="en-US" sz="2800" dirty="0" err="1"/>
              <a:t>mEq</a:t>
            </a:r>
            <a:r>
              <a:rPr lang="en-US" sz="2800" dirty="0"/>
              <a:t>)     --&gt;      K: (12*1000)/600 = 20 </a:t>
            </a:r>
            <a:r>
              <a:rPr lang="en-US" sz="2800" dirty="0" err="1"/>
              <a:t>mEq</a:t>
            </a:r>
            <a:r>
              <a:rPr lang="en-US" sz="2800" dirty="0"/>
              <a:t>/L</a:t>
            </a:r>
          </a:p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0D772D-D99B-C49D-9E5F-43EFC2F0F2CB}"/>
              </a:ext>
            </a:extLst>
          </p:cNvPr>
          <p:cNvSpPr txBox="1"/>
          <p:nvPr/>
        </p:nvSpPr>
        <p:spPr>
          <a:xfrm>
            <a:off x="703225" y="2850305"/>
            <a:ext cx="11565706" cy="313932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Since no Acet in fluids, can use Cl with Na and K:</a:t>
            </a:r>
          </a:p>
          <a:p>
            <a:endParaRPr lang="en-US" dirty="0"/>
          </a:p>
          <a:p>
            <a:r>
              <a:rPr lang="en-US" dirty="0"/>
              <a:t>½ NS + 20 </a:t>
            </a:r>
            <a:r>
              <a:rPr lang="en-US" dirty="0" err="1"/>
              <a:t>mEq</a:t>
            </a:r>
            <a:r>
              <a:rPr lang="en-US" dirty="0"/>
              <a:t> </a:t>
            </a:r>
            <a:r>
              <a:rPr lang="en-US" dirty="0" err="1"/>
              <a:t>KCl</a:t>
            </a:r>
            <a:endParaRPr lang="en-US" dirty="0"/>
          </a:p>
          <a:p>
            <a:endParaRPr lang="en-US" dirty="0"/>
          </a:p>
          <a:p>
            <a:r>
              <a:rPr lang="en-US" u="sng" dirty="0"/>
              <a:t>Final:</a:t>
            </a:r>
          </a:p>
          <a:p>
            <a:endParaRPr lang="en-US" dirty="0"/>
          </a:p>
          <a:p>
            <a:r>
              <a:rPr lang="en-US" dirty="0"/>
              <a:t>D15% + ½ NS + 20 </a:t>
            </a:r>
            <a:r>
              <a:rPr lang="en-US" dirty="0" err="1"/>
              <a:t>mEq</a:t>
            </a:r>
            <a:r>
              <a:rPr lang="en-US" dirty="0"/>
              <a:t> </a:t>
            </a:r>
            <a:r>
              <a:rPr lang="en-US" dirty="0" err="1"/>
              <a:t>KCl</a:t>
            </a:r>
            <a:endParaRPr lang="en-US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4CFA9191-1EF9-A2BF-E33F-D401D29E4546}"/>
              </a:ext>
            </a:extLst>
          </p:cNvPr>
          <p:cNvSpPr/>
          <p:nvPr/>
        </p:nvSpPr>
        <p:spPr>
          <a:xfrm>
            <a:off x="9245138" y="2709461"/>
            <a:ext cx="2522177" cy="244863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5C057910-4108-11C7-8E6E-329563B5D503}"/>
              </a:ext>
            </a:extLst>
          </p:cNvPr>
          <p:cNvSpPr txBox="1"/>
          <p:nvPr/>
        </p:nvSpPr>
        <p:spPr>
          <a:xfrm>
            <a:off x="9556402" y="2850913"/>
            <a:ext cx="3086719" cy="230832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u="sng" dirty="0"/>
              <a:t>Remember:</a:t>
            </a:r>
            <a:r>
              <a:rPr lang="en-US" b="1" dirty="0"/>
              <a:t> </a:t>
            </a:r>
          </a:p>
          <a:p>
            <a:pPr>
              <a:lnSpc>
                <a:spcPct val="150000"/>
              </a:lnSpc>
            </a:pPr>
            <a:r>
              <a:rPr lang="en-US" dirty="0"/>
              <a:t>NS: 154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>
              <a:lnSpc>
                <a:spcPct val="150000"/>
              </a:lnSpc>
            </a:pPr>
            <a:r>
              <a:rPr lang="en-US" dirty="0"/>
              <a:t>¾ NS: 115.5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>
              <a:lnSpc>
                <a:spcPct val="150000"/>
              </a:lnSpc>
            </a:pPr>
            <a:r>
              <a:rPr lang="en-US" b="1" dirty="0"/>
              <a:t>½ NS: 77 </a:t>
            </a:r>
            <a:r>
              <a:rPr lang="en-US" b="1" dirty="0" err="1"/>
              <a:t>mEq</a:t>
            </a:r>
            <a:r>
              <a:rPr lang="en-US" b="1" dirty="0"/>
              <a:t>/L</a:t>
            </a:r>
          </a:p>
          <a:p>
            <a:pPr>
              <a:lnSpc>
                <a:spcPct val="150000"/>
              </a:lnSpc>
            </a:pPr>
            <a:r>
              <a:rPr lang="en-US" dirty="0"/>
              <a:t>¼ NS: 38.5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90537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05A1E-7D68-690D-B86B-A196B5717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Next Step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B7AAB6-BB61-7DFB-4D0F-445959B952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4146" y="2140635"/>
            <a:ext cx="10515600" cy="435133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Run TPN- like fluids at maintenance rate (4:2:1 rule) </a:t>
            </a:r>
          </a:p>
          <a:p>
            <a:r>
              <a:rPr lang="en-US" dirty="0"/>
              <a:t> Weight = 5.9 kg, maintenance rate: 24 ml/</a:t>
            </a:r>
            <a:r>
              <a:rPr lang="en-US" dirty="0" err="1"/>
              <a:t>hr</a:t>
            </a:r>
            <a:endParaRPr lang="en-US"/>
          </a:p>
          <a:p>
            <a:r>
              <a:rPr lang="en-US" dirty="0"/>
              <a:t>Need extra hydration? </a:t>
            </a:r>
            <a:r>
              <a:rPr lang="en-US" b="1" dirty="0"/>
              <a:t>No</a:t>
            </a:r>
          </a:p>
        </p:txBody>
      </p:sp>
      <p:pic>
        <p:nvPicPr>
          <p:cNvPr id="8" name="Picture 7" descr="A medical form with numbers and text&#10;&#10;Description automatically generated">
            <a:extLst>
              <a:ext uri="{FF2B5EF4-FFF2-40B4-BE49-F238E27FC236}">
                <a16:creationId xmlns:a16="http://schemas.microsoft.com/office/drawing/2014/main" id="{55F68537-2EEE-CDBB-2FAA-5BC16621E5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04610" y="225074"/>
            <a:ext cx="3795448" cy="4248854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7C246D0-D2E0-84EF-151E-7CD30CFA3F7E}"/>
              </a:ext>
            </a:extLst>
          </p:cNvPr>
          <p:cNvSpPr/>
          <p:nvPr/>
        </p:nvSpPr>
        <p:spPr>
          <a:xfrm>
            <a:off x="10636561" y="222957"/>
            <a:ext cx="1016904" cy="1951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8F33A21-6171-4CFB-54FF-2125A92E57E6}"/>
              </a:ext>
            </a:extLst>
          </p:cNvPr>
          <p:cNvSpPr/>
          <p:nvPr/>
        </p:nvSpPr>
        <p:spPr>
          <a:xfrm>
            <a:off x="10636313" y="706777"/>
            <a:ext cx="1016904" cy="1951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01679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00EA87-B133-5C4B-E8F1-300D18BF0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721" y="112914"/>
            <a:ext cx="10515600" cy="1325563"/>
          </a:xfrm>
        </p:spPr>
        <p:txBody>
          <a:bodyPr/>
          <a:lstStyle/>
          <a:p>
            <a:r>
              <a:rPr lang="en-US"/>
              <a:t>Now Let's Order:</a:t>
            </a:r>
          </a:p>
        </p:txBody>
      </p:sp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8AA6F4EE-6D07-A524-BDBC-871E8D75D3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722" y="1362765"/>
            <a:ext cx="6836833" cy="2051079"/>
          </a:xfrm>
          <a:prstGeom prst="rect">
            <a:avLst/>
          </a:prstGeom>
        </p:spPr>
      </p:pic>
      <p:pic>
        <p:nvPicPr>
          <p:cNvPr id="7" name="Picture 6" descr="A screenshot of a computer&#10;&#10;Description automatically generated">
            <a:extLst>
              <a:ext uri="{FF2B5EF4-FFF2-40B4-BE49-F238E27FC236}">
                <a16:creationId xmlns:a16="http://schemas.microsoft.com/office/drawing/2014/main" id="{31A597FD-5F3C-7818-24BD-FCD61E2FE9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59917" y="2641130"/>
            <a:ext cx="6836833" cy="42145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4992B6-96F9-5D9F-A0DD-0857BDE47C41}"/>
              </a:ext>
            </a:extLst>
          </p:cNvPr>
          <p:cNvSpPr txBox="1"/>
          <p:nvPr/>
        </p:nvSpPr>
        <p:spPr>
          <a:xfrm>
            <a:off x="3496027" y="4286249"/>
            <a:ext cx="1220611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2400" dirty="0">
                <a:solidFill>
                  <a:srgbClr val="FF0000"/>
                </a:solidFill>
              </a:rPr>
              <a:t>OR</a:t>
            </a:r>
          </a:p>
        </p:txBody>
      </p:sp>
      <p:sp>
        <p:nvSpPr>
          <p:cNvPr id="10" name="Flowchart: Process 9">
            <a:extLst>
              <a:ext uri="{FF2B5EF4-FFF2-40B4-BE49-F238E27FC236}">
                <a16:creationId xmlns:a16="http://schemas.microsoft.com/office/drawing/2014/main" id="{C6DD160C-5935-6FBB-69FC-78A30C4570CD}"/>
              </a:ext>
            </a:extLst>
          </p:cNvPr>
          <p:cNvSpPr/>
          <p:nvPr/>
        </p:nvSpPr>
        <p:spPr>
          <a:xfrm>
            <a:off x="218326" y="1441619"/>
            <a:ext cx="2081921" cy="194936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1" name="Flowchart: Process 10">
            <a:extLst>
              <a:ext uri="{FF2B5EF4-FFF2-40B4-BE49-F238E27FC236}">
                <a16:creationId xmlns:a16="http://schemas.microsoft.com/office/drawing/2014/main" id="{C6DD160C-5935-6FBB-69FC-78A30C4570CD}"/>
              </a:ext>
            </a:extLst>
          </p:cNvPr>
          <p:cNvSpPr/>
          <p:nvPr/>
        </p:nvSpPr>
        <p:spPr>
          <a:xfrm>
            <a:off x="295937" y="2810397"/>
            <a:ext cx="1877310" cy="22315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C6DD160C-5935-6FBB-69FC-78A30C4570CD}"/>
              </a:ext>
            </a:extLst>
          </p:cNvPr>
          <p:cNvSpPr/>
          <p:nvPr/>
        </p:nvSpPr>
        <p:spPr>
          <a:xfrm>
            <a:off x="5263048" y="2725730"/>
            <a:ext cx="2074867" cy="194936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3" name="Flowchart: Process 12">
            <a:extLst>
              <a:ext uri="{FF2B5EF4-FFF2-40B4-BE49-F238E27FC236}">
                <a16:creationId xmlns:a16="http://schemas.microsoft.com/office/drawing/2014/main" id="{C6DD160C-5935-6FBB-69FC-78A30C4570CD}"/>
              </a:ext>
            </a:extLst>
          </p:cNvPr>
          <p:cNvSpPr/>
          <p:nvPr/>
        </p:nvSpPr>
        <p:spPr>
          <a:xfrm>
            <a:off x="5263049" y="5188119"/>
            <a:ext cx="1933754" cy="20904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6002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BE17F-3388-CD35-D6F3-A1EE66522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nd TPN Sheets on Cerner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5101AF-09D4-186B-7884-F5FA6CC500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pPr marL="0" indent="0">
              <a:buNone/>
            </a:pPr>
            <a:endParaRPr lang="en-US"/>
          </a:p>
          <a:p>
            <a:endParaRPr lang="en-US"/>
          </a:p>
        </p:txBody>
      </p:sp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78F32EBD-FC30-0B78-5EC2-3AC77BB2C1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2958" y="1824079"/>
            <a:ext cx="9380923" cy="4362449"/>
          </a:xfrm>
          <a:prstGeom prst="rect">
            <a:avLst/>
          </a:prstGeom>
        </p:spPr>
      </p:pic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C3283941-314B-E5AE-FFFD-61566629F0CD}"/>
              </a:ext>
            </a:extLst>
          </p:cNvPr>
          <p:cNvSpPr/>
          <p:nvPr/>
        </p:nvSpPr>
        <p:spPr>
          <a:xfrm>
            <a:off x="1063308" y="3360544"/>
            <a:ext cx="2591729" cy="340290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FD96D3BB-86B3-AE7F-C26B-7FEFA0B328FE}"/>
              </a:ext>
            </a:extLst>
          </p:cNvPr>
          <p:cNvSpPr/>
          <p:nvPr/>
        </p:nvSpPr>
        <p:spPr>
          <a:xfrm>
            <a:off x="4010158" y="3873039"/>
            <a:ext cx="1317236" cy="21216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6692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C4F4D9DA-102C-7B31-F3F2-EF5B07F111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43" y="1059"/>
            <a:ext cx="9045222" cy="3716162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95D6F78D-C771-AB16-76C3-8685F1DD27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9943" y="1304261"/>
            <a:ext cx="7013223" cy="2415034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25809557-1AA2-1F3F-4683-C25C554C2E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41362" y="3874580"/>
            <a:ext cx="8840609" cy="2989396"/>
          </a:xfrm>
          <a:prstGeom prst="rect">
            <a:avLst/>
          </a:prstGeom>
        </p:spPr>
      </p:pic>
      <p:sp>
        <p:nvSpPr>
          <p:cNvPr id="8" name="Flowchart: Process 7">
            <a:extLst>
              <a:ext uri="{FF2B5EF4-FFF2-40B4-BE49-F238E27FC236}">
                <a16:creationId xmlns:a16="http://schemas.microsoft.com/office/drawing/2014/main" id="{E3D3F812-6604-6BF9-4666-3481E21BF8FE}"/>
              </a:ext>
            </a:extLst>
          </p:cNvPr>
          <p:cNvSpPr/>
          <p:nvPr/>
        </p:nvSpPr>
        <p:spPr>
          <a:xfrm>
            <a:off x="1834047" y="2598729"/>
            <a:ext cx="1348144" cy="152603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" name="Flowchart: Process 9">
            <a:extLst>
              <a:ext uri="{FF2B5EF4-FFF2-40B4-BE49-F238E27FC236}">
                <a16:creationId xmlns:a16="http://schemas.microsoft.com/office/drawing/2014/main" id="{CFBAFAD5-D99E-1517-C5DB-FAB3022ACDCA}"/>
              </a:ext>
            </a:extLst>
          </p:cNvPr>
          <p:cNvSpPr/>
          <p:nvPr/>
        </p:nvSpPr>
        <p:spPr>
          <a:xfrm>
            <a:off x="7090437" y="2514063"/>
            <a:ext cx="1235255" cy="159659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04B0F0CD-0811-4281-E88D-E5890E838C61}"/>
              </a:ext>
            </a:extLst>
          </p:cNvPr>
          <p:cNvSpPr/>
          <p:nvPr/>
        </p:nvSpPr>
        <p:spPr>
          <a:xfrm>
            <a:off x="8494493" y="2492897"/>
            <a:ext cx="1461033" cy="180825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3" name="Flowchart: Process 12">
            <a:extLst>
              <a:ext uri="{FF2B5EF4-FFF2-40B4-BE49-F238E27FC236}">
                <a16:creationId xmlns:a16="http://schemas.microsoft.com/office/drawing/2014/main" id="{FE9FDF70-09B5-F4A7-8827-ED2DFB45D6C2}"/>
              </a:ext>
            </a:extLst>
          </p:cNvPr>
          <p:cNvSpPr/>
          <p:nvPr/>
        </p:nvSpPr>
        <p:spPr>
          <a:xfrm>
            <a:off x="4550437" y="5378620"/>
            <a:ext cx="4438476" cy="194935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61280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9050E2-8D86-1CE2-1DAE-D1D3F0541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5735" y="-112466"/>
            <a:ext cx="10515600" cy="1325563"/>
          </a:xfrm>
        </p:spPr>
        <p:txBody>
          <a:bodyPr/>
          <a:lstStyle/>
          <a:p>
            <a:r>
              <a:rPr lang="en-US" dirty="0"/>
              <a:t>2- Calculate TPN-Like Fluid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C8D225-CFB3-835A-E034-CE62DC5DCF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769734" y="1814893"/>
            <a:ext cx="6007995" cy="4850394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>
              <a:buNone/>
            </a:pPr>
            <a:r>
              <a:rPr lang="en-US" b="1" u="sng" dirty="0"/>
              <a:t>Need:</a:t>
            </a:r>
          </a:p>
          <a:p>
            <a:pPr marL="0" indent="0">
              <a:buNone/>
            </a:pPr>
            <a:endParaRPr lang="en-US"/>
          </a:p>
          <a:p>
            <a:r>
              <a:rPr lang="en-US" dirty="0"/>
              <a:t>Weight </a:t>
            </a:r>
          </a:p>
          <a:p>
            <a:r>
              <a:rPr lang="en-US" dirty="0"/>
              <a:t>Dextrose conc.</a:t>
            </a:r>
          </a:p>
          <a:p>
            <a:r>
              <a:rPr lang="en-US" dirty="0"/>
              <a:t>For </a:t>
            </a:r>
            <a:r>
              <a:rPr lang="en-US" err="1"/>
              <a:t>lytes</a:t>
            </a:r>
            <a:r>
              <a:rPr lang="en-US"/>
              <a:t>, focus on Na, K, Acet </a:t>
            </a:r>
          </a:p>
          <a:p>
            <a:r>
              <a:rPr lang="en-US" dirty="0"/>
              <a:t>Total TPN volume</a:t>
            </a:r>
          </a:p>
          <a:p>
            <a:r>
              <a:rPr lang="en-US" dirty="0"/>
              <a:t>Maintenance fluid rate (based on </a:t>
            </a:r>
            <a:r>
              <a:rPr lang="en-US" dirty="0" err="1"/>
              <a:t>wt</a:t>
            </a:r>
            <a:r>
              <a:rPr lang="en-US" dirty="0"/>
              <a:t>)</a:t>
            </a:r>
          </a:p>
          <a:p>
            <a:r>
              <a:rPr lang="en-US" dirty="0"/>
              <a:t>Extra hydration or not?</a:t>
            </a:r>
          </a:p>
        </p:txBody>
      </p:sp>
      <p:pic>
        <p:nvPicPr>
          <p:cNvPr id="5" name="Picture 4" descr="A close-up of a medical form&#10;&#10;Description automatically generated">
            <a:extLst>
              <a:ext uri="{FF2B5EF4-FFF2-40B4-BE49-F238E27FC236}">
                <a16:creationId xmlns:a16="http://schemas.microsoft.com/office/drawing/2014/main" id="{BA7AEFEF-2778-5D37-4B86-BFBA360D73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271" y="1060901"/>
            <a:ext cx="5260196" cy="561057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9AB9A91-6868-9208-0C3C-E2B77CD802B3}"/>
              </a:ext>
            </a:extLst>
          </p:cNvPr>
          <p:cNvSpPr/>
          <p:nvPr/>
        </p:nvSpPr>
        <p:spPr>
          <a:xfrm>
            <a:off x="3552969" y="1785995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7A73E15-61A5-E4B3-0F7A-EF3D7FBF84C6}"/>
              </a:ext>
            </a:extLst>
          </p:cNvPr>
          <p:cNvSpPr/>
          <p:nvPr/>
        </p:nvSpPr>
        <p:spPr>
          <a:xfrm>
            <a:off x="3552536" y="1508335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9D5FEC9-A227-5FDD-332A-0C29A3C4D3D7}"/>
              </a:ext>
            </a:extLst>
          </p:cNvPr>
          <p:cNvSpPr/>
          <p:nvPr/>
        </p:nvSpPr>
        <p:spPr>
          <a:xfrm>
            <a:off x="3552536" y="1109605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AF3D8C70-3150-27C0-2D43-04BB4B781995}"/>
              </a:ext>
            </a:extLst>
          </p:cNvPr>
          <p:cNvSpPr/>
          <p:nvPr/>
        </p:nvSpPr>
        <p:spPr>
          <a:xfrm>
            <a:off x="631420" y="3197138"/>
            <a:ext cx="1304062" cy="300143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lowchart: Process 13">
            <a:extLst>
              <a:ext uri="{FF2B5EF4-FFF2-40B4-BE49-F238E27FC236}">
                <a16:creationId xmlns:a16="http://schemas.microsoft.com/office/drawing/2014/main" id="{30DDA2BD-58CC-3571-0D62-CB72B2E12291}"/>
              </a:ext>
            </a:extLst>
          </p:cNvPr>
          <p:cNvSpPr/>
          <p:nvPr/>
        </p:nvSpPr>
        <p:spPr>
          <a:xfrm>
            <a:off x="631420" y="3796676"/>
            <a:ext cx="1304062" cy="235520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lowchart: Process 15">
            <a:extLst>
              <a:ext uri="{FF2B5EF4-FFF2-40B4-BE49-F238E27FC236}">
                <a16:creationId xmlns:a16="http://schemas.microsoft.com/office/drawing/2014/main" id="{4ABC1E52-6A91-D66B-231E-2CAA638C3A65}"/>
              </a:ext>
            </a:extLst>
          </p:cNvPr>
          <p:cNvSpPr/>
          <p:nvPr/>
        </p:nvSpPr>
        <p:spPr>
          <a:xfrm>
            <a:off x="631732" y="2409727"/>
            <a:ext cx="1816246" cy="556079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lowchart: Process 17">
            <a:extLst>
              <a:ext uri="{FF2B5EF4-FFF2-40B4-BE49-F238E27FC236}">
                <a16:creationId xmlns:a16="http://schemas.microsoft.com/office/drawing/2014/main" id="{A1D21C41-5547-97D6-4988-D99D75AFBB3A}"/>
              </a:ext>
            </a:extLst>
          </p:cNvPr>
          <p:cNvSpPr/>
          <p:nvPr/>
        </p:nvSpPr>
        <p:spPr>
          <a:xfrm>
            <a:off x="638475" y="6024169"/>
            <a:ext cx="4297802" cy="17845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Process 19">
            <a:extLst>
              <a:ext uri="{FF2B5EF4-FFF2-40B4-BE49-F238E27FC236}">
                <a16:creationId xmlns:a16="http://schemas.microsoft.com/office/drawing/2014/main" id="{B650BEB8-BEA3-49C3-2C18-960CB9661CA0}"/>
              </a:ext>
            </a:extLst>
          </p:cNvPr>
          <p:cNvSpPr/>
          <p:nvPr/>
        </p:nvSpPr>
        <p:spPr>
          <a:xfrm>
            <a:off x="3996670" y="5134047"/>
            <a:ext cx="1411645" cy="27960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FCA5C757-B61D-A4B2-07BE-B36196757BBE}"/>
              </a:ext>
            </a:extLst>
          </p:cNvPr>
          <p:cNvSpPr/>
          <p:nvPr/>
        </p:nvSpPr>
        <p:spPr>
          <a:xfrm>
            <a:off x="1607641" y="1618188"/>
            <a:ext cx="836052" cy="53938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30126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AE76A-E90F-16DD-E8F0-6521F5FFBD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5359" y="589243"/>
            <a:ext cx="5085550" cy="1338369"/>
          </a:xfrm>
        </p:spPr>
        <p:txBody>
          <a:bodyPr/>
          <a:lstStyle/>
          <a:p>
            <a:r>
              <a:rPr lang="en-US"/>
              <a:t>Total TPN: 857 ml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154E4A-504B-F285-191C-FC2B0F11F3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519057" y="2350700"/>
            <a:ext cx="6475079" cy="3346011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Weight: 35.5kg</a:t>
            </a:r>
          </a:p>
          <a:p>
            <a:r>
              <a:rPr lang="en-US" dirty="0"/>
              <a:t>D15%</a:t>
            </a:r>
          </a:p>
          <a:p>
            <a:r>
              <a:rPr lang="en-US" dirty="0"/>
              <a:t>Na: 2.3mEq/kg (82mEq), K: 3.5 </a:t>
            </a:r>
            <a:r>
              <a:rPr lang="en-US" dirty="0" err="1"/>
              <a:t>mEq</a:t>
            </a:r>
            <a:r>
              <a:rPr lang="en-US" dirty="0"/>
              <a:t>/kg (124mEq), Acet: 2.1 </a:t>
            </a:r>
            <a:r>
              <a:rPr lang="en-US" dirty="0" err="1"/>
              <a:t>mEq</a:t>
            </a:r>
            <a:r>
              <a:rPr lang="en-US" dirty="0"/>
              <a:t>/kg (75mEq)</a:t>
            </a:r>
          </a:p>
          <a:p>
            <a:r>
              <a:rPr lang="en-US" b="1" dirty="0"/>
              <a:t>Need to convert </a:t>
            </a:r>
            <a:r>
              <a:rPr lang="en-US" b="1" err="1"/>
              <a:t>lytes</a:t>
            </a:r>
            <a:r>
              <a:rPr lang="en-US" b="1" dirty="0"/>
              <a:t> from 857ml to 1000ml (1L) bag</a:t>
            </a:r>
          </a:p>
        </p:txBody>
      </p:sp>
      <p:pic>
        <p:nvPicPr>
          <p:cNvPr id="7" name="Picture 6" descr="A close-up of a medical form&#10;&#10;Description automatically generated">
            <a:extLst>
              <a:ext uri="{FF2B5EF4-FFF2-40B4-BE49-F238E27FC236}">
                <a16:creationId xmlns:a16="http://schemas.microsoft.com/office/drawing/2014/main" id="{1EAC6257-F9E8-3BF4-F995-1D9310AA40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287" y="759944"/>
            <a:ext cx="5100112" cy="548890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B453B78-8D0F-35EB-2A95-E41CE867A315}"/>
              </a:ext>
            </a:extLst>
          </p:cNvPr>
          <p:cNvSpPr/>
          <p:nvPr/>
        </p:nvSpPr>
        <p:spPr>
          <a:xfrm>
            <a:off x="3478944" y="876494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154C069-3066-A58E-282A-AA608DBD0C9A}"/>
              </a:ext>
            </a:extLst>
          </p:cNvPr>
          <p:cNvSpPr/>
          <p:nvPr/>
        </p:nvSpPr>
        <p:spPr>
          <a:xfrm>
            <a:off x="3478359" y="1255345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3D74C53-AD22-CFA3-C6B1-BAA310FD1C03}"/>
              </a:ext>
            </a:extLst>
          </p:cNvPr>
          <p:cNvSpPr/>
          <p:nvPr/>
        </p:nvSpPr>
        <p:spPr>
          <a:xfrm>
            <a:off x="3478359" y="1513858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135755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CDAA9-25AE-B069-7EC7-77A005C3B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2065" y="-202168"/>
            <a:ext cx="10515600" cy="1325563"/>
          </a:xfrm>
        </p:spPr>
        <p:txBody>
          <a:bodyPr/>
          <a:lstStyle/>
          <a:p>
            <a:r>
              <a:rPr lang="en-US"/>
              <a:t>Convert to 1000 ml (1L): 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D1BCFB39-CF04-FACC-1188-03C1357FB1F6}"/>
              </a:ext>
            </a:extLst>
          </p:cNvPr>
          <p:cNvSpPr txBox="1">
            <a:spLocks/>
          </p:cNvSpPr>
          <p:nvPr/>
        </p:nvSpPr>
        <p:spPr>
          <a:xfrm>
            <a:off x="585281" y="863274"/>
            <a:ext cx="10778137" cy="1886158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/>
              <a:t>   </a:t>
            </a:r>
            <a:r>
              <a:rPr lang="en-US" sz="2800" b="1" dirty="0"/>
              <a:t>857 ml</a:t>
            </a:r>
            <a:r>
              <a:rPr lang="en-US" sz="2800" dirty="0"/>
              <a:t> bag                                             </a:t>
            </a:r>
            <a:r>
              <a:rPr lang="en-US" sz="2800" b="1" dirty="0"/>
              <a:t>1000 ml</a:t>
            </a:r>
            <a:r>
              <a:rPr lang="en-US" sz="2800" dirty="0"/>
              <a:t> bag          </a:t>
            </a:r>
          </a:p>
          <a:p>
            <a:r>
              <a:rPr lang="en-US" sz="2800" dirty="0"/>
              <a:t>Na: 2.3 </a:t>
            </a:r>
            <a:r>
              <a:rPr lang="en-US" sz="2800" dirty="0" err="1"/>
              <a:t>mEq</a:t>
            </a:r>
            <a:r>
              <a:rPr lang="en-US" sz="2800" dirty="0"/>
              <a:t>/kg (82 </a:t>
            </a:r>
            <a:r>
              <a:rPr lang="en-US" sz="2800" dirty="0" err="1"/>
              <a:t>mEq</a:t>
            </a:r>
            <a:r>
              <a:rPr lang="en-US" sz="2800" dirty="0"/>
              <a:t>)     --&gt;     Na: (82*1000)/857 = 96 </a:t>
            </a:r>
            <a:r>
              <a:rPr lang="en-US" sz="2800" dirty="0" err="1"/>
              <a:t>mEq</a:t>
            </a:r>
            <a:r>
              <a:rPr lang="en-US" sz="2800" dirty="0"/>
              <a:t>/L </a:t>
            </a:r>
            <a:endParaRPr lang="en-US" dirty="0"/>
          </a:p>
          <a:p>
            <a:r>
              <a:rPr lang="en-US" sz="2800" dirty="0"/>
              <a:t>K: 3.5 </a:t>
            </a:r>
            <a:r>
              <a:rPr lang="en-US" sz="2800" dirty="0" err="1"/>
              <a:t>mEq</a:t>
            </a:r>
            <a:r>
              <a:rPr lang="en-US" sz="2800" dirty="0"/>
              <a:t>/kg (124 </a:t>
            </a:r>
            <a:r>
              <a:rPr lang="en-US" sz="2800" dirty="0" err="1"/>
              <a:t>mEq</a:t>
            </a:r>
            <a:r>
              <a:rPr lang="en-US" sz="2800" dirty="0"/>
              <a:t>)     --&gt;      K: (124*1000)/857 = 145 </a:t>
            </a:r>
            <a:r>
              <a:rPr lang="en-US" sz="2800" dirty="0" err="1"/>
              <a:t>mEq</a:t>
            </a:r>
            <a:r>
              <a:rPr lang="en-US" sz="2800" dirty="0"/>
              <a:t>/L</a:t>
            </a:r>
          </a:p>
          <a:p>
            <a:r>
              <a:rPr lang="en-US" sz="2800" dirty="0"/>
              <a:t>Acet: 2.1 </a:t>
            </a:r>
            <a:r>
              <a:rPr lang="en-US" sz="2800" dirty="0" err="1"/>
              <a:t>mEq</a:t>
            </a:r>
            <a:r>
              <a:rPr lang="en-US" sz="2800" dirty="0"/>
              <a:t>/kg (75 </a:t>
            </a:r>
            <a:r>
              <a:rPr lang="en-US" sz="2800" dirty="0" err="1"/>
              <a:t>mEq</a:t>
            </a:r>
            <a:r>
              <a:rPr lang="en-US" sz="2800" dirty="0"/>
              <a:t>)  --&gt;     Acet: (75*1000)/857 = 88 </a:t>
            </a:r>
            <a:r>
              <a:rPr lang="en-US" sz="2800" dirty="0" err="1"/>
              <a:t>mEq</a:t>
            </a:r>
            <a:r>
              <a:rPr lang="en-US" sz="2800" dirty="0"/>
              <a:t>/L</a:t>
            </a:r>
          </a:p>
          <a:p>
            <a:endParaRPr lang="en-US" sz="2800"/>
          </a:p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0D772D-D99B-C49D-9E5F-43EFC2F0F2CB}"/>
              </a:ext>
            </a:extLst>
          </p:cNvPr>
          <p:cNvSpPr txBox="1"/>
          <p:nvPr/>
        </p:nvSpPr>
        <p:spPr>
          <a:xfrm>
            <a:off x="392781" y="2829138"/>
            <a:ext cx="11565706" cy="452431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Can use Acet or Cl with Na and K </a:t>
            </a:r>
          </a:p>
          <a:p>
            <a:r>
              <a:rPr lang="en-US" dirty="0"/>
              <a:t>Start with Acet, need 88 </a:t>
            </a:r>
            <a:r>
              <a:rPr lang="en-US" dirty="0" err="1"/>
              <a:t>mEq</a:t>
            </a:r>
            <a:r>
              <a:rPr lang="en-US" dirty="0"/>
              <a:t>/L, can combine it with K for example so 57 </a:t>
            </a:r>
            <a:r>
              <a:rPr lang="en-US" dirty="0" err="1"/>
              <a:t>mEq</a:t>
            </a:r>
            <a:r>
              <a:rPr lang="en-US" dirty="0"/>
              <a:t>/L of K left (145-88 = 57) which can combine with Cl</a:t>
            </a:r>
          </a:p>
          <a:p>
            <a:r>
              <a:rPr lang="en-US" dirty="0"/>
              <a:t>For Na, combine it with Cl</a:t>
            </a:r>
          </a:p>
          <a:p>
            <a:endParaRPr lang="en-US"/>
          </a:p>
          <a:p>
            <a:r>
              <a:rPr lang="en-US" dirty="0"/>
              <a:t>96 </a:t>
            </a:r>
            <a:r>
              <a:rPr lang="en-US" dirty="0" err="1"/>
              <a:t>mEq</a:t>
            </a:r>
            <a:r>
              <a:rPr lang="en-US" dirty="0"/>
              <a:t>/L NaCl  + 88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KAcet</a:t>
            </a:r>
            <a:r>
              <a:rPr lang="en-US" dirty="0"/>
              <a:t> + 57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KCl</a:t>
            </a:r>
            <a:r>
              <a:rPr lang="en-US" dirty="0"/>
              <a:t> </a:t>
            </a:r>
          </a:p>
          <a:p>
            <a:endParaRPr lang="en-US"/>
          </a:p>
          <a:p>
            <a:r>
              <a:rPr lang="en-US" b="1" dirty="0"/>
              <a:t>OR</a:t>
            </a:r>
            <a:r>
              <a:rPr lang="en-US" dirty="0"/>
              <a:t> could have started with Acet and Na, so 8 </a:t>
            </a:r>
            <a:r>
              <a:rPr lang="en-US" dirty="0" err="1"/>
              <a:t>mEq</a:t>
            </a:r>
            <a:r>
              <a:rPr lang="en-US" dirty="0"/>
              <a:t>/L of Na left (96-88 = 8)</a:t>
            </a:r>
          </a:p>
          <a:p>
            <a:endParaRPr lang="en-US"/>
          </a:p>
          <a:p>
            <a:r>
              <a:rPr lang="en-US" dirty="0"/>
              <a:t>88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NaAcet</a:t>
            </a:r>
            <a:r>
              <a:rPr lang="en-US" dirty="0"/>
              <a:t> + 8 </a:t>
            </a:r>
            <a:r>
              <a:rPr lang="en-US" dirty="0" err="1"/>
              <a:t>mEq</a:t>
            </a:r>
            <a:r>
              <a:rPr lang="en-US" dirty="0"/>
              <a:t>/L NaCl + 145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KCl</a:t>
            </a:r>
            <a:r>
              <a:rPr lang="en-US" dirty="0"/>
              <a:t> </a:t>
            </a:r>
          </a:p>
          <a:p>
            <a:endParaRPr lang="en-US" dirty="0"/>
          </a:p>
          <a:p>
            <a:r>
              <a:rPr lang="en-US" b="1" dirty="0"/>
              <a:t>OR</a:t>
            </a:r>
            <a:r>
              <a:rPr lang="en-US" dirty="0"/>
              <a:t> could have separated Acet with both K and Na</a:t>
            </a:r>
          </a:p>
          <a:p>
            <a:endParaRPr lang="en-US" dirty="0"/>
          </a:p>
          <a:p>
            <a:r>
              <a:rPr lang="en-US" dirty="0"/>
              <a:t>16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NaAcet</a:t>
            </a:r>
            <a:r>
              <a:rPr lang="en-US" dirty="0"/>
              <a:t> + 80 </a:t>
            </a:r>
            <a:r>
              <a:rPr lang="en-US" dirty="0" err="1"/>
              <a:t>mEq</a:t>
            </a:r>
            <a:r>
              <a:rPr lang="en-US" dirty="0"/>
              <a:t>/L NaCl + 72 </a:t>
            </a:r>
            <a:r>
              <a:rPr lang="en-US" dirty="0" err="1"/>
              <a:t>mEq</a:t>
            </a:r>
            <a:r>
              <a:rPr lang="en-US" dirty="0"/>
              <a:t>/L </a:t>
            </a:r>
            <a:r>
              <a:rPr lang="en-US" dirty="0" err="1"/>
              <a:t>KAcet</a:t>
            </a:r>
            <a:r>
              <a:rPr lang="en-US" dirty="0"/>
              <a:t> +73 </a:t>
            </a:r>
            <a:r>
              <a:rPr lang="en-US" dirty="0" err="1"/>
              <a:t>mEq</a:t>
            </a:r>
            <a:r>
              <a:rPr lang="en-US" dirty="0"/>
              <a:t>/L KCl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482883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8BC3AB-8ABB-9334-4030-19543AF9FA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1544" y="381640"/>
            <a:ext cx="11672454" cy="6335528"/>
          </a:xfr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1) 96 </a:t>
            </a:r>
            <a:r>
              <a:rPr lang="en-US" sz="1800" dirty="0" err="1"/>
              <a:t>mEq</a:t>
            </a:r>
            <a:r>
              <a:rPr lang="en-US" sz="1800" dirty="0"/>
              <a:t>/L NaCl  + 88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Acet</a:t>
            </a:r>
            <a:r>
              <a:rPr lang="en-US" sz="1800" dirty="0"/>
              <a:t> + 57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r>
              <a:rPr lang="en-US" sz="1800" dirty="0"/>
              <a:t>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b="1" dirty="0"/>
              <a:t>OR</a:t>
            </a:r>
            <a:r>
              <a:rPr lang="en-US" sz="1800" dirty="0"/>
              <a:t> could have started with Acet and Na, so 8 </a:t>
            </a:r>
            <a:r>
              <a:rPr lang="en-US" sz="1800" dirty="0" err="1"/>
              <a:t>mEq</a:t>
            </a:r>
            <a:r>
              <a:rPr lang="en-US" sz="1800" dirty="0"/>
              <a:t>/L of Na left (96-88 = 8)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2) 88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NaAcet</a:t>
            </a:r>
            <a:r>
              <a:rPr lang="en-US" sz="1800" dirty="0"/>
              <a:t> + 8 </a:t>
            </a:r>
            <a:r>
              <a:rPr lang="en-US" sz="1800" dirty="0" err="1"/>
              <a:t>mEq</a:t>
            </a:r>
            <a:r>
              <a:rPr lang="en-US" sz="1800" dirty="0"/>
              <a:t>/L NaCl + 145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r>
              <a:rPr lang="en-US" sz="1800" dirty="0"/>
              <a:t> 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900" b="1" dirty="0"/>
              <a:t>OR</a:t>
            </a:r>
            <a:r>
              <a:rPr lang="en-US" sz="1900" dirty="0"/>
              <a:t> could have separated Acet with both K and Na</a:t>
            </a:r>
            <a:endParaRPr lang="en-US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3) 16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NaAcet</a:t>
            </a:r>
            <a:r>
              <a:rPr lang="en-US" sz="1800" dirty="0"/>
              <a:t> + 80 </a:t>
            </a:r>
            <a:r>
              <a:rPr lang="en-US" sz="1800" dirty="0" err="1"/>
              <a:t>mEq</a:t>
            </a:r>
            <a:r>
              <a:rPr lang="en-US" sz="1800" dirty="0"/>
              <a:t>/L NaCl + 72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Acet</a:t>
            </a:r>
            <a:r>
              <a:rPr lang="en-US" sz="1800" dirty="0"/>
              <a:t> +73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endParaRPr lang="en-US" dirty="0" err="1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b="1" u="sng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b="1" u="sng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b="1" dirty="0"/>
              <a:t>                                                 </a:t>
            </a:r>
            <a:r>
              <a:rPr lang="en-US" sz="1800" b="1" u="sng" dirty="0"/>
              <a:t>Final:</a:t>
            </a:r>
            <a:endParaRPr lang="en-US" sz="1800" u="sng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1) D15% + ¾ NS + 88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Acet</a:t>
            </a:r>
            <a:r>
              <a:rPr lang="en-US" sz="1800" dirty="0"/>
              <a:t> + 57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r>
              <a:rPr lang="en-US" sz="1800" dirty="0"/>
              <a:t> </a:t>
            </a:r>
            <a:endParaRPr lang="en-US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b="1" dirty="0"/>
              <a:t>OR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2) D15% + 88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NaAcet</a:t>
            </a:r>
            <a:r>
              <a:rPr lang="en-US" sz="1800" dirty="0"/>
              <a:t> + 8 </a:t>
            </a:r>
            <a:r>
              <a:rPr lang="en-US" sz="1800" dirty="0" err="1"/>
              <a:t>mEq</a:t>
            </a:r>
            <a:r>
              <a:rPr lang="en-US" sz="1800" dirty="0"/>
              <a:t>/L NaCl + 145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r>
              <a:rPr lang="en-US" sz="1800" dirty="0"/>
              <a:t> 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b="1" dirty="0"/>
              <a:t>OR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3) D15% + 16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NaAcet</a:t>
            </a:r>
            <a:r>
              <a:rPr lang="en-US" sz="1800" dirty="0"/>
              <a:t> + ½ NS + 72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Acet</a:t>
            </a:r>
            <a:r>
              <a:rPr lang="en-US" sz="1800" dirty="0"/>
              <a:t> + 73 </a:t>
            </a:r>
            <a:r>
              <a:rPr lang="en-US" sz="1800" dirty="0" err="1"/>
              <a:t>mEq</a:t>
            </a:r>
            <a:r>
              <a:rPr lang="en-US" sz="1800" dirty="0"/>
              <a:t>/L </a:t>
            </a:r>
            <a:r>
              <a:rPr lang="en-US" sz="1800" dirty="0" err="1"/>
              <a:t>KCl</a:t>
            </a:r>
            <a:r>
              <a:rPr lang="en-US" sz="1800" dirty="0"/>
              <a:t>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/>
          </a:p>
        </p:txBody>
      </p:sp>
      <p:sp>
        <p:nvSpPr>
          <p:cNvPr id="4" name="TextBox 5">
            <a:extLst>
              <a:ext uri="{FF2B5EF4-FFF2-40B4-BE49-F238E27FC236}">
                <a16:creationId xmlns:a16="http://schemas.microsoft.com/office/drawing/2014/main" id="{B91A50B9-F3FA-EFE6-8ED6-40E75CF0009A}"/>
              </a:ext>
            </a:extLst>
          </p:cNvPr>
          <p:cNvSpPr txBox="1"/>
          <p:nvPr/>
        </p:nvSpPr>
        <p:spPr>
          <a:xfrm>
            <a:off x="8314624" y="2476969"/>
            <a:ext cx="3086719" cy="230832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u="sng" dirty="0"/>
              <a:t>Remember:</a:t>
            </a:r>
            <a:r>
              <a:rPr lang="en-US" b="1" dirty="0"/>
              <a:t> </a:t>
            </a:r>
          </a:p>
          <a:p>
            <a:pPr>
              <a:lnSpc>
                <a:spcPct val="150000"/>
              </a:lnSpc>
            </a:pPr>
            <a:r>
              <a:rPr lang="en-US" dirty="0"/>
              <a:t>NS: 154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>
              <a:lnSpc>
                <a:spcPct val="150000"/>
              </a:lnSpc>
            </a:pPr>
            <a:r>
              <a:rPr lang="en-US" b="1" dirty="0"/>
              <a:t>¾ NS: 115.5 </a:t>
            </a:r>
            <a:r>
              <a:rPr lang="en-US" b="1" dirty="0" err="1"/>
              <a:t>mEq</a:t>
            </a:r>
            <a:r>
              <a:rPr lang="en-US" b="1" dirty="0"/>
              <a:t>/L</a:t>
            </a:r>
          </a:p>
          <a:p>
            <a:pPr>
              <a:lnSpc>
                <a:spcPct val="150000"/>
              </a:lnSpc>
            </a:pPr>
            <a:r>
              <a:rPr lang="en-US" b="1" dirty="0"/>
              <a:t>½ NS: 77 </a:t>
            </a:r>
            <a:r>
              <a:rPr lang="en-US" b="1" dirty="0" err="1"/>
              <a:t>mEq</a:t>
            </a:r>
            <a:r>
              <a:rPr lang="en-US" b="1" dirty="0"/>
              <a:t>/L</a:t>
            </a:r>
          </a:p>
          <a:p>
            <a:pPr>
              <a:lnSpc>
                <a:spcPct val="150000"/>
              </a:lnSpc>
            </a:pPr>
            <a:r>
              <a:rPr lang="en-US" dirty="0"/>
              <a:t>¼ NS: 38.5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endParaRPr lang="en-US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C415C56E-5949-157B-9D64-F3640484FC20}"/>
              </a:ext>
            </a:extLst>
          </p:cNvPr>
          <p:cNvSpPr/>
          <p:nvPr/>
        </p:nvSpPr>
        <p:spPr>
          <a:xfrm>
            <a:off x="8024527" y="2208517"/>
            <a:ext cx="2522177" cy="244863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8619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05A1E-7D68-690D-B86B-A196B5717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Next Step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B7AAB6-BB61-7DFB-4D0F-445959B952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96368" y="1780801"/>
            <a:ext cx="10515600" cy="435133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Run TPN- like fluids at maintenance rate (4:2:1 rule) </a:t>
            </a:r>
          </a:p>
          <a:p>
            <a:r>
              <a:rPr lang="en-US" dirty="0"/>
              <a:t> Weight = 35.5kg, maintenance rate: 76 ml/</a:t>
            </a:r>
            <a:r>
              <a:rPr lang="en-US" dirty="0" err="1"/>
              <a:t>hr</a:t>
            </a:r>
            <a:endParaRPr lang="en-US" dirty="0"/>
          </a:p>
          <a:p>
            <a:r>
              <a:rPr lang="en-US" dirty="0"/>
              <a:t>Need extra hydration? Yes</a:t>
            </a:r>
          </a:p>
        </p:txBody>
      </p:sp>
      <p:pic>
        <p:nvPicPr>
          <p:cNvPr id="6" name="Picture 5" descr="A close-up of a medical form&#10;&#10;Description automatically generated">
            <a:extLst>
              <a:ext uri="{FF2B5EF4-FFF2-40B4-BE49-F238E27FC236}">
                <a16:creationId xmlns:a16="http://schemas.microsoft.com/office/drawing/2014/main" id="{1317407D-2086-93D9-DF86-CB31910119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75387" y="-2056"/>
            <a:ext cx="3313575" cy="3567900"/>
          </a:xfrm>
          <a:prstGeom prst="rect">
            <a:avLst/>
          </a:prstGeom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046213C4-A40F-67FD-2B8E-5264F73037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302" y="4438245"/>
            <a:ext cx="11423596" cy="94626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90BDE7B-1907-C434-9171-AC3C3EE9BD0D}"/>
              </a:ext>
            </a:extLst>
          </p:cNvPr>
          <p:cNvSpPr/>
          <p:nvPr/>
        </p:nvSpPr>
        <p:spPr>
          <a:xfrm>
            <a:off x="10893124" y="2530"/>
            <a:ext cx="930365" cy="56638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89423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00EA87-B133-5C4B-E8F1-300D18BF0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721" y="112914"/>
            <a:ext cx="10515600" cy="1325563"/>
          </a:xfrm>
        </p:spPr>
        <p:txBody>
          <a:bodyPr/>
          <a:lstStyle/>
          <a:p>
            <a:r>
              <a:rPr lang="en-US"/>
              <a:t>Now Let's Order:</a:t>
            </a:r>
          </a:p>
        </p:txBody>
      </p:sp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1F3F9A4E-56BD-D16E-B2AC-BADC314FDA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218" y="1221433"/>
            <a:ext cx="6702380" cy="3406244"/>
          </a:xfrm>
          <a:prstGeom prst="rect">
            <a:avLst/>
          </a:prstGeom>
        </p:spPr>
      </p:pic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1DF4EBF3-CB21-4D9B-C581-71579BE204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1580" y="1241014"/>
            <a:ext cx="6364309" cy="2188638"/>
          </a:xfrm>
          <a:prstGeom prst="rect">
            <a:avLst/>
          </a:prstGeom>
        </p:spPr>
      </p:pic>
      <p:pic>
        <p:nvPicPr>
          <p:cNvPr id="6" name="Picture 5" descr="A screenshot of a medical report&#10;&#10;Description automatically generated">
            <a:extLst>
              <a:ext uri="{FF2B5EF4-FFF2-40B4-BE49-F238E27FC236}">
                <a16:creationId xmlns:a16="http://schemas.microsoft.com/office/drawing/2014/main" id="{58CFA5DF-D2A1-3AD6-8599-EA51C68057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5980" y="3786903"/>
            <a:ext cx="7163873" cy="2962248"/>
          </a:xfrm>
          <a:prstGeom prst="rect">
            <a:avLst/>
          </a:prstGeom>
        </p:spPr>
      </p:pic>
      <p:sp>
        <p:nvSpPr>
          <p:cNvPr id="9" name="Flowchart: Process 8">
            <a:extLst>
              <a:ext uri="{FF2B5EF4-FFF2-40B4-BE49-F238E27FC236}">
                <a16:creationId xmlns:a16="http://schemas.microsoft.com/office/drawing/2014/main" id="{F182FC2C-ABCE-D16D-70B2-F71259526D8E}"/>
              </a:ext>
            </a:extLst>
          </p:cNvPr>
          <p:cNvSpPr/>
          <p:nvPr/>
        </p:nvSpPr>
        <p:spPr>
          <a:xfrm>
            <a:off x="112493" y="1222897"/>
            <a:ext cx="1411645" cy="27960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41454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 shot of a computer&#10;&#10;Description automatically generated">
            <a:extLst>
              <a:ext uri="{FF2B5EF4-FFF2-40B4-BE49-F238E27FC236}">
                <a16:creationId xmlns:a16="http://schemas.microsoft.com/office/drawing/2014/main" id="{77C434E4-DD0E-564F-6170-2BF71D0ADA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572" y="589188"/>
            <a:ext cx="10732033" cy="2356280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18F390FB-E2D9-F372-1A78-41B03A76A0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9445" y="3227567"/>
            <a:ext cx="6096000" cy="1606698"/>
          </a:xfrm>
          <a:prstGeom prst="rect">
            <a:avLst/>
          </a:prstGeom>
        </p:spPr>
      </p:pic>
      <p:pic>
        <p:nvPicPr>
          <p:cNvPr id="7" name="Picture 6" descr="A screenshot of a computer&#10;&#10;Description automatically generated">
            <a:extLst>
              <a:ext uri="{FF2B5EF4-FFF2-40B4-BE49-F238E27FC236}">
                <a16:creationId xmlns:a16="http://schemas.microsoft.com/office/drawing/2014/main" id="{37D3EEB2-EB6C-A8DC-25FE-1C95281E81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71463" y="4836607"/>
            <a:ext cx="6096000" cy="1430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090689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86838AB3-C8E3-0F7E-CC59-F2DC83FCD0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286" y="56142"/>
            <a:ext cx="10655193" cy="3313514"/>
          </a:xfrm>
          <a:prstGeom prst="rect">
            <a:avLst/>
          </a:prstGeom>
        </p:spPr>
      </p:pic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E01BC16B-B2D4-BB1A-1FE4-F014A93C74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285" y="3513767"/>
            <a:ext cx="10655192" cy="3345912"/>
          </a:xfrm>
          <a:prstGeom prst="rect">
            <a:avLst/>
          </a:prstGeom>
        </p:spPr>
      </p:pic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3F97B4E1-10EB-5805-EC45-FD4A73E9D517}"/>
              </a:ext>
            </a:extLst>
          </p:cNvPr>
          <p:cNvSpPr/>
          <p:nvPr/>
        </p:nvSpPr>
        <p:spPr>
          <a:xfrm>
            <a:off x="2573820" y="1627497"/>
            <a:ext cx="3731362" cy="23914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CE559FB9-FCE7-1D86-5F0B-5983BE95DB33}"/>
              </a:ext>
            </a:extLst>
          </p:cNvPr>
          <p:cNvSpPr/>
          <p:nvPr/>
        </p:nvSpPr>
        <p:spPr>
          <a:xfrm>
            <a:off x="2573820" y="5059869"/>
            <a:ext cx="6610777" cy="266116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7384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C8FD2-3CB9-27C5-CB16-C17FDA4CB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9444" y="96184"/>
            <a:ext cx="10515600" cy="1325563"/>
          </a:xfrm>
        </p:spPr>
        <p:txBody>
          <a:bodyPr/>
          <a:lstStyle/>
          <a:p>
            <a:r>
              <a:rPr lang="en-US"/>
              <a:t>Don't Forget Extra Hydration! </a:t>
            </a:r>
          </a:p>
        </p:txBody>
      </p:sp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C87D51B0-3545-EFC7-6C02-E5164A7C2C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42" y="2538548"/>
            <a:ext cx="6096000" cy="3413760"/>
          </a:xfrm>
          <a:prstGeom prst="rect">
            <a:avLst/>
          </a:prstGeom>
        </p:spPr>
      </p:pic>
      <p:pic>
        <p:nvPicPr>
          <p:cNvPr id="7" name="Picture 6" descr="A screenshot of a medical report&#10;&#10;Description automatically generated">
            <a:extLst>
              <a:ext uri="{FF2B5EF4-FFF2-40B4-BE49-F238E27FC236}">
                <a16:creationId xmlns:a16="http://schemas.microsoft.com/office/drawing/2014/main" id="{1166902D-307A-5ABC-9A8A-90B4D2624A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2277" y="2139760"/>
            <a:ext cx="5929513" cy="2719352"/>
          </a:xfrm>
          <a:prstGeom prst="rect">
            <a:avLst/>
          </a:prstGeom>
        </p:spPr>
      </p:pic>
      <p:pic>
        <p:nvPicPr>
          <p:cNvPr id="8" name="Picture 7" descr="A screenshot of a computer&#10;&#10;Description automatically generated">
            <a:extLst>
              <a:ext uri="{FF2B5EF4-FFF2-40B4-BE49-F238E27FC236}">
                <a16:creationId xmlns:a16="http://schemas.microsoft.com/office/drawing/2014/main" id="{1FE0F9BA-1898-4744-5853-74C063ADF9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3706" y="4851224"/>
            <a:ext cx="7421495" cy="1919653"/>
          </a:xfrm>
          <a:prstGeom prst="rect">
            <a:avLst/>
          </a:prstGeom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D243B4E3-EF28-5DD5-D258-97A257A7C4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43" y="1300597"/>
            <a:ext cx="10149327" cy="837412"/>
          </a:xfrm>
          <a:prstGeom prst="rect">
            <a:avLst/>
          </a:prstGeom>
        </p:spPr>
      </p:pic>
      <p:sp>
        <p:nvSpPr>
          <p:cNvPr id="4" name="Flowchart: Process 3">
            <a:extLst>
              <a:ext uri="{FF2B5EF4-FFF2-40B4-BE49-F238E27FC236}">
                <a16:creationId xmlns:a16="http://schemas.microsoft.com/office/drawing/2014/main" id="{773D9104-86D0-5079-8CCE-021D0095FF27}"/>
              </a:ext>
            </a:extLst>
          </p:cNvPr>
          <p:cNvSpPr/>
          <p:nvPr/>
        </p:nvSpPr>
        <p:spPr>
          <a:xfrm>
            <a:off x="85520" y="2537852"/>
            <a:ext cx="1715096" cy="27960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lowchart: Process 9">
            <a:extLst>
              <a:ext uri="{FF2B5EF4-FFF2-40B4-BE49-F238E27FC236}">
                <a16:creationId xmlns:a16="http://schemas.microsoft.com/office/drawing/2014/main" id="{409F5C52-DAA9-5C2A-BA24-122C7701CAC3}"/>
              </a:ext>
            </a:extLst>
          </p:cNvPr>
          <p:cNvSpPr/>
          <p:nvPr/>
        </p:nvSpPr>
        <p:spPr>
          <a:xfrm>
            <a:off x="8197785" y="4223693"/>
            <a:ext cx="3023308" cy="164965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272E3F9C-2CBB-6416-669A-0D7DADB32BED}"/>
              </a:ext>
            </a:extLst>
          </p:cNvPr>
          <p:cNvSpPr/>
          <p:nvPr/>
        </p:nvSpPr>
        <p:spPr>
          <a:xfrm>
            <a:off x="6606351" y="5963480"/>
            <a:ext cx="5437432" cy="171709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388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medical form&#10;&#10;Description automatically generated">
            <a:extLst>
              <a:ext uri="{FF2B5EF4-FFF2-40B4-BE49-F238E27FC236}">
                <a16:creationId xmlns:a16="http://schemas.microsoft.com/office/drawing/2014/main" id="{08F67302-9B4E-8524-CA03-A31DE7C766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773" y="-2319"/>
            <a:ext cx="6065125" cy="64584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CDC36B7-208D-D46B-7574-FCF790348FF4}"/>
              </a:ext>
            </a:extLst>
          </p:cNvPr>
          <p:cNvSpPr txBox="1"/>
          <p:nvPr/>
        </p:nvSpPr>
        <p:spPr>
          <a:xfrm>
            <a:off x="7486430" y="1348313"/>
            <a:ext cx="4105572" cy="461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lnSpc>
                <a:spcPct val="90000"/>
              </a:lnSpc>
              <a:spcBef>
                <a:spcPts val="1000"/>
              </a:spcBef>
            </a:pPr>
            <a:r>
              <a:rPr lang="en-US" sz="2800" b="1" u="sng" dirty="0">
                <a:latin typeface="Aptos"/>
                <a:cs typeface="Arial"/>
              </a:rPr>
              <a:t>Consists of:</a:t>
            </a: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 dirty="0">
                <a:latin typeface="Aptos"/>
                <a:cs typeface="Arial"/>
              </a:rPr>
              <a:t>Fluids</a:t>
            </a:r>
            <a:endParaRPr lang="en-US" sz="2800">
              <a:latin typeface="Aptos"/>
            </a:endParaRP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>
                <a:latin typeface="Aptos"/>
                <a:cs typeface="Arial"/>
              </a:rPr>
              <a:t>Electrolytes </a:t>
            </a:r>
            <a:endParaRPr lang="en-US" sz="2800" dirty="0">
              <a:latin typeface="Aptos"/>
              <a:cs typeface="Arial"/>
            </a:endParaRP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>
                <a:latin typeface="Aptos"/>
                <a:cs typeface="Arial"/>
              </a:rPr>
              <a:t>Carbohydrates</a:t>
            </a:r>
            <a:endParaRPr lang="en-US" sz="2800" dirty="0">
              <a:latin typeface="Aptos"/>
              <a:cs typeface="Arial"/>
            </a:endParaRP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>
                <a:latin typeface="Aptos"/>
                <a:cs typeface="Arial"/>
              </a:rPr>
              <a:t>Proteins</a:t>
            </a:r>
            <a:endParaRPr lang="en-US" sz="2800" dirty="0">
              <a:latin typeface="Aptos"/>
              <a:cs typeface="Arial"/>
            </a:endParaRP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>
                <a:latin typeface="Aptos"/>
                <a:cs typeface="Arial"/>
              </a:rPr>
              <a:t>Lipids</a:t>
            </a:r>
            <a:endParaRPr lang="en-US" sz="2800" dirty="0">
              <a:latin typeface="Aptos"/>
              <a:cs typeface="Arial"/>
            </a:endParaRP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 dirty="0">
                <a:latin typeface="Aptos"/>
                <a:cs typeface="Arial"/>
              </a:rPr>
              <a:t>Trace elements</a:t>
            </a:r>
          </a:p>
          <a:p>
            <a:pPr marL="285750" indent="-285750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 dirty="0">
                <a:latin typeface="Aptos"/>
                <a:cs typeface="Arial"/>
              </a:rPr>
              <a:t>Vitamins</a:t>
            </a:r>
          </a:p>
          <a:p>
            <a:pPr marL="285750" indent="-285750" algn="l">
              <a:lnSpc>
                <a:spcPct val="90000"/>
              </a:lnSpc>
              <a:spcBef>
                <a:spcPts val="1000"/>
              </a:spcBef>
              <a:buFont typeface="Candara,Sans-Serif"/>
              <a:buChar char="•"/>
            </a:pPr>
            <a:r>
              <a:rPr lang="en-US" sz="2800" dirty="0">
                <a:latin typeface="Aptos"/>
                <a:cs typeface="Arial"/>
              </a:rPr>
              <a:t>Medications</a:t>
            </a:r>
            <a:endParaRPr lang="en-US">
              <a:latin typeface="Aptos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990DE21-E26E-9308-8E5C-D7F669956FA6}"/>
              </a:ext>
            </a:extLst>
          </p:cNvPr>
          <p:cNvSpPr/>
          <p:nvPr/>
        </p:nvSpPr>
        <p:spPr>
          <a:xfrm>
            <a:off x="4288968" y="139843"/>
            <a:ext cx="788755" cy="22246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3A5027F-06CB-CD00-DB5B-5448BD354F44}"/>
              </a:ext>
            </a:extLst>
          </p:cNvPr>
          <p:cNvSpPr/>
          <p:nvPr/>
        </p:nvSpPr>
        <p:spPr>
          <a:xfrm>
            <a:off x="4287563" y="495610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AD2551D-AA2D-6AB2-550A-2B359EC2A3E1}"/>
              </a:ext>
            </a:extLst>
          </p:cNvPr>
          <p:cNvSpPr/>
          <p:nvPr/>
        </p:nvSpPr>
        <p:spPr>
          <a:xfrm>
            <a:off x="4287562" y="873238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Flowchart: Process 7">
            <a:extLst>
              <a:ext uri="{FF2B5EF4-FFF2-40B4-BE49-F238E27FC236}">
                <a16:creationId xmlns:a16="http://schemas.microsoft.com/office/drawing/2014/main" id="{D1ADD205-DCAF-C98D-7976-61B0BA44D8EC}"/>
              </a:ext>
            </a:extLst>
          </p:cNvPr>
          <p:cNvSpPr/>
          <p:nvPr/>
        </p:nvSpPr>
        <p:spPr>
          <a:xfrm>
            <a:off x="840777" y="1539836"/>
            <a:ext cx="2531039" cy="77860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lowchart: Process 9">
            <a:extLst>
              <a:ext uri="{FF2B5EF4-FFF2-40B4-BE49-F238E27FC236}">
                <a16:creationId xmlns:a16="http://schemas.microsoft.com/office/drawing/2014/main" id="{F0219CCC-D8B3-C646-6F2B-C47AF331C1CC}"/>
              </a:ext>
            </a:extLst>
          </p:cNvPr>
          <p:cNvSpPr/>
          <p:nvPr/>
        </p:nvSpPr>
        <p:spPr>
          <a:xfrm>
            <a:off x="840777" y="2328809"/>
            <a:ext cx="4082012" cy="174965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lowchart: Process 10">
            <a:extLst>
              <a:ext uri="{FF2B5EF4-FFF2-40B4-BE49-F238E27FC236}">
                <a16:creationId xmlns:a16="http://schemas.microsoft.com/office/drawing/2014/main" id="{A1A26B26-8830-DD62-6351-1C0383C065FC}"/>
              </a:ext>
            </a:extLst>
          </p:cNvPr>
          <p:cNvSpPr/>
          <p:nvPr/>
        </p:nvSpPr>
        <p:spPr>
          <a:xfrm>
            <a:off x="840777" y="4082084"/>
            <a:ext cx="5734135" cy="913476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2EB5C46A-7260-BE61-8902-13E19AD03B99}"/>
              </a:ext>
            </a:extLst>
          </p:cNvPr>
          <p:cNvSpPr/>
          <p:nvPr/>
        </p:nvSpPr>
        <p:spPr>
          <a:xfrm>
            <a:off x="840777" y="4999180"/>
            <a:ext cx="5727392" cy="697688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lowchart: Process 12">
            <a:extLst>
              <a:ext uri="{FF2B5EF4-FFF2-40B4-BE49-F238E27FC236}">
                <a16:creationId xmlns:a16="http://schemas.microsoft.com/office/drawing/2014/main" id="{52209403-C1A1-FE25-C873-1911C98C7A5B}"/>
              </a:ext>
            </a:extLst>
          </p:cNvPr>
          <p:cNvSpPr/>
          <p:nvPr/>
        </p:nvSpPr>
        <p:spPr>
          <a:xfrm>
            <a:off x="4920511" y="2328808"/>
            <a:ext cx="1654402" cy="1749652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lowchart: Process 13">
            <a:extLst>
              <a:ext uri="{FF2B5EF4-FFF2-40B4-BE49-F238E27FC236}">
                <a16:creationId xmlns:a16="http://schemas.microsoft.com/office/drawing/2014/main" id="{1C36D20E-F80A-8414-282C-E5E3FF4BEC18}"/>
              </a:ext>
            </a:extLst>
          </p:cNvPr>
          <p:cNvSpPr/>
          <p:nvPr/>
        </p:nvSpPr>
        <p:spPr>
          <a:xfrm>
            <a:off x="840776" y="5700489"/>
            <a:ext cx="5734135" cy="751634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Flowchart: Process 14">
            <a:extLst>
              <a:ext uri="{FF2B5EF4-FFF2-40B4-BE49-F238E27FC236}">
                <a16:creationId xmlns:a16="http://schemas.microsoft.com/office/drawing/2014/main" id="{5A53B1D6-7D41-6587-8D34-F372DEA33DDF}"/>
              </a:ext>
            </a:extLst>
          </p:cNvPr>
          <p:cNvSpPr/>
          <p:nvPr/>
        </p:nvSpPr>
        <p:spPr>
          <a:xfrm>
            <a:off x="3369537" y="1539835"/>
            <a:ext cx="3212118" cy="785350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F7CDFB00-0165-3009-F75E-4F1C6C605198}"/>
              </a:ext>
            </a:extLst>
          </p:cNvPr>
          <p:cNvSpPr/>
          <p:nvPr/>
        </p:nvSpPr>
        <p:spPr>
          <a:xfrm>
            <a:off x="2106649" y="775267"/>
            <a:ext cx="795592" cy="30336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590755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06286-C44F-D904-6766-051335CE5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9846" y="2199320"/>
            <a:ext cx="11365263" cy="1339049"/>
          </a:xfrm>
        </p:spPr>
        <p:txBody>
          <a:bodyPr/>
          <a:lstStyle/>
          <a:p>
            <a:r>
              <a:rPr lang="en-US" dirty="0"/>
              <a:t>Repeat BMP, Mg, PHO4 in AM among other labs</a:t>
            </a:r>
          </a:p>
        </p:txBody>
      </p:sp>
    </p:spTree>
    <p:extLst>
      <p:ext uri="{BB962C8B-B14F-4D97-AF65-F5344CB8AC3E}">
        <p14:creationId xmlns:p14="http://schemas.microsoft.com/office/powerpoint/2010/main" val="1670317384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F381A-0C46-8E52-F837-E4D708B785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lculate Key TPN Parameter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F5D10B-DEF1-C7DF-56E8-EA874D688E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0109" y="1831442"/>
            <a:ext cx="11271783" cy="4351338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171450" indent="-171450"/>
            <a:r>
              <a:rPr lang="en-US" b="1" dirty="0">
                <a:latin typeface="Aptos"/>
                <a:cs typeface="Arial"/>
              </a:rPr>
              <a:t>  Glucose Infusion Rate (GIR) =</a:t>
            </a:r>
            <a:r>
              <a:rPr lang="en-US" dirty="0">
                <a:latin typeface="Aptos"/>
                <a:cs typeface="Arial"/>
              </a:rPr>
              <a:t> (rate (ml/</a:t>
            </a:r>
            <a:r>
              <a:rPr lang="en-US" dirty="0" err="1">
                <a:latin typeface="Aptos"/>
                <a:cs typeface="Arial"/>
              </a:rPr>
              <a:t>hr</a:t>
            </a:r>
            <a:r>
              <a:rPr lang="en-US" dirty="0">
                <a:latin typeface="Aptos"/>
                <a:cs typeface="Arial"/>
              </a:rPr>
              <a:t>) x Dex%) / (6 x weight (kg))</a:t>
            </a:r>
            <a:endParaRPr lang="en-US" b="1">
              <a:solidFill>
                <a:srgbClr val="0F4761"/>
              </a:solidFill>
              <a:latin typeface="Aptos"/>
              <a:cs typeface="Arial"/>
            </a:endParaRPr>
          </a:p>
          <a:p>
            <a:r>
              <a:rPr lang="en-US" b="1" dirty="0">
                <a:latin typeface="Aptos"/>
                <a:cs typeface="Arial"/>
              </a:rPr>
              <a:t>TPN Calories (from Dextrose) </a:t>
            </a:r>
            <a:r>
              <a:rPr lang="en-US" dirty="0">
                <a:latin typeface="Aptos"/>
                <a:cs typeface="Arial"/>
              </a:rPr>
              <a:t>= 3.4 kcal/g x Dex% x (volume (ml) / 100)</a:t>
            </a:r>
          </a:p>
          <a:p>
            <a:r>
              <a:rPr lang="en-US" dirty="0">
                <a:latin typeface="Aptos"/>
                <a:cs typeface="Arial"/>
              </a:rPr>
              <a:t>Amino Acids (AA) contribute to anabolism and are not included in TPN calorie calculation.</a:t>
            </a:r>
          </a:p>
          <a:p>
            <a:r>
              <a:rPr lang="en-US" b="1" dirty="0">
                <a:latin typeface="Aptos"/>
                <a:cs typeface="Arial"/>
              </a:rPr>
              <a:t>Lipid Calories </a:t>
            </a:r>
            <a:r>
              <a:rPr lang="en-US" dirty="0">
                <a:latin typeface="Aptos"/>
                <a:cs typeface="Arial"/>
              </a:rPr>
              <a:t>= 9 kcal/g × Lipid (g/kg/day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7468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24072-5194-B87A-86EC-17D0F3772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Order Home TPN</a:t>
            </a:r>
          </a:p>
        </p:txBody>
      </p:sp>
      <p:pic>
        <p:nvPicPr>
          <p:cNvPr id="4" name="Content Placeholder 3" descr="A screenshot of a computer&#10;&#10;Description automatically generated">
            <a:extLst>
              <a:ext uri="{FF2B5EF4-FFF2-40B4-BE49-F238E27FC236}">
                <a16:creationId xmlns:a16="http://schemas.microsoft.com/office/drawing/2014/main" id="{841F9F36-D40C-0395-F951-040DD584F76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840" y="1717638"/>
            <a:ext cx="10783260" cy="4573714"/>
          </a:xfrm>
        </p:spPr>
      </p:pic>
      <p:sp>
        <p:nvSpPr>
          <p:cNvPr id="6" name="Flowchart: Process 5">
            <a:extLst>
              <a:ext uri="{FF2B5EF4-FFF2-40B4-BE49-F238E27FC236}">
                <a16:creationId xmlns:a16="http://schemas.microsoft.com/office/drawing/2014/main" id="{4C8DCD83-E78E-ED43-17BD-373448DE628C}"/>
              </a:ext>
            </a:extLst>
          </p:cNvPr>
          <p:cNvSpPr/>
          <p:nvPr/>
        </p:nvSpPr>
        <p:spPr>
          <a:xfrm>
            <a:off x="840777" y="2328809"/>
            <a:ext cx="1957854" cy="23239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C98DE49E-9BCF-F9F1-67AD-9CD0D3826DEC}"/>
              </a:ext>
            </a:extLst>
          </p:cNvPr>
          <p:cNvSpPr/>
          <p:nvPr/>
        </p:nvSpPr>
        <p:spPr>
          <a:xfrm>
            <a:off x="4880051" y="2585056"/>
            <a:ext cx="1890421" cy="29308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276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DE4CE9C6-10FB-957F-BA89-DD88CDE5DC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5156" y="446268"/>
            <a:ext cx="10914844" cy="6094254"/>
          </a:xfrm>
          <a:prstGeom prst="rect">
            <a:avLst/>
          </a:prstGeom>
        </p:spPr>
      </p:pic>
      <p:sp>
        <p:nvSpPr>
          <p:cNvPr id="4" name="Flowchart: Process 3">
            <a:extLst>
              <a:ext uri="{FF2B5EF4-FFF2-40B4-BE49-F238E27FC236}">
                <a16:creationId xmlns:a16="http://schemas.microsoft.com/office/drawing/2014/main" id="{0BB309F9-0D3E-DAFD-8B04-D0775F9C5816}"/>
              </a:ext>
            </a:extLst>
          </p:cNvPr>
          <p:cNvSpPr/>
          <p:nvPr/>
        </p:nvSpPr>
        <p:spPr>
          <a:xfrm>
            <a:off x="10079184" y="6246702"/>
            <a:ext cx="1890421" cy="293087"/>
          </a:xfrm>
          <a:prstGeom prst="flowChartProcess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5471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86301785-BC4C-5320-30D4-DA8593283B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512" y="262805"/>
            <a:ext cx="9675477" cy="6197919"/>
          </a:xfrm>
          <a:prstGeom prst="rect">
            <a:avLst/>
          </a:prstGeom>
        </p:spPr>
      </p:pic>
      <p:pic>
        <p:nvPicPr>
          <p:cNvPr id="4" name="Picture 3" descr="A close-up of a medical form&#10;&#10;Description automatically generated">
            <a:extLst>
              <a:ext uri="{FF2B5EF4-FFF2-40B4-BE49-F238E27FC236}">
                <a16:creationId xmlns:a16="http://schemas.microsoft.com/office/drawing/2014/main" id="{BABDBCEE-BB5E-B762-79DB-479F019B39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4244" y="132549"/>
            <a:ext cx="6065125" cy="645843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D05FE3C-E449-BDCA-51CC-1A4B1DCBAB32}"/>
              </a:ext>
            </a:extLst>
          </p:cNvPr>
          <p:cNvSpPr/>
          <p:nvPr/>
        </p:nvSpPr>
        <p:spPr>
          <a:xfrm>
            <a:off x="9891298" y="265688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DC8DC3E-0663-78DE-F81B-30646D07375E}"/>
              </a:ext>
            </a:extLst>
          </p:cNvPr>
          <p:cNvSpPr/>
          <p:nvPr/>
        </p:nvSpPr>
        <p:spPr>
          <a:xfrm>
            <a:off x="9891298" y="677681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ACBF35E-6D03-1CE9-D8B7-961370C360BB}"/>
              </a:ext>
            </a:extLst>
          </p:cNvPr>
          <p:cNvSpPr/>
          <p:nvPr/>
        </p:nvSpPr>
        <p:spPr>
          <a:xfrm>
            <a:off x="9891298" y="1021592"/>
            <a:ext cx="889905" cy="20223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1107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659DE7C8-F8BF-61CD-37B5-590CCDBA17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446" y="1168534"/>
            <a:ext cx="11090621" cy="4123924"/>
          </a:xfrm>
          <a:prstGeom prst="rect">
            <a:avLst/>
          </a:prstGeom>
        </p:spPr>
      </p:pic>
      <p:sp>
        <p:nvSpPr>
          <p:cNvPr id="6" name="Oval 5">
            <a:extLst>
              <a:ext uri="{FF2B5EF4-FFF2-40B4-BE49-F238E27FC236}">
                <a16:creationId xmlns:a16="http://schemas.microsoft.com/office/drawing/2014/main" id="{1B8F986C-D20D-2C34-FA4E-6FCF528EAE8B}"/>
              </a:ext>
            </a:extLst>
          </p:cNvPr>
          <p:cNvSpPr/>
          <p:nvPr/>
        </p:nvSpPr>
        <p:spPr>
          <a:xfrm>
            <a:off x="178048" y="4524578"/>
            <a:ext cx="964175" cy="694481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046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548D115F-9288-45E7-C063-CBFCBD5413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247" y="1280"/>
            <a:ext cx="7211945" cy="5043287"/>
          </a:xfrm>
          <a:prstGeom prst="rect">
            <a:avLst/>
          </a:prstGeom>
        </p:spPr>
      </p:pic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B9FE9E1D-8671-6261-E549-0CF4B7F048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86933" y="3840443"/>
            <a:ext cx="6096000" cy="2641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77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0</Words>
  <Application>Microsoft Office PowerPoint</Application>
  <PresentationFormat>Widescreen</PresentationFormat>
  <Paragraphs>0</Paragraphs>
  <Slides>41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2" baseType="lpstr">
      <vt:lpstr>office theme</vt:lpstr>
      <vt:lpstr>TPN Workshops</vt:lpstr>
      <vt:lpstr>TPN</vt:lpstr>
      <vt:lpstr>Find TPN Sheets on Cerner </vt:lpstr>
      <vt:lpstr>PowerPoint Presentation</vt:lpstr>
      <vt:lpstr>Order Home TP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Order Lipid: </vt:lpstr>
      <vt:lpstr>Order Lipid:</vt:lpstr>
      <vt:lpstr>PowerPoint Presentation</vt:lpstr>
      <vt:lpstr>If Ordering Other Lipids</vt:lpstr>
      <vt:lpstr>Don't Forget Extra Hydration</vt:lpstr>
      <vt:lpstr>Don't Forget Extra Hydration:</vt:lpstr>
      <vt:lpstr>TPN-Like Fluids </vt:lpstr>
      <vt:lpstr>First Thing First:</vt:lpstr>
      <vt:lpstr>Calculate TPN-Like Fluids </vt:lpstr>
      <vt:lpstr>1 - Calculate TPN-Like Fluids </vt:lpstr>
      <vt:lpstr>Total TPN: 600 ml </vt:lpstr>
      <vt:lpstr>Convert to 1000 ml (1L): </vt:lpstr>
      <vt:lpstr>Next Steps: </vt:lpstr>
      <vt:lpstr>Now Let's Order:</vt:lpstr>
      <vt:lpstr>PowerPoint Presentation</vt:lpstr>
      <vt:lpstr>2- Calculate TPN-Like Fluids </vt:lpstr>
      <vt:lpstr>Total TPN: 857 ml </vt:lpstr>
      <vt:lpstr>Convert to 1000 ml (1L): </vt:lpstr>
      <vt:lpstr>PowerPoint Presentation</vt:lpstr>
      <vt:lpstr>Next Steps: </vt:lpstr>
      <vt:lpstr>Now Let's Order:</vt:lpstr>
      <vt:lpstr>PowerPoint Presentation</vt:lpstr>
      <vt:lpstr>PowerPoint Presentation</vt:lpstr>
      <vt:lpstr>Don't Forget Extra Hydration! </vt:lpstr>
      <vt:lpstr>Repeat BMP, Mg, PHO4 in AM among other labs</vt:lpstr>
      <vt:lpstr>Calculate Key TPN Parameters: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 </cp:lastModifiedBy>
  <cp:revision>393</cp:revision>
  <dcterms:created xsi:type="dcterms:W3CDTF">2013-07-15T20:26:40Z</dcterms:created>
  <dcterms:modified xsi:type="dcterms:W3CDTF">2025-05-16T21:41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4-12-12T15:04:55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290b325c-8a50-4b76-b111-22d1a4c73a5a</vt:lpwstr>
  </property>
  <property fmtid="{D5CDD505-2E9C-101B-9397-08002B2CF9AE}" pid="8" name="MSIP_Label_5e4b1be8-281e-475d-98b0-21c3457e5a46_ContentBits">
    <vt:lpwstr>0</vt:lpwstr>
  </property>
</Properties>
</file>